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65" r:id="rId2"/>
    <p:sldId id="257" r:id="rId3"/>
    <p:sldId id="261" r:id="rId4"/>
    <p:sldId id="256" r:id="rId5"/>
    <p:sldId id="260" r:id="rId6"/>
    <p:sldId id="262" r:id="rId7"/>
    <p:sldId id="264" r:id="rId8"/>
    <p:sldId id="263" r:id="rId9"/>
    <p:sldId id="259" r:id="rId10"/>
    <p:sldId id="258" r:id="rId11"/>
    <p:sldId id="266" r:id="rId12"/>
    <p:sldId id="267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5CE6EFC-C947-461A-B6D9-EB162DC25B8B}" v="69" dt="2024-07-10T16:30:42.03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821" y="72"/>
      </p:cViewPr>
      <p:guideLst>
        <p:guide orient="horz" pos="213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man, Shankar, Ph.D." userId="5c40f8ff-9e47-4060-8f0c-840d2230e7fd" providerId="ADAL" clId="{85CE6EFC-C947-461A-B6D9-EB162DC25B8B}"/>
    <pc:docChg chg="undo custSel addSld delSld modSld sldOrd">
      <pc:chgData name="Suman, Shankar, Ph.D." userId="5c40f8ff-9e47-4060-8f0c-840d2230e7fd" providerId="ADAL" clId="{85CE6EFC-C947-461A-B6D9-EB162DC25B8B}" dt="2024-07-10T16:32:39.934" v="1687" actId="14100"/>
      <pc:docMkLst>
        <pc:docMk/>
      </pc:docMkLst>
      <pc:sldChg chg="modSp mod ord">
        <pc:chgData name="Suman, Shankar, Ph.D." userId="5c40f8ff-9e47-4060-8f0c-840d2230e7fd" providerId="ADAL" clId="{85CE6EFC-C947-461A-B6D9-EB162DC25B8B}" dt="2024-06-23T21:37:56.906" v="1147" actId="20577"/>
        <pc:sldMkLst>
          <pc:docMk/>
          <pc:sldMk cId="16268869" sldId="256"/>
        </pc:sldMkLst>
        <pc:spChg chg="mod">
          <ac:chgData name="Suman, Shankar, Ph.D." userId="5c40f8ff-9e47-4060-8f0c-840d2230e7fd" providerId="ADAL" clId="{85CE6EFC-C947-461A-B6D9-EB162DC25B8B}" dt="2024-06-23T21:37:56.906" v="1147" actId="20577"/>
          <ac:spMkLst>
            <pc:docMk/>
            <pc:sldMk cId="16268869" sldId="256"/>
            <ac:spMk id="2" creationId="{78FB01BB-DF30-3E8D-C9C2-69EE59359760}"/>
          </ac:spMkLst>
        </pc:spChg>
        <pc:spChg chg="mod">
          <ac:chgData name="Suman, Shankar, Ph.D." userId="5c40f8ff-9e47-4060-8f0c-840d2230e7fd" providerId="ADAL" clId="{85CE6EFC-C947-461A-B6D9-EB162DC25B8B}" dt="2024-06-23T21:37:48.563" v="1145" actId="20577"/>
          <ac:spMkLst>
            <pc:docMk/>
            <pc:sldMk cId="16268869" sldId="256"/>
            <ac:spMk id="46" creationId="{AA22BBBF-32EB-3D3F-D39A-667988F784EB}"/>
          </ac:spMkLst>
        </pc:spChg>
      </pc:sldChg>
      <pc:sldChg chg="addSp delSp modSp mod ord">
        <pc:chgData name="Suman, Shankar, Ph.D." userId="5c40f8ff-9e47-4060-8f0c-840d2230e7fd" providerId="ADAL" clId="{85CE6EFC-C947-461A-B6D9-EB162DC25B8B}" dt="2024-06-25T20:37:59.880" v="1418" actId="20577"/>
        <pc:sldMkLst>
          <pc:docMk/>
          <pc:sldMk cId="1762179812" sldId="257"/>
        </pc:sldMkLst>
        <pc:spChg chg="mod">
          <ac:chgData name="Suman, Shankar, Ph.D." userId="5c40f8ff-9e47-4060-8f0c-840d2230e7fd" providerId="ADAL" clId="{85CE6EFC-C947-461A-B6D9-EB162DC25B8B}" dt="2024-06-22T23:58:54.683" v="1035" actId="20577"/>
          <ac:spMkLst>
            <pc:docMk/>
            <pc:sldMk cId="1762179812" sldId="257"/>
            <ac:spMk id="2" creationId="{37709C2F-9977-8CDD-31C8-FEB89D7E6C4D}"/>
          </ac:spMkLst>
        </pc:spChg>
        <pc:spChg chg="mod">
          <ac:chgData name="Suman, Shankar, Ph.D." userId="5c40f8ff-9e47-4060-8f0c-840d2230e7fd" providerId="ADAL" clId="{85CE6EFC-C947-461A-B6D9-EB162DC25B8B}" dt="2024-06-23T21:37:28.565" v="1142" actId="1076"/>
          <ac:spMkLst>
            <pc:docMk/>
            <pc:sldMk cId="1762179812" sldId="257"/>
            <ac:spMk id="4" creationId="{D3F87CF8-6F8D-484A-94FA-327FCBFAE740}"/>
          </ac:spMkLst>
        </pc:spChg>
        <pc:spChg chg="mod">
          <ac:chgData name="Suman, Shankar, Ph.D." userId="5c40f8ff-9e47-4060-8f0c-840d2230e7fd" providerId="ADAL" clId="{85CE6EFC-C947-461A-B6D9-EB162DC25B8B}" dt="2024-06-25T20:37:59.880" v="1418" actId="20577"/>
          <ac:spMkLst>
            <pc:docMk/>
            <pc:sldMk cId="1762179812" sldId="257"/>
            <ac:spMk id="16" creationId="{ECB7D2C6-CE77-41B9-FE05-54DA14375285}"/>
          </ac:spMkLst>
        </pc:spChg>
        <pc:spChg chg="del">
          <ac:chgData name="Suman, Shankar, Ph.D." userId="5c40f8ff-9e47-4060-8f0c-840d2230e7fd" providerId="ADAL" clId="{85CE6EFC-C947-461A-B6D9-EB162DC25B8B}" dt="2024-06-22T23:58:57.708" v="1036" actId="478"/>
          <ac:spMkLst>
            <pc:docMk/>
            <pc:sldMk cId="1762179812" sldId="257"/>
            <ac:spMk id="17" creationId="{D31D59E8-9442-F284-6B26-73D940130C60}"/>
          </ac:spMkLst>
        </pc:spChg>
        <pc:spChg chg="del">
          <ac:chgData name="Suman, Shankar, Ph.D." userId="5c40f8ff-9e47-4060-8f0c-840d2230e7fd" providerId="ADAL" clId="{85CE6EFC-C947-461A-B6D9-EB162DC25B8B}" dt="2024-06-23T00:06:40.934" v="1039" actId="478"/>
          <ac:spMkLst>
            <pc:docMk/>
            <pc:sldMk cId="1762179812" sldId="257"/>
            <ac:spMk id="18" creationId="{82F6CCA6-7313-D970-2493-9A3C3C64AA35}"/>
          </ac:spMkLst>
        </pc:spChg>
        <pc:grpChg chg="del mod">
          <ac:chgData name="Suman, Shankar, Ph.D." userId="5c40f8ff-9e47-4060-8f0c-840d2230e7fd" providerId="ADAL" clId="{85CE6EFC-C947-461A-B6D9-EB162DC25B8B}" dt="2024-06-22T23:58:07.812" v="1026" actId="478"/>
          <ac:grpSpMkLst>
            <pc:docMk/>
            <pc:sldMk cId="1762179812" sldId="257"/>
            <ac:grpSpMk id="6" creationId="{3A2F69B2-7CF6-EFC8-5E3D-2F3D682DD02B}"/>
          </ac:grpSpMkLst>
        </pc:grpChg>
        <pc:graphicFrameChg chg="mod modGraphic">
          <ac:chgData name="Suman, Shankar, Ph.D." userId="5c40f8ff-9e47-4060-8f0c-840d2230e7fd" providerId="ADAL" clId="{85CE6EFC-C947-461A-B6D9-EB162DC25B8B}" dt="2024-06-23T21:37:35.528" v="1143" actId="1076"/>
          <ac:graphicFrameMkLst>
            <pc:docMk/>
            <pc:sldMk cId="1762179812" sldId="257"/>
            <ac:graphicFrameMk id="5" creationId="{ECC36C1F-FE95-30BE-41CF-D4107E7C4B5B}"/>
          </ac:graphicFrameMkLst>
        </pc:graphicFrameChg>
        <pc:picChg chg="add del mod modCrop">
          <ac:chgData name="Suman, Shankar, Ph.D." userId="5c40f8ff-9e47-4060-8f0c-840d2230e7fd" providerId="ADAL" clId="{85CE6EFC-C947-461A-B6D9-EB162DC25B8B}" dt="2024-06-23T00:08:56.028" v="1094" actId="478"/>
          <ac:picMkLst>
            <pc:docMk/>
            <pc:sldMk cId="1762179812" sldId="257"/>
            <ac:picMk id="3" creationId="{A642D0BF-1011-D2AB-C74C-DC469D10706D}"/>
          </ac:picMkLst>
        </pc:picChg>
        <pc:picChg chg="mod">
          <ac:chgData name="Suman, Shankar, Ph.D." userId="5c40f8ff-9e47-4060-8f0c-840d2230e7fd" providerId="ADAL" clId="{85CE6EFC-C947-461A-B6D9-EB162DC25B8B}" dt="2024-06-22T23:45:58.355" v="728" actId="14100"/>
          <ac:picMkLst>
            <pc:docMk/>
            <pc:sldMk cId="1762179812" sldId="257"/>
            <ac:picMk id="7" creationId="{319EAA58-FEDB-9B19-7AA8-5150B8356667}"/>
          </ac:picMkLst>
        </pc:picChg>
        <pc:picChg chg="del mod">
          <ac:chgData name="Suman, Shankar, Ph.D." userId="5c40f8ff-9e47-4060-8f0c-840d2230e7fd" providerId="ADAL" clId="{85CE6EFC-C947-461A-B6D9-EB162DC25B8B}" dt="2024-06-23T00:06:31.220" v="1038" actId="478"/>
          <ac:picMkLst>
            <pc:docMk/>
            <pc:sldMk cId="1762179812" sldId="257"/>
            <ac:picMk id="19" creationId="{3C302D61-E013-15AF-3569-74C6D6A39163}"/>
          </ac:picMkLst>
        </pc:picChg>
        <pc:picChg chg="add del mod">
          <ac:chgData name="Suman, Shankar, Ph.D." userId="5c40f8ff-9e47-4060-8f0c-840d2230e7fd" providerId="ADAL" clId="{85CE6EFC-C947-461A-B6D9-EB162DC25B8B}" dt="2024-06-23T00:08:57.519" v="1096" actId="478"/>
          <ac:picMkLst>
            <pc:docMk/>
            <pc:sldMk cId="1762179812" sldId="257"/>
            <ac:picMk id="20" creationId="{B1CD48B8-28DE-7284-1FBD-A09E9ECEC56B}"/>
          </ac:picMkLst>
        </pc:picChg>
        <pc:picChg chg="add del mod">
          <ac:chgData name="Suman, Shankar, Ph.D." userId="5c40f8ff-9e47-4060-8f0c-840d2230e7fd" providerId="ADAL" clId="{85CE6EFC-C947-461A-B6D9-EB162DC25B8B}" dt="2024-06-23T00:08:56.869" v="1095" actId="478"/>
          <ac:picMkLst>
            <pc:docMk/>
            <pc:sldMk cId="1762179812" sldId="257"/>
            <ac:picMk id="21" creationId="{F5981FCD-46E7-5940-263A-D712FDCFB24F}"/>
          </ac:picMkLst>
        </pc:picChg>
        <pc:picChg chg="add del mod modCrop">
          <ac:chgData name="Suman, Shankar, Ph.D." userId="5c40f8ff-9e47-4060-8f0c-840d2230e7fd" providerId="ADAL" clId="{85CE6EFC-C947-461A-B6D9-EB162DC25B8B}" dt="2024-06-23T21:37:25.099" v="1141" actId="1076"/>
          <ac:picMkLst>
            <pc:docMk/>
            <pc:sldMk cId="1762179812" sldId="257"/>
            <ac:picMk id="22" creationId="{31188B6E-E04D-DD4C-7D19-4864D22AC30E}"/>
          </ac:picMkLst>
        </pc:picChg>
        <pc:picChg chg="add mod">
          <ac:chgData name="Suman, Shankar, Ph.D." userId="5c40f8ff-9e47-4060-8f0c-840d2230e7fd" providerId="ADAL" clId="{85CE6EFC-C947-461A-B6D9-EB162DC25B8B}" dt="2024-06-23T00:13:03.564" v="1121" actId="1076"/>
          <ac:picMkLst>
            <pc:docMk/>
            <pc:sldMk cId="1762179812" sldId="257"/>
            <ac:picMk id="23" creationId="{B83AE3FE-19DE-998A-4E14-0A5D41B2887F}"/>
          </ac:picMkLst>
        </pc:picChg>
      </pc:sldChg>
      <pc:sldChg chg="addSp delSp modSp mod">
        <pc:chgData name="Suman, Shankar, Ph.D." userId="5c40f8ff-9e47-4060-8f0c-840d2230e7fd" providerId="ADAL" clId="{85CE6EFC-C947-461A-B6D9-EB162DC25B8B}" dt="2024-06-25T20:37:18.913" v="1415" actId="14100"/>
        <pc:sldMkLst>
          <pc:docMk/>
          <pc:sldMk cId="82386172" sldId="258"/>
        </pc:sldMkLst>
        <pc:spChg chg="mod">
          <ac:chgData name="Suman, Shankar, Ph.D." userId="5c40f8ff-9e47-4060-8f0c-840d2230e7fd" providerId="ADAL" clId="{85CE6EFC-C947-461A-B6D9-EB162DC25B8B}" dt="2024-06-23T21:39:07.249" v="1173" actId="20577"/>
          <ac:spMkLst>
            <pc:docMk/>
            <pc:sldMk cId="82386172" sldId="258"/>
            <ac:spMk id="2" creationId="{8F9C5386-591D-F5A2-8036-86BB9C5A7A10}"/>
          </ac:spMkLst>
        </pc:spChg>
        <pc:spChg chg="mod">
          <ac:chgData name="Suman, Shankar, Ph.D." userId="5c40f8ff-9e47-4060-8f0c-840d2230e7fd" providerId="ADAL" clId="{85CE6EFC-C947-461A-B6D9-EB162DC25B8B}" dt="2024-06-23T21:39:02.079" v="1170" actId="20577"/>
          <ac:spMkLst>
            <pc:docMk/>
            <pc:sldMk cId="82386172" sldId="258"/>
            <ac:spMk id="4" creationId="{77B976B6-553F-4F55-F2B4-A9734EA88A85}"/>
          </ac:spMkLst>
        </pc:spChg>
        <pc:spChg chg="mod">
          <ac:chgData name="Suman, Shankar, Ph.D." userId="5c40f8ff-9e47-4060-8f0c-840d2230e7fd" providerId="ADAL" clId="{85CE6EFC-C947-461A-B6D9-EB162DC25B8B}" dt="2024-06-25T20:35:18.735" v="1358" actId="165"/>
          <ac:spMkLst>
            <pc:docMk/>
            <pc:sldMk cId="82386172" sldId="258"/>
            <ac:spMk id="7" creationId="{83C1721C-8407-9AC4-3F0D-0FA77DA28F6C}"/>
          </ac:spMkLst>
        </pc:spChg>
        <pc:spChg chg="mod">
          <ac:chgData name="Suman, Shankar, Ph.D." userId="5c40f8ff-9e47-4060-8f0c-840d2230e7fd" providerId="ADAL" clId="{85CE6EFC-C947-461A-B6D9-EB162DC25B8B}" dt="2024-06-25T20:35:18.735" v="1358" actId="165"/>
          <ac:spMkLst>
            <pc:docMk/>
            <pc:sldMk cId="82386172" sldId="258"/>
            <ac:spMk id="8" creationId="{6CF18541-DA42-2B00-AD75-5574B396EC4A}"/>
          </ac:spMkLst>
        </pc:spChg>
        <pc:spChg chg="mod">
          <ac:chgData name="Suman, Shankar, Ph.D." userId="5c40f8ff-9e47-4060-8f0c-840d2230e7fd" providerId="ADAL" clId="{85CE6EFC-C947-461A-B6D9-EB162DC25B8B}" dt="2024-06-25T20:35:18.735" v="1358" actId="165"/>
          <ac:spMkLst>
            <pc:docMk/>
            <pc:sldMk cId="82386172" sldId="258"/>
            <ac:spMk id="9" creationId="{59D14F7B-191A-868B-077D-C82DA328783A}"/>
          </ac:spMkLst>
        </pc:spChg>
        <pc:spChg chg="mod">
          <ac:chgData name="Suman, Shankar, Ph.D." userId="5c40f8ff-9e47-4060-8f0c-840d2230e7fd" providerId="ADAL" clId="{85CE6EFC-C947-461A-B6D9-EB162DC25B8B}" dt="2024-06-25T20:35:18.735" v="1358" actId="165"/>
          <ac:spMkLst>
            <pc:docMk/>
            <pc:sldMk cId="82386172" sldId="258"/>
            <ac:spMk id="10" creationId="{3B8CD912-A0F5-A91D-1F60-845CD222048C}"/>
          </ac:spMkLst>
        </pc:spChg>
        <pc:spChg chg="mod">
          <ac:chgData name="Suman, Shankar, Ph.D." userId="5c40f8ff-9e47-4060-8f0c-840d2230e7fd" providerId="ADAL" clId="{85CE6EFC-C947-461A-B6D9-EB162DC25B8B}" dt="2024-06-25T20:35:18.735" v="1358" actId="165"/>
          <ac:spMkLst>
            <pc:docMk/>
            <pc:sldMk cId="82386172" sldId="258"/>
            <ac:spMk id="14" creationId="{51FC1957-0CE9-1F18-AD8A-64EC1F85DFDF}"/>
          </ac:spMkLst>
        </pc:spChg>
        <pc:spChg chg="mod">
          <ac:chgData name="Suman, Shankar, Ph.D." userId="5c40f8ff-9e47-4060-8f0c-840d2230e7fd" providerId="ADAL" clId="{85CE6EFC-C947-461A-B6D9-EB162DC25B8B}" dt="2024-06-25T20:35:18.735" v="1358" actId="165"/>
          <ac:spMkLst>
            <pc:docMk/>
            <pc:sldMk cId="82386172" sldId="258"/>
            <ac:spMk id="15" creationId="{87D67BAA-8E27-F0EF-FBC2-7173F18727E6}"/>
          </ac:spMkLst>
        </pc:spChg>
        <pc:spChg chg="add mod">
          <ac:chgData name="Suman, Shankar, Ph.D." userId="5c40f8ff-9e47-4060-8f0c-840d2230e7fd" providerId="ADAL" clId="{85CE6EFC-C947-461A-B6D9-EB162DC25B8B}" dt="2024-06-25T20:37:16.923" v="1414" actId="1036"/>
          <ac:spMkLst>
            <pc:docMk/>
            <pc:sldMk cId="82386172" sldId="258"/>
            <ac:spMk id="21" creationId="{99B00CE0-5C07-2D72-BECD-73DE5E011A16}"/>
          </ac:spMkLst>
        </pc:spChg>
        <pc:spChg chg="del mod">
          <ac:chgData name="Suman, Shankar, Ph.D." userId="5c40f8ff-9e47-4060-8f0c-840d2230e7fd" providerId="ADAL" clId="{85CE6EFC-C947-461A-B6D9-EB162DC25B8B}" dt="2024-06-25T20:33:15.142" v="1339" actId="478"/>
          <ac:spMkLst>
            <pc:docMk/>
            <pc:sldMk cId="82386172" sldId="258"/>
            <ac:spMk id="23" creationId="{62987D06-59A5-3393-49D0-3F20628967A5}"/>
          </ac:spMkLst>
        </pc:spChg>
        <pc:spChg chg="mod ord topLvl">
          <ac:chgData name="Suman, Shankar, Ph.D." userId="5c40f8ff-9e47-4060-8f0c-840d2230e7fd" providerId="ADAL" clId="{85CE6EFC-C947-461A-B6D9-EB162DC25B8B}" dt="2024-06-25T20:36:41.598" v="1398" actId="164"/>
          <ac:spMkLst>
            <pc:docMk/>
            <pc:sldMk cId="82386172" sldId="258"/>
            <ac:spMk id="24" creationId="{49BAA0A6-7292-AE93-38C4-4B5849D39561}"/>
          </ac:spMkLst>
        </pc:spChg>
        <pc:grpChg chg="del">
          <ac:chgData name="Suman, Shankar, Ph.D." userId="5c40f8ff-9e47-4060-8f0c-840d2230e7fd" providerId="ADAL" clId="{85CE6EFC-C947-461A-B6D9-EB162DC25B8B}" dt="2024-06-25T20:35:18.735" v="1358" actId="165"/>
          <ac:grpSpMkLst>
            <pc:docMk/>
            <pc:sldMk cId="82386172" sldId="258"/>
            <ac:grpSpMk id="3" creationId="{EF5F2D4D-5009-0A60-B978-E978F385E0D9}"/>
          </ac:grpSpMkLst>
        </pc:grpChg>
        <pc:grpChg chg="mod topLvl">
          <ac:chgData name="Suman, Shankar, Ph.D." userId="5c40f8ff-9e47-4060-8f0c-840d2230e7fd" providerId="ADAL" clId="{85CE6EFC-C947-461A-B6D9-EB162DC25B8B}" dt="2024-06-25T20:36:41.598" v="1398" actId="164"/>
          <ac:grpSpMkLst>
            <pc:docMk/>
            <pc:sldMk cId="82386172" sldId="258"/>
            <ac:grpSpMk id="5" creationId="{E74DA9B1-F74D-7A91-E8AF-86F485C4695E}"/>
          </ac:grpSpMkLst>
        </pc:grpChg>
        <pc:grpChg chg="mod">
          <ac:chgData name="Suman, Shankar, Ph.D." userId="5c40f8ff-9e47-4060-8f0c-840d2230e7fd" providerId="ADAL" clId="{85CE6EFC-C947-461A-B6D9-EB162DC25B8B}" dt="2024-06-25T20:35:18.735" v="1358" actId="165"/>
          <ac:grpSpMkLst>
            <pc:docMk/>
            <pc:sldMk cId="82386172" sldId="258"/>
            <ac:grpSpMk id="11" creationId="{9980C76D-3B07-4BE7-22FF-983AE5A42D40}"/>
          </ac:grpSpMkLst>
        </pc:grpChg>
        <pc:grpChg chg="add mod">
          <ac:chgData name="Suman, Shankar, Ph.D." userId="5c40f8ff-9e47-4060-8f0c-840d2230e7fd" providerId="ADAL" clId="{85CE6EFC-C947-461A-B6D9-EB162DC25B8B}" dt="2024-06-25T20:36:41.598" v="1398" actId="164"/>
          <ac:grpSpMkLst>
            <pc:docMk/>
            <pc:sldMk cId="82386172" sldId="258"/>
            <ac:grpSpMk id="30" creationId="{A8FDA411-C753-040D-BE42-CB7D8FB011B5}"/>
          </ac:grpSpMkLst>
        </pc:grpChg>
        <pc:picChg chg="mod">
          <ac:chgData name="Suman, Shankar, Ph.D." userId="5c40f8ff-9e47-4060-8f0c-840d2230e7fd" providerId="ADAL" clId="{85CE6EFC-C947-461A-B6D9-EB162DC25B8B}" dt="2024-06-25T20:35:18.735" v="1358" actId="165"/>
          <ac:picMkLst>
            <pc:docMk/>
            <pc:sldMk cId="82386172" sldId="258"/>
            <ac:picMk id="6" creationId="{4686E6F7-1A12-C48A-8C4B-366086DB05CE}"/>
          </ac:picMkLst>
        </pc:picChg>
        <pc:picChg chg="mod">
          <ac:chgData name="Suman, Shankar, Ph.D." userId="5c40f8ff-9e47-4060-8f0c-840d2230e7fd" providerId="ADAL" clId="{85CE6EFC-C947-461A-B6D9-EB162DC25B8B}" dt="2024-06-25T20:35:18.735" v="1358" actId="165"/>
          <ac:picMkLst>
            <pc:docMk/>
            <pc:sldMk cId="82386172" sldId="258"/>
            <ac:picMk id="12" creationId="{6F089C6B-F714-9081-55DF-6CBA8F159563}"/>
          </ac:picMkLst>
        </pc:picChg>
        <pc:picChg chg="add mod modCrop">
          <ac:chgData name="Suman, Shankar, Ph.D." userId="5c40f8ff-9e47-4060-8f0c-840d2230e7fd" providerId="ADAL" clId="{85CE6EFC-C947-461A-B6D9-EB162DC25B8B}" dt="2024-06-25T20:36:41.598" v="1398" actId="164"/>
          <ac:picMkLst>
            <pc:docMk/>
            <pc:sldMk cId="82386172" sldId="258"/>
            <ac:picMk id="13" creationId="{6002919C-FD8C-4C7A-2A6F-7C8234449E2A}"/>
          </ac:picMkLst>
        </pc:picChg>
        <pc:picChg chg="mod topLvl modCrop">
          <ac:chgData name="Suman, Shankar, Ph.D." userId="5c40f8ff-9e47-4060-8f0c-840d2230e7fd" providerId="ADAL" clId="{85CE6EFC-C947-461A-B6D9-EB162DC25B8B}" dt="2024-06-25T20:36:41.598" v="1398" actId="164"/>
          <ac:picMkLst>
            <pc:docMk/>
            <pc:sldMk cId="82386172" sldId="258"/>
            <ac:picMk id="22" creationId="{04AB3514-FC06-FB87-4AF9-FF6DCFE4FDF4}"/>
          </ac:picMkLst>
        </pc:picChg>
        <pc:cxnChg chg="add mod">
          <ac:chgData name="Suman, Shankar, Ph.D." userId="5c40f8ff-9e47-4060-8f0c-840d2230e7fd" providerId="ADAL" clId="{85CE6EFC-C947-461A-B6D9-EB162DC25B8B}" dt="2024-06-25T20:36:41.598" v="1398" actId="164"/>
          <ac:cxnSpMkLst>
            <pc:docMk/>
            <pc:sldMk cId="82386172" sldId="258"/>
            <ac:cxnSpMk id="17" creationId="{6BDB89ED-9A10-0104-9B25-270E8270AC84}"/>
          </ac:cxnSpMkLst>
        </pc:cxnChg>
        <pc:cxnChg chg="add mod ord">
          <ac:chgData name="Suman, Shankar, Ph.D." userId="5c40f8ff-9e47-4060-8f0c-840d2230e7fd" providerId="ADAL" clId="{85CE6EFC-C947-461A-B6D9-EB162DC25B8B}" dt="2024-06-25T20:37:18.913" v="1415" actId="14100"/>
          <ac:cxnSpMkLst>
            <pc:docMk/>
            <pc:sldMk cId="82386172" sldId="258"/>
            <ac:cxnSpMk id="25" creationId="{D9D585F9-8140-F1B2-3CE0-D6277CBF983E}"/>
          </ac:cxnSpMkLst>
        </pc:cxnChg>
      </pc:sldChg>
      <pc:sldChg chg="modSp mod">
        <pc:chgData name="Suman, Shankar, Ph.D." userId="5c40f8ff-9e47-4060-8f0c-840d2230e7fd" providerId="ADAL" clId="{85CE6EFC-C947-461A-B6D9-EB162DC25B8B}" dt="2024-06-25T21:20:15.703" v="1428"/>
        <pc:sldMkLst>
          <pc:docMk/>
          <pc:sldMk cId="1006216581" sldId="259"/>
        </pc:sldMkLst>
        <pc:spChg chg="mod">
          <ac:chgData name="Suman, Shankar, Ph.D." userId="5c40f8ff-9e47-4060-8f0c-840d2230e7fd" providerId="ADAL" clId="{85CE6EFC-C947-461A-B6D9-EB162DC25B8B}" dt="2024-06-25T21:20:15.703" v="1428"/>
          <ac:spMkLst>
            <pc:docMk/>
            <pc:sldMk cId="1006216581" sldId="259"/>
            <ac:spMk id="3" creationId="{820AC9B5-EF24-EDC3-A37B-BA9BB9E0EC1B}"/>
          </ac:spMkLst>
        </pc:spChg>
        <pc:spChg chg="mod">
          <ac:chgData name="Suman, Shankar, Ph.D." userId="5c40f8ff-9e47-4060-8f0c-840d2230e7fd" providerId="ADAL" clId="{85CE6EFC-C947-461A-B6D9-EB162DC25B8B}" dt="2024-06-23T21:38:55.463" v="1167" actId="20577"/>
          <ac:spMkLst>
            <pc:docMk/>
            <pc:sldMk cId="1006216581" sldId="259"/>
            <ac:spMk id="4" creationId="{B114B6FA-95FA-4472-9852-72971ABD883E}"/>
          </ac:spMkLst>
        </pc:spChg>
      </pc:sldChg>
      <pc:sldChg chg="addSp delSp modSp mod modNotesTx">
        <pc:chgData name="Suman, Shankar, Ph.D." userId="5c40f8ff-9e47-4060-8f0c-840d2230e7fd" providerId="ADAL" clId="{85CE6EFC-C947-461A-B6D9-EB162DC25B8B}" dt="2024-06-25T21:07:41.294" v="1425"/>
        <pc:sldMkLst>
          <pc:docMk/>
          <pc:sldMk cId="566839228" sldId="260"/>
        </pc:sldMkLst>
        <pc:spChg chg="mod">
          <ac:chgData name="Suman, Shankar, Ph.D." userId="5c40f8ff-9e47-4060-8f0c-840d2230e7fd" providerId="ADAL" clId="{85CE6EFC-C947-461A-B6D9-EB162DC25B8B}" dt="2024-06-23T21:38:43.978" v="1163" actId="20577"/>
          <ac:spMkLst>
            <pc:docMk/>
            <pc:sldMk cId="566839228" sldId="260"/>
            <ac:spMk id="2" creationId="{E2F815E8-B831-BDC7-C3EF-DB50F4996774}"/>
          </ac:spMkLst>
        </pc:spChg>
        <pc:spChg chg="mod">
          <ac:chgData name="Suman, Shankar, Ph.D." userId="5c40f8ff-9e47-4060-8f0c-840d2230e7fd" providerId="ADAL" clId="{85CE6EFC-C947-461A-B6D9-EB162DC25B8B}" dt="2024-06-25T21:07:23.724" v="1423"/>
          <ac:spMkLst>
            <pc:docMk/>
            <pc:sldMk cId="566839228" sldId="260"/>
            <ac:spMk id="12" creationId="{C5DC9843-A5A5-1AF7-108A-B2BDD67A3E83}"/>
          </ac:spMkLst>
        </pc:spChg>
        <pc:spChg chg="mod">
          <ac:chgData name="Suman, Shankar, Ph.D." userId="5c40f8ff-9e47-4060-8f0c-840d2230e7fd" providerId="ADAL" clId="{85CE6EFC-C947-461A-B6D9-EB162DC25B8B}" dt="2024-06-22T21:31:12.174" v="637"/>
          <ac:spMkLst>
            <pc:docMk/>
            <pc:sldMk cId="566839228" sldId="260"/>
            <ac:spMk id="19" creationId="{BE0A6433-A745-DDD7-5BB7-5D9E8582A4F0}"/>
          </ac:spMkLst>
        </pc:spChg>
        <pc:spChg chg="mod">
          <ac:chgData name="Suman, Shankar, Ph.D." userId="5c40f8ff-9e47-4060-8f0c-840d2230e7fd" providerId="ADAL" clId="{85CE6EFC-C947-461A-B6D9-EB162DC25B8B}" dt="2024-06-22T21:34:32.800" v="675" actId="1076"/>
          <ac:spMkLst>
            <pc:docMk/>
            <pc:sldMk cId="566839228" sldId="260"/>
            <ac:spMk id="20" creationId="{0D7D45A5-68CA-3C92-3C88-7E1A2B05B7A3}"/>
          </ac:spMkLst>
        </pc:spChg>
        <pc:spChg chg="mod">
          <ac:chgData name="Suman, Shankar, Ph.D." userId="5c40f8ff-9e47-4060-8f0c-840d2230e7fd" providerId="ADAL" clId="{85CE6EFC-C947-461A-B6D9-EB162DC25B8B}" dt="2024-06-22T21:31:12.174" v="637"/>
          <ac:spMkLst>
            <pc:docMk/>
            <pc:sldMk cId="566839228" sldId="260"/>
            <ac:spMk id="21" creationId="{8338D657-CA0F-A78D-5981-215A82450A68}"/>
          </ac:spMkLst>
        </pc:spChg>
        <pc:spChg chg="mod">
          <ac:chgData name="Suman, Shankar, Ph.D." userId="5c40f8ff-9e47-4060-8f0c-840d2230e7fd" providerId="ADAL" clId="{85CE6EFC-C947-461A-B6D9-EB162DC25B8B}" dt="2024-06-22T21:31:12.174" v="637"/>
          <ac:spMkLst>
            <pc:docMk/>
            <pc:sldMk cId="566839228" sldId="260"/>
            <ac:spMk id="22" creationId="{B6DB34F0-E5C5-9C45-43AC-4AD1B2CFE87D}"/>
          </ac:spMkLst>
        </pc:spChg>
        <pc:spChg chg="mod">
          <ac:chgData name="Suman, Shankar, Ph.D." userId="5c40f8ff-9e47-4060-8f0c-840d2230e7fd" providerId="ADAL" clId="{85CE6EFC-C947-461A-B6D9-EB162DC25B8B}" dt="2024-06-25T21:07:41.294" v="1425"/>
          <ac:spMkLst>
            <pc:docMk/>
            <pc:sldMk cId="566839228" sldId="260"/>
            <ac:spMk id="23" creationId="{628F72F1-5620-380C-A40C-B41335DE8B36}"/>
          </ac:spMkLst>
        </pc:spChg>
        <pc:spChg chg="mod">
          <ac:chgData name="Suman, Shankar, Ph.D." userId="5c40f8ff-9e47-4060-8f0c-840d2230e7fd" providerId="ADAL" clId="{85CE6EFC-C947-461A-B6D9-EB162DC25B8B}" dt="2024-06-22T21:31:12.174" v="637"/>
          <ac:spMkLst>
            <pc:docMk/>
            <pc:sldMk cId="566839228" sldId="260"/>
            <ac:spMk id="24" creationId="{CE2301E8-81DB-6ADC-2FF2-771E955F3448}"/>
          </ac:spMkLst>
        </pc:spChg>
        <pc:spChg chg="mod">
          <ac:chgData name="Suman, Shankar, Ph.D." userId="5c40f8ff-9e47-4060-8f0c-840d2230e7fd" providerId="ADAL" clId="{85CE6EFC-C947-461A-B6D9-EB162DC25B8B}" dt="2024-06-22T21:36:44.673" v="697" actId="20577"/>
          <ac:spMkLst>
            <pc:docMk/>
            <pc:sldMk cId="566839228" sldId="260"/>
            <ac:spMk id="25" creationId="{4C0BBFB2-1A63-E9A8-5728-D3A347F18C37}"/>
          </ac:spMkLst>
        </pc:spChg>
        <pc:grpChg chg="mod">
          <ac:chgData name="Suman, Shankar, Ph.D." userId="5c40f8ff-9e47-4060-8f0c-840d2230e7fd" providerId="ADAL" clId="{85CE6EFC-C947-461A-B6D9-EB162DC25B8B}" dt="2024-06-22T21:37:47.154" v="698" actId="1076"/>
          <ac:grpSpMkLst>
            <pc:docMk/>
            <pc:sldMk cId="566839228" sldId="260"/>
            <ac:grpSpMk id="4" creationId="{436DA0C9-400E-1C30-B32F-D7760D548B11}"/>
          </ac:grpSpMkLst>
        </pc:grpChg>
        <pc:grpChg chg="add mod">
          <ac:chgData name="Suman, Shankar, Ph.D." userId="5c40f8ff-9e47-4060-8f0c-840d2230e7fd" providerId="ADAL" clId="{85CE6EFC-C947-461A-B6D9-EB162DC25B8B}" dt="2024-06-22T21:32:10.438" v="643" actId="1076"/>
          <ac:grpSpMkLst>
            <pc:docMk/>
            <pc:sldMk cId="566839228" sldId="260"/>
            <ac:grpSpMk id="16" creationId="{0F0F4671-07B1-C0F1-DAA0-D90D77703F3C}"/>
          </ac:grpSpMkLst>
        </pc:grpChg>
        <pc:picChg chg="mod modCrop">
          <ac:chgData name="Suman, Shankar, Ph.D." userId="5c40f8ff-9e47-4060-8f0c-840d2230e7fd" providerId="ADAL" clId="{85CE6EFC-C947-461A-B6D9-EB162DC25B8B}" dt="2024-06-22T20:59:29.773" v="622" actId="732"/>
          <ac:picMkLst>
            <pc:docMk/>
            <pc:sldMk cId="566839228" sldId="260"/>
            <ac:picMk id="7" creationId="{7A14FC36-318B-EB7E-8DBE-796453D76CCD}"/>
          </ac:picMkLst>
        </pc:picChg>
        <pc:picChg chg="add del mod modCrop">
          <ac:chgData name="Suman, Shankar, Ph.D." userId="5c40f8ff-9e47-4060-8f0c-840d2230e7fd" providerId="ADAL" clId="{85CE6EFC-C947-461A-B6D9-EB162DC25B8B}" dt="2024-06-22T20:59:10.511" v="621" actId="21"/>
          <ac:picMkLst>
            <pc:docMk/>
            <pc:sldMk cId="566839228" sldId="260"/>
            <ac:picMk id="13" creationId="{7D0135E7-F3EC-71F4-B8AC-2DA92840E23F}"/>
          </ac:picMkLst>
        </pc:picChg>
        <pc:picChg chg="add del mod modCrop">
          <ac:chgData name="Suman, Shankar, Ph.D." userId="5c40f8ff-9e47-4060-8f0c-840d2230e7fd" providerId="ADAL" clId="{85CE6EFC-C947-461A-B6D9-EB162DC25B8B}" dt="2024-06-22T21:00:04.393" v="630" actId="478"/>
          <ac:picMkLst>
            <pc:docMk/>
            <pc:sldMk cId="566839228" sldId="260"/>
            <ac:picMk id="14" creationId="{0304D88A-3FFA-3DDA-8CA8-70A3925E14FC}"/>
          </ac:picMkLst>
        </pc:picChg>
        <pc:picChg chg="add del mod modCrop">
          <ac:chgData name="Suman, Shankar, Ph.D." userId="5c40f8ff-9e47-4060-8f0c-840d2230e7fd" providerId="ADAL" clId="{85CE6EFC-C947-461A-B6D9-EB162DC25B8B}" dt="2024-06-22T21:00:10.817" v="634" actId="478"/>
          <ac:picMkLst>
            <pc:docMk/>
            <pc:sldMk cId="566839228" sldId="260"/>
            <ac:picMk id="15" creationId="{6AC7FAC0-AA4F-E359-7F2A-313A24E593F8}"/>
          </ac:picMkLst>
        </pc:picChg>
        <pc:picChg chg="mod">
          <ac:chgData name="Suman, Shankar, Ph.D." userId="5c40f8ff-9e47-4060-8f0c-840d2230e7fd" providerId="ADAL" clId="{85CE6EFC-C947-461A-B6D9-EB162DC25B8B}" dt="2024-06-22T21:31:12.174" v="637"/>
          <ac:picMkLst>
            <pc:docMk/>
            <pc:sldMk cId="566839228" sldId="260"/>
            <ac:picMk id="26" creationId="{9A09383A-034F-AFF2-7280-408AA75EFC1B}"/>
          </ac:picMkLst>
        </pc:picChg>
      </pc:sldChg>
      <pc:sldChg chg="addSp delSp modSp new mod">
        <pc:chgData name="Suman, Shankar, Ph.D." userId="5c40f8ff-9e47-4060-8f0c-840d2230e7fd" providerId="ADAL" clId="{85CE6EFC-C947-461A-B6D9-EB162DC25B8B}" dt="2024-06-23T21:37:41.608" v="1144" actId="20577"/>
        <pc:sldMkLst>
          <pc:docMk/>
          <pc:sldMk cId="1036054209" sldId="261"/>
        </pc:sldMkLst>
        <pc:spChg chg="del">
          <ac:chgData name="Suman, Shankar, Ph.D." userId="5c40f8ff-9e47-4060-8f0c-840d2230e7fd" providerId="ADAL" clId="{85CE6EFC-C947-461A-B6D9-EB162DC25B8B}" dt="2024-06-12T19:09:21.350" v="1" actId="478"/>
          <ac:spMkLst>
            <pc:docMk/>
            <pc:sldMk cId="1036054209" sldId="261"/>
            <ac:spMk id="2" creationId="{6B047C12-A6BF-6944-8763-22BB2B833B10}"/>
          </ac:spMkLst>
        </pc:spChg>
        <pc:spChg chg="add mod">
          <ac:chgData name="Suman, Shankar, Ph.D." userId="5c40f8ff-9e47-4060-8f0c-840d2230e7fd" providerId="ADAL" clId="{85CE6EFC-C947-461A-B6D9-EB162DC25B8B}" dt="2024-06-23T21:37:41.608" v="1144" actId="20577"/>
          <ac:spMkLst>
            <pc:docMk/>
            <pc:sldMk cId="1036054209" sldId="261"/>
            <ac:spMk id="2" creationId="{E4C726CC-D893-101A-0042-D683C54969DE}"/>
          </ac:spMkLst>
        </pc:spChg>
        <pc:spChg chg="del">
          <ac:chgData name="Suman, Shankar, Ph.D." userId="5c40f8ff-9e47-4060-8f0c-840d2230e7fd" providerId="ADAL" clId="{85CE6EFC-C947-461A-B6D9-EB162DC25B8B}" dt="2024-06-12T19:09:21.350" v="1" actId="478"/>
          <ac:spMkLst>
            <pc:docMk/>
            <pc:sldMk cId="1036054209" sldId="261"/>
            <ac:spMk id="3" creationId="{0AE72E25-2AC3-A441-E0BB-4DA450746AAE}"/>
          </ac:spMkLst>
        </pc:spChg>
        <pc:spChg chg="add mod">
          <ac:chgData name="Suman, Shankar, Ph.D." userId="5c40f8ff-9e47-4060-8f0c-840d2230e7fd" providerId="ADAL" clId="{85CE6EFC-C947-461A-B6D9-EB162DC25B8B}" dt="2024-06-22T23:59:02.563" v="1037" actId="20577"/>
          <ac:spMkLst>
            <pc:docMk/>
            <pc:sldMk cId="1036054209" sldId="261"/>
            <ac:spMk id="3" creationId="{2DD3EF42-6F69-B380-B2AF-5CE84372FC7F}"/>
          </ac:spMkLst>
        </pc:spChg>
        <pc:picChg chg="add mod">
          <ac:chgData name="Suman, Shankar, Ph.D." userId="5c40f8ff-9e47-4060-8f0c-840d2230e7fd" providerId="ADAL" clId="{85CE6EFC-C947-461A-B6D9-EB162DC25B8B}" dt="2024-06-21T23:10:16.923" v="272" actId="1037"/>
          <ac:picMkLst>
            <pc:docMk/>
            <pc:sldMk cId="1036054209" sldId="261"/>
            <ac:picMk id="4" creationId="{2701231C-7D03-0656-40C5-FCA2BA995AC1}"/>
          </ac:picMkLst>
        </pc:picChg>
        <pc:picChg chg="add mod">
          <ac:chgData name="Suman, Shankar, Ph.D." userId="5c40f8ff-9e47-4060-8f0c-840d2230e7fd" providerId="ADAL" clId="{85CE6EFC-C947-461A-B6D9-EB162DC25B8B}" dt="2024-06-21T23:10:16.923" v="272" actId="1037"/>
          <ac:picMkLst>
            <pc:docMk/>
            <pc:sldMk cId="1036054209" sldId="261"/>
            <ac:picMk id="5" creationId="{FBA89740-C6A9-7079-B710-F6CDC980CDB1}"/>
          </ac:picMkLst>
        </pc:picChg>
      </pc:sldChg>
      <pc:sldChg chg="addSp delSp modSp new mod">
        <pc:chgData name="Suman, Shankar, Ph.D." userId="5c40f8ff-9e47-4060-8f0c-840d2230e7fd" providerId="ADAL" clId="{85CE6EFC-C947-461A-B6D9-EB162DC25B8B}" dt="2024-06-25T21:07:18.500" v="1422"/>
        <pc:sldMkLst>
          <pc:docMk/>
          <pc:sldMk cId="3424790429" sldId="262"/>
        </pc:sldMkLst>
        <pc:spChg chg="del">
          <ac:chgData name="Suman, Shankar, Ph.D." userId="5c40f8ff-9e47-4060-8f0c-840d2230e7fd" providerId="ADAL" clId="{85CE6EFC-C947-461A-B6D9-EB162DC25B8B}" dt="2024-06-18T18:24:36.739" v="9" actId="478"/>
          <ac:spMkLst>
            <pc:docMk/>
            <pc:sldMk cId="3424790429" sldId="262"/>
            <ac:spMk id="2" creationId="{70BF7AE9-0DBB-AB5E-685F-6E3BE789807A}"/>
          </ac:spMkLst>
        </pc:spChg>
        <pc:spChg chg="add mod">
          <ac:chgData name="Suman, Shankar, Ph.D." userId="5c40f8ff-9e47-4060-8f0c-840d2230e7fd" providerId="ADAL" clId="{85CE6EFC-C947-461A-B6D9-EB162DC25B8B}" dt="2024-06-25T21:07:18.500" v="1422"/>
          <ac:spMkLst>
            <pc:docMk/>
            <pc:sldMk cId="3424790429" sldId="262"/>
            <ac:spMk id="2" creationId="{B8593C73-85CA-B2D7-075B-E516FDD8F179}"/>
          </ac:spMkLst>
        </pc:spChg>
        <pc:spChg chg="del">
          <ac:chgData name="Suman, Shankar, Ph.D." userId="5c40f8ff-9e47-4060-8f0c-840d2230e7fd" providerId="ADAL" clId="{85CE6EFC-C947-461A-B6D9-EB162DC25B8B}" dt="2024-06-18T18:24:36.739" v="9" actId="478"/>
          <ac:spMkLst>
            <pc:docMk/>
            <pc:sldMk cId="3424790429" sldId="262"/>
            <ac:spMk id="3" creationId="{AD96BB70-EFBD-CF5D-8324-C7611AA4B470}"/>
          </ac:spMkLst>
        </pc:spChg>
        <pc:spChg chg="add mod">
          <ac:chgData name="Suman, Shankar, Ph.D." userId="5c40f8ff-9e47-4060-8f0c-840d2230e7fd" providerId="ADAL" clId="{85CE6EFC-C947-461A-B6D9-EB162DC25B8B}" dt="2024-06-23T21:38:09.608" v="1151" actId="20577"/>
          <ac:spMkLst>
            <pc:docMk/>
            <pc:sldMk cId="3424790429" sldId="262"/>
            <ac:spMk id="4" creationId="{EC249A5D-B850-D349-71F3-CF40E1134F24}"/>
          </ac:spMkLst>
        </pc:spChg>
        <pc:spChg chg="add mod">
          <ac:chgData name="Suman, Shankar, Ph.D." userId="5c40f8ff-9e47-4060-8f0c-840d2230e7fd" providerId="ADAL" clId="{85CE6EFC-C947-461A-B6D9-EB162DC25B8B}" dt="2024-06-18T18:28:09.529" v="107" actId="164"/>
          <ac:spMkLst>
            <pc:docMk/>
            <pc:sldMk cId="3424790429" sldId="262"/>
            <ac:spMk id="8" creationId="{81670BD8-C235-09CF-047A-7DB78C3B397A}"/>
          </ac:spMkLst>
        </pc:spChg>
        <pc:spChg chg="add mod">
          <ac:chgData name="Suman, Shankar, Ph.D." userId="5c40f8ff-9e47-4060-8f0c-840d2230e7fd" providerId="ADAL" clId="{85CE6EFC-C947-461A-B6D9-EB162DC25B8B}" dt="2024-06-18T18:28:09.529" v="107" actId="164"/>
          <ac:spMkLst>
            <pc:docMk/>
            <pc:sldMk cId="3424790429" sldId="262"/>
            <ac:spMk id="9" creationId="{D02739D5-0DCF-25DA-E423-3EC3C547F61E}"/>
          </ac:spMkLst>
        </pc:spChg>
        <pc:spChg chg="add mod">
          <ac:chgData name="Suman, Shankar, Ph.D." userId="5c40f8ff-9e47-4060-8f0c-840d2230e7fd" providerId="ADAL" clId="{85CE6EFC-C947-461A-B6D9-EB162DC25B8B}" dt="2024-06-18T18:28:09.529" v="107" actId="164"/>
          <ac:spMkLst>
            <pc:docMk/>
            <pc:sldMk cId="3424790429" sldId="262"/>
            <ac:spMk id="10" creationId="{E601CBDD-ABE8-5DE5-C1C6-EA31DE0A3B79}"/>
          </ac:spMkLst>
        </pc:spChg>
        <pc:spChg chg="mod">
          <ac:chgData name="Suman, Shankar, Ph.D." userId="5c40f8ff-9e47-4060-8f0c-840d2230e7fd" providerId="ADAL" clId="{85CE6EFC-C947-461A-B6D9-EB162DC25B8B}" dt="2024-06-18T18:28:11.877" v="108"/>
          <ac:spMkLst>
            <pc:docMk/>
            <pc:sldMk cId="3424790429" sldId="262"/>
            <ac:spMk id="14" creationId="{E26F4882-7C41-6441-2DD8-2F78F9255BA8}"/>
          </ac:spMkLst>
        </pc:spChg>
        <pc:spChg chg="mod">
          <ac:chgData name="Suman, Shankar, Ph.D." userId="5c40f8ff-9e47-4060-8f0c-840d2230e7fd" providerId="ADAL" clId="{85CE6EFC-C947-461A-B6D9-EB162DC25B8B}" dt="2024-06-18T18:28:11.877" v="108"/>
          <ac:spMkLst>
            <pc:docMk/>
            <pc:sldMk cId="3424790429" sldId="262"/>
            <ac:spMk id="15" creationId="{8F33BBFF-451F-2BE9-684F-7CBF45FBE953}"/>
          </ac:spMkLst>
        </pc:spChg>
        <pc:spChg chg="mod">
          <ac:chgData name="Suman, Shankar, Ph.D." userId="5c40f8ff-9e47-4060-8f0c-840d2230e7fd" providerId="ADAL" clId="{85CE6EFC-C947-461A-B6D9-EB162DC25B8B}" dt="2024-06-18T18:28:11.877" v="108"/>
          <ac:spMkLst>
            <pc:docMk/>
            <pc:sldMk cId="3424790429" sldId="262"/>
            <ac:spMk id="16" creationId="{E127DC3C-A597-1CC1-D19C-EF30D566B9E5}"/>
          </ac:spMkLst>
        </pc:spChg>
        <pc:spChg chg="add del mod">
          <ac:chgData name="Suman, Shankar, Ph.D." userId="5c40f8ff-9e47-4060-8f0c-840d2230e7fd" providerId="ADAL" clId="{85CE6EFC-C947-461A-B6D9-EB162DC25B8B}" dt="2024-06-21T23:13:29.937" v="275" actId="478"/>
          <ac:spMkLst>
            <pc:docMk/>
            <pc:sldMk cId="3424790429" sldId="262"/>
            <ac:spMk id="17" creationId="{9D708C6B-B0B1-3771-C50F-BB02C2BDF723}"/>
          </ac:spMkLst>
        </pc:spChg>
        <pc:spChg chg="del mod">
          <ac:chgData name="Suman, Shankar, Ph.D." userId="5c40f8ff-9e47-4060-8f0c-840d2230e7fd" providerId="ADAL" clId="{85CE6EFC-C947-461A-B6D9-EB162DC25B8B}" dt="2024-06-18T20:23:25.150" v="143" actId="478"/>
          <ac:spMkLst>
            <pc:docMk/>
            <pc:sldMk cId="3424790429" sldId="262"/>
            <ac:spMk id="24" creationId="{6354824D-E481-60BE-5809-D129627DC18E}"/>
          </ac:spMkLst>
        </pc:spChg>
        <pc:spChg chg="mod">
          <ac:chgData name="Suman, Shankar, Ph.D." userId="5c40f8ff-9e47-4060-8f0c-840d2230e7fd" providerId="ADAL" clId="{85CE6EFC-C947-461A-B6D9-EB162DC25B8B}" dt="2024-06-18T20:24:34.233" v="160" actId="404"/>
          <ac:spMkLst>
            <pc:docMk/>
            <pc:sldMk cId="3424790429" sldId="262"/>
            <ac:spMk id="25" creationId="{B68D1771-CD34-1FFE-D14E-EA422E01E879}"/>
          </ac:spMkLst>
        </pc:spChg>
        <pc:spChg chg="mod">
          <ac:chgData name="Suman, Shankar, Ph.D." userId="5c40f8ff-9e47-4060-8f0c-840d2230e7fd" providerId="ADAL" clId="{85CE6EFC-C947-461A-B6D9-EB162DC25B8B}" dt="2024-06-18T20:24:34.233" v="160" actId="404"/>
          <ac:spMkLst>
            <pc:docMk/>
            <pc:sldMk cId="3424790429" sldId="262"/>
            <ac:spMk id="26" creationId="{25C9E1F7-3651-46AE-CA5A-8E0D87EB1896}"/>
          </ac:spMkLst>
        </pc:spChg>
        <pc:spChg chg="mod">
          <ac:chgData name="Suman, Shankar, Ph.D." userId="5c40f8ff-9e47-4060-8f0c-840d2230e7fd" providerId="ADAL" clId="{85CE6EFC-C947-461A-B6D9-EB162DC25B8B}" dt="2024-06-18T20:24:39.102" v="161"/>
          <ac:spMkLst>
            <pc:docMk/>
            <pc:sldMk cId="3424790429" sldId="262"/>
            <ac:spMk id="29" creationId="{7D9233FD-A4C8-6CD0-AC3A-C3986EDCF516}"/>
          </ac:spMkLst>
        </pc:spChg>
        <pc:spChg chg="mod">
          <ac:chgData name="Suman, Shankar, Ph.D." userId="5c40f8ff-9e47-4060-8f0c-840d2230e7fd" providerId="ADAL" clId="{85CE6EFC-C947-461A-B6D9-EB162DC25B8B}" dt="2024-06-18T20:24:39.102" v="161"/>
          <ac:spMkLst>
            <pc:docMk/>
            <pc:sldMk cId="3424790429" sldId="262"/>
            <ac:spMk id="30" creationId="{6ADAD43E-C236-6AEF-7B54-B5D4161C30A6}"/>
          </ac:spMkLst>
        </pc:spChg>
        <pc:spChg chg="add del mod topLvl">
          <ac:chgData name="Suman, Shankar, Ph.D." userId="5c40f8ff-9e47-4060-8f0c-840d2230e7fd" providerId="ADAL" clId="{85CE6EFC-C947-461A-B6D9-EB162DC25B8B}" dt="2024-06-21T23:16:16.944" v="422" actId="478"/>
          <ac:spMkLst>
            <pc:docMk/>
            <pc:sldMk cId="3424790429" sldId="262"/>
            <ac:spMk id="32" creationId="{08E86DF3-A9CC-5F29-0602-FC6CCDF59130}"/>
          </ac:spMkLst>
        </pc:spChg>
        <pc:grpChg chg="add del mod">
          <ac:chgData name="Suman, Shankar, Ph.D." userId="5c40f8ff-9e47-4060-8f0c-840d2230e7fd" providerId="ADAL" clId="{85CE6EFC-C947-461A-B6D9-EB162DC25B8B}" dt="2024-06-21T23:13:29.937" v="275" actId="478"/>
          <ac:grpSpMkLst>
            <pc:docMk/>
            <pc:sldMk cId="3424790429" sldId="262"/>
            <ac:grpSpMk id="11" creationId="{124BCCD2-2F09-9DDD-6139-DDAFFA343C08}"/>
          </ac:grpSpMkLst>
        </pc:grpChg>
        <pc:grpChg chg="add del mod">
          <ac:chgData name="Suman, Shankar, Ph.D." userId="5c40f8ff-9e47-4060-8f0c-840d2230e7fd" providerId="ADAL" clId="{85CE6EFC-C947-461A-B6D9-EB162DC25B8B}" dt="2024-06-21T23:13:29.937" v="275" actId="478"/>
          <ac:grpSpMkLst>
            <pc:docMk/>
            <pc:sldMk cId="3424790429" sldId="262"/>
            <ac:grpSpMk id="12" creationId="{C1098DB0-F9A5-5740-AAEB-EB62C2F9B121}"/>
          </ac:grpSpMkLst>
        </pc:grpChg>
        <pc:grpChg chg="add mod">
          <ac:chgData name="Suman, Shankar, Ph.D." userId="5c40f8ff-9e47-4060-8f0c-840d2230e7fd" providerId="ADAL" clId="{85CE6EFC-C947-461A-B6D9-EB162DC25B8B}" dt="2024-06-18T20:25:11.715" v="163" actId="164"/>
          <ac:grpSpMkLst>
            <pc:docMk/>
            <pc:sldMk cId="3424790429" sldId="262"/>
            <ac:grpSpMk id="22" creationId="{32C79387-1C47-730E-4EC0-11B628F2BE04}"/>
          </ac:grpSpMkLst>
        </pc:grpChg>
        <pc:grpChg chg="add mod">
          <ac:chgData name="Suman, Shankar, Ph.D." userId="5c40f8ff-9e47-4060-8f0c-840d2230e7fd" providerId="ADAL" clId="{85CE6EFC-C947-461A-B6D9-EB162DC25B8B}" dt="2024-06-18T20:25:11.715" v="163" actId="164"/>
          <ac:grpSpMkLst>
            <pc:docMk/>
            <pc:sldMk cId="3424790429" sldId="262"/>
            <ac:grpSpMk id="27" creationId="{885658A0-48C0-F2EE-F304-CAD6B4627A98}"/>
          </ac:grpSpMkLst>
        </pc:grpChg>
        <pc:grpChg chg="add del mod topLvl">
          <ac:chgData name="Suman, Shankar, Ph.D." userId="5c40f8ff-9e47-4060-8f0c-840d2230e7fd" providerId="ADAL" clId="{85CE6EFC-C947-461A-B6D9-EB162DC25B8B}" dt="2024-06-21T23:16:25.485" v="423" actId="21"/>
          <ac:grpSpMkLst>
            <pc:docMk/>
            <pc:sldMk cId="3424790429" sldId="262"/>
            <ac:grpSpMk id="31" creationId="{934D9966-26FA-1C59-5F0D-DF530097B39B}"/>
          </ac:grpSpMkLst>
        </pc:grpChg>
        <pc:grpChg chg="add del mod">
          <ac:chgData name="Suman, Shankar, Ph.D." userId="5c40f8ff-9e47-4060-8f0c-840d2230e7fd" providerId="ADAL" clId="{85CE6EFC-C947-461A-B6D9-EB162DC25B8B}" dt="2024-06-21T23:16:16.944" v="422" actId="478"/>
          <ac:grpSpMkLst>
            <pc:docMk/>
            <pc:sldMk cId="3424790429" sldId="262"/>
            <ac:grpSpMk id="33" creationId="{798B1746-9642-7227-80AC-A85A8C290961}"/>
          </ac:grpSpMkLst>
        </pc:grpChg>
        <pc:picChg chg="add del">
          <ac:chgData name="Suman, Shankar, Ph.D." userId="5c40f8ff-9e47-4060-8f0c-840d2230e7fd" providerId="ADAL" clId="{85CE6EFC-C947-461A-B6D9-EB162DC25B8B}" dt="2024-06-22T22:27:19.245" v="702" actId="478"/>
          <ac:picMkLst>
            <pc:docMk/>
            <pc:sldMk cId="3424790429" sldId="262"/>
            <ac:picMk id="3" creationId="{D52A7E4F-9189-B633-86F3-9C47D394D3E2}"/>
          </ac:picMkLst>
        </pc:picChg>
        <pc:picChg chg="add del mod modCrop">
          <ac:chgData name="Suman, Shankar, Ph.D." userId="5c40f8ff-9e47-4060-8f0c-840d2230e7fd" providerId="ADAL" clId="{85CE6EFC-C947-461A-B6D9-EB162DC25B8B}" dt="2024-06-21T23:13:27.781" v="274" actId="478"/>
          <ac:picMkLst>
            <pc:docMk/>
            <pc:sldMk cId="3424790429" sldId="262"/>
            <ac:picMk id="5" creationId="{B042994F-004D-47A5-CDF1-1E6453883E49}"/>
          </ac:picMkLst>
        </pc:picChg>
        <pc:picChg chg="add mod modCrop">
          <ac:chgData name="Suman, Shankar, Ph.D." userId="5c40f8ff-9e47-4060-8f0c-840d2230e7fd" providerId="ADAL" clId="{85CE6EFC-C947-461A-B6D9-EB162DC25B8B}" dt="2024-06-22T22:27:35.887" v="709" actId="14100"/>
          <ac:picMkLst>
            <pc:docMk/>
            <pc:sldMk cId="3424790429" sldId="262"/>
            <ac:picMk id="6" creationId="{E7724812-B49F-006B-BB56-05769EC74B40}"/>
          </ac:picMkLst>
        </pc:picChg>
        <pc:picChg chg="add mod">
          <ac:chgData name="Suman, Shankar, Ph.D." userId="5c40f8ff-9e47-4060-8f0c-840d2230e7fd" providerId="ADAL" clId="{85CE6EFC-C947-461A-B6D9-EB162DC25B8B}" dt="2024-06-18T18:28:09.529" v="107" actId="164"/>
          <ac:picMkLst>
            <pc:docMk/>
            <pc:sldMk cId="3424790429" sldId="262"/>
            <ac:picMk id="7" creationId="{12CD3BC5-5DA7-2DAE-2377-374619289C08}"/>
          </ac:picMkLst>
        </pc:picChg>
        <pc:picChg chg="mod">
          <ac:chgData name="Suman, Shankar, Ph.D." userId="5c40f8ff-9e47-4060-8f0c-840d2230e7fd" providerId="ADAL" clId="{85CE6EFC-C947-461A-B6D9-EB162DC25B8B}" dt="2024-06-18T18:28:11.877" v="108"/>
          <ac:picMkLst>
            <pc:docMk/>
            <pc:sldMk cId="3424790429" sldId="262"/>
            <ac:picMk id="13" creationId="{ADCAAFCE-6430-46E0-3D6F-875ADFFBBEDB}"/>
          </ac:picMkLst>
        </pc:picChg>
        <pc:picChg chg="add del mod modCrop">
          <ac:chgData name="Suman, Shankar, Ph.D." userId="5c40f8ff-9e47-4060-8f0c-840d2230e7fd" providerId="ADAL" clId="{85CE6EFC-C947-461A-B6D9-EB162DC25B8B}" dt="2024-06-18T20:22:33.768" v="130" actId="478"/>
          <ac:picMkLst>
            <pc:docMk/>
            <pc:sldMk cId="3424790429" sldId="262"/>
            <ac:picMk id="19" creationId="{14F9AD6B-5DEA-46AD-BD1A-BF4BCAA5AE28}"/>
          </ac:picMkLst>
        </pc:picChg>
        <pc:picChg chg="add mod modCrop">
          <ac:chgData name="Suman, Shankar, Ph.D." userId="5c40f8ff-9e47-4060-8f0c-840d2230e7fd" providerId="ADAL" clId="{85CE6EFC-C947-461A-B6D9-EB162DC25B8B}" dt="2024-06-18T20:25:11.715" v="163" actId="164"/>
          <ac:picMkLst>
            <pc:docMk/>
            <pc:sldMk cId="3424790429" sldId="262"/>
            <ac:picMk id="21" creationId="{D7CB5BBA-9F91-0FC4-183E-4E4C5D06B2A7}"/>
          </ac:picMkLst>
        </pc:picChg>
        <pc:picChg chg="mod modCrop">
          <ac:chgData name="Suman, Shankar, Ph.D." userId="5c40f8ff-9e47-4060-8f0c-840d2230e7fd" providerId="ADAL" clId="{85CE6EFC-C947-461A-B6D9-EB162DC25B8B}" dt="2024-06-18T20:24:10.769" v="146" actId="732"/>
          <ac:picMkLst>
            <pc:docMk/>
            <pc:sldMk cId="3424790429" sldId="262"/>
            <ac:picMk id="23" creationId="{EB977E2C-F237-A70E-3486-EFB0F7064279}"/>
          </ac:picMkLst>
        </pc:picChg>
        <pc:picChg chg="mod">
          <ac:chgData name="Suman, Shankar, Ph.D." userId="5c40f8ff-9e47-4060-8f0c-840d2230e7fd" providerId="ADAL" clId="{85CE6EFC-C947-461A-B6D9-EB162DC25B8B}" dt="2024-06-18T20:24:39.102" v="161"/>
          <ac:picMkLst>
            <pc:docMk/>
            <pc:sldMk cId="3424790429" sldId="262"/>
            <ac:picMk id="28" creationId="{29960FC0-C144-D223-7D8F-47F80A00293C}"/>
          </ac:picMkLst>
        </pc:picChg>
      </pc:sldChg>
      <pc:sldChg chg="new del">
        <pc:chgData name="Suman, Shankar, Ph.D." userId="5c40f8ff-9e47-4060-8f0c-840d2230e7fd" providerId="ADAL" clId="{85CE6EFC-C947-461A-B6D9-EB162DC25B8B}" dt="2024-06-21T23:14:09.615" v="284" actId="47"/>
        <pc:sldMkLst>
          <pc:docMk/>
          <pc:sldMk cId="956948201" sldId="263"/>
        </pc:sldMkLst>
      </pc:sldChg>
      <pc:sldChg chg="addSp delSp modSp add mod ord">
        <pc:chgData name="Suman, Shankar, Ph.D." userId="5c40f8ff-9e47-4060-8f0c-840d2230e7fd" providerId="ADAL" clId="{85CE6EFC-C947-461A-B6D9-EB162DC25B8B}" dt="2024-06-25T21:08:33.334" v="1426"/>
        <pc:sldMkLst>
          <pc:docMk/>
          <pc:sldMk cId="1522125892" sldId="263"/>
        </pc:sldMkLst>
        <pc:spChg chg="mod">
          <ac:chgData name="Suman, Shankar, Ph.D." userId="5c40f8ff-9e47-4060-8f0c-840d2230e7fd" providerId="ADAL" clId="{85CE6EFC-C947-461A-B6D9-EB162DC25B8B}" dt="2024-06-23T21:38:32.448" v="1159" actId="20577"/>
          <ac:spMkLst>
            <pc:docMk/>
            <pc:sldMk cId="1522125892" sldId="263"/>
            <ac:spMk id="2" creationId="{E2F815E8-B831-BDC7-C3EF-DB50F4996774}"/>
          </ac:spMkLst>
        </pc:spChg>
        <pc:spChg chg="mod">
          <ac:chgData name="Suman, Shankar, Ph.D." userId="5c40f8ff-9e47-4060-8f0c-840d2230e7fd" providerId="ADAL" clId="{85CE6EFC-C947-461A-B6D9-EB162DC25B8B}" dt="2024-06-25T21:08:33.334" v="1426"/>
          <ac:spMkLst>
            <pc:docMk/>
            <pc:sldMk cId="1522125892" sldId="263"/>
            <ac:spMk id="12" creationId="{C5DC9843-A5A5-1AF7-108A-B2BDD67A3E83}"/>
          </ac:spMkLst>
        </pc:spChg>
        <pc:spChg chg="mod topLvl">
          <ac:chgData name="Suman, Shankar, Ph.D." userId="5c40f8ff-9e47-4060-8f0c-840d2230e7fd" providerId="ADAL" clId="{85CE6EFC-C947-461A-B6D9-EB162DC25B8B}" dt="2024-06-23T21:54:13.131" v="1321" actId="164"/>
          <ac:spMkLst>
            <pc:docMk/>
            <pc:sldMk cId="1522125892" sldId="263"/>
            <ac:spMk id="13" creationId="{1398F2A7-C9A7-43B4-6013-15B91A56B8E9}"/>
          </ac:spMkLst>
        </pc:spChg>
        <pc:spChg chg="mod topLvl">
          <ac:chgData name="Suman, Shankar, Ph.D." userId="5c40f8ff-9e47-4060-8f0c-840d2230e7fd" providerId="ADAL" clId="{85CE6EFC-C947-461A-B6D9-EB162DC25B8B}" dt="2024-06-23T21:54:13.131" v="1321" actId="164"/>
          <ac:spMkLst>
            <pc:docMk/>
            <pc:sldMk cId="1522125892" sldId="263"/>
            <ac:spMk id="14" creationId="{B21EA18A-AFFE-A99B-A7FD-A60679F01D19}"/>
          </ac:spMkLst>
        </pc:spChg>
        <pc:spChg chg="mod topLvl">
          <ac:chgData name="Suman, Shankar, Ph.D." userId="5c40f8ff-9e47-4060-8f0c-840d2230e7fd" providerId="ADAL" clId="{85CE6EFC-C947-461A-B6D9-EB162DC25B8B}" dt="2024-06-23T21:54:13.131" v="1321" actId="164"/>
          <ac:spMkLst>
            <pc:docMk/>
            <pc:sldMk cId="1522125892" sldId="263"/>
            <ac:spMk id="15" creationId="{971041E7-E61B-0558-8B9F-83B569DD569E}"/>
          </ac:spMkLst>
        </pc:spChg>
        <pc:spChg chg="mod topLvl">
          <ac:chgData name="Suman, Shankar, Ph.D." userId="5c40f8ff-9e47-4060-8f0c-840d2230e7fd" providerId="ADAL" clId="{85CE6EFC-C947-461A-B6D9-EB162DC25B8B}" dt="2024-06-23T21:54:13.131" v="1321" actId="164"/>
          <ac:spMkLst>
            <pc:docMk/>
            <pc:sldMk cId="1522125892" sldId="263"/>
            <ac:spMk id="16" creationId="{7F633B3A-B94A-7E59-3850-8C5351ED12D4}"/>
          </ac:spMkLst>
        </pc:spChg>
        <pc:spChg chg="del">
          <ac:chgData name="Suman, Shankar, Ph.D." userId="5c40f8ff-9e47-4060-8f0c-840d2230e7fd" providerId="ADAL" clId="{85CE6EFC-C947-461A-B6D9-EB162DC25B8B}" dt="2024-06-22T00:37:19.805" v="429" actId="478"/>
          <ac:spMkLst>
            <pc:docMk/>
            <pc:sldMk cId="1522125892" sldId="263"/>
            <ac:spMk id="17" creationId="{561B2D43-FD6C-5C23-5D6F-A705620DC80D}"/>
          </ac:spMkLst>
        </pc:spChg>
        <pc:spChg chg="del">
          <ac:chgData name="Suman, Shankar, Ph.D." userId="5c40f8ff-9e47-4060-8f0c-840d2230e7fd" providerId="ADAL" clId="{85CE6EFC-C947-461A-B6D9-EB162DC25B8B}" dt="2024-06-22T00:37:19.805" v="429" actId="478"/>
          <ac:spMkLst>
            <pc:docMk/>
            <pc:sldMk cId="1522125892" sldId="263"/>
            <ac:spMk id="18" creationId="{C47E9812-246F-4DC9-A7D8-E876D8AC0BD4}"/>
          </ac:spMkLst>
        </pc:spChg>
        <pc:spChg chg="mod topLvl">
          <ac:chgData name="Suman, Shankar, Ph.D." userId="5c40f8ff-9e47-4060-8f0c-840d2230e7fd" providerId="ADAL" clId="{85CE6EFC-C947-461A-B6D9-EB162DC25B8B}" dt="2024-06-23T21:54:13.131" v="1321" actId="164"/>
          <ac:spMkLst>
            <pc:docMk/>
            <pc:sldMk cId="1522125892" sldId="263"/>
            <ac:spMk id="19" creationId="{A8307FE9-B194-BCA4-3ADB-464C466A46A2}"/>
          </ac:spMkLst>
        </pc:spChg>
        <pc:spChg chg="mod topLvl">
          <ac:chgData name="Suman, Shankar, Ph.D." userId="5c40f8ff-9e47-4060-8f0c-840d2230e7fd" providerId="ADAL" clId="{85CE6EFC-C947-461A-B6D9-EB162DC25B8B}" dt="2024-06-23T21:54:13.131" v="1321" actId="164"/>
          <ac:spMkLst>
            <pc:docMk/>
            <pc:sldMk cId="1522125892" sldId="263"/>
            <ac:spMk id="20" creationId="{654CB50D-0E7D-4C07-BC7F-C3679195CB1C}"/>
          </ac:spMkLst>
        </pc:spChg>
        <pc:spChg chg="mod topLvl">
          <ac:chgData name="Suman, Shankar, Ph.D." userId="5c40f8ff-9e47-4060-8f0c-840d2230e7fd" providerId="ADAL" clId="{85CE6EFC-C947-461A-B6D9-EB162DC25B8B}" dt="2024-06-23T21:54:13.131" v="1321" actId="164"/>
          <ac:spMkLst>
            <pc:docMk/>
            <pc:sldMk cId="1522125892" sldId="263"/>
            <ac:spMk id="21" creationId="{0E376937-413B-085C-68FA-3B2FD8614C0A}"/>
          </ac:spMkLst>
        </pc:spChg>
        <pc:spChg chg="mod topLvl">
          <ac:chgData name="Suman, Shankar, Ph.D." userId="5c40f8ff-9e47-4060-8f0c-840d2230e7fd" providerId="ADAL" clId="{85CE6EFC-C947-461A-B6D9-EB162DC25B8B}" dt="2024-06-23T21:54:13.131" v="1321" actId="164"/>
          <ac:spMkLst>
            <pc:docMk/>
            <pc:sldMk cId="1522125892" sldId="263"/>
            <ac:spMk id="22" creationId="{441D9533-87DD-467F-BB18-DC397FB20C57}"/>
          </ac:spMkLst>
        </pc:spChg>
        <pc:spChg chg="add mod">
          <ac:chgData name="Suman, Shankar, Ph.D." userId="5c40f8ff-9e47-4060-8f0c-840d2230e7fd" providerId="ADAL" clId="{85CE6EFC-C947-461A-B6D9-EB162DC25B8B}" dt="2024-06-23T21:54:13.131" v="1321" actId="164"/>
          <ac:spMkLst>
            <pc:docMk/>
            <pc:sldMk cId="1522125892" sldId="263"/>
            <ac:spMk id="24" creationId="{1933ECF1-307B-40BD-4712-FEB2EC1E102E}"/>
          </ac:spMkLst>
        </pc:spChg>
        <pc:spChg chg="add mod">
          <ac:chgData name="Suman, Shankar, Ph.D." userId="5c40f8ff-9e47-4060-8f0c-840d2230e7fd" providerId="ADAL" clId="{85CE6EFC-C947-461A-B6D9-EB162DC25B8B}" dt="2024-06-23T21:54:13.131" v="1321" actId="164"/>
          <ac:spMkLst>
            <pc:docMk/>
            <pc:sldMk cId="1522125892" sldId="263"/>
            <ac:spMk id="25" creationId="{ECE05CA0-DB22-3069-9DE9-06B9C3632B8E}"/>
          </ac:spMkLst>
        </pc:spChg>
        <pc:grpChg chg="add del mod">
          <ac:chgData name="Suman, Shankar, Ph.D." userId="5c40f8ff-9e47-4060-8f0c-840d2230e7fd" providerId="ADAL" clId="{85CE6EFC-C947-461A-B6D9-EB162DC25B8B}" dt="2024-06-23T21:50:30.911" v="1194" actId="165"/>
          <ac:grpSpMkLst>
            <pc:docMk/>
            <pc:sldMk cId="1522125892" sldId="263"/>
            <ac:grpSpMk id="3" creationId="{A95E8470-318A-6B6E-44E5-FAF33F91A1F8}"/>
          </ac:grpSpMkLst>
        </pc:grpChg>
        <pc:grpChg chg="del">
          <ac:chgData name="Suman, Shankar, Ph.D." userId="5c40f8ff-9e47-4060-8f0c-840d2230e7fd" providerId="ADAL" clId="{85CE6EFC-C947-461A-B6D9-EB162DC25B8B}" dt="2024-06-22T00:37:19.805" v="429" actId="478"/>
          <ac:grpSpMkLst>
            <pc:docMk/>
            <pc:sldMk cId="1522125892" sldId="263"/>
            <ac:grpSpMk id="4" creationId="{436DA0C9-400E-1C30-B32F-D7760D548B11}"/>
          </ac:grpSpMkLst>
        </pc:grpChg>
        <pc:grpChg chg="add mod">
          <ac:chgData name="Suman, Shankar, Ph.D." userId="5c40f8ff-9e47-4060-8f0c-840d2230e7fd" providerId="ADAL" clId="{85CE6EFC-C947-461A-B6D9-EB162DC25B8B}" dt="2024-06-23T21:54:20.702" v="1322" actId="1076"/>
          <ac:grpSpMkLst>
            <pc:docMk/>
            <pc:sldMk cId="1522125892" sldId="263"/>
            <ac:grpSpMk id="26" creationId="{B3618958-AB2F-02AC-B551-8936C2A611B5}"/>
          </ac:grpSpMkLst>
        </pc:grpChg>
        <pc:picChg chg="mod topLvl">
          <ac:chgData name="Suman, Shankar, Ph.D." userId="5c40f8ff-9e47-4060-8f0c-840d2230e7fd" providerId="ADAL" clId="{85CE6EFC-C947-461A-B6D9-EB162DC25B8B}" dt="2024-06-23T21:54:13.131" v="1321" actId="164"/>
          <ac:picMkLst>
            <pc:docMk/>
            <pc:sldMk cId="1522125892" sldId="263"/>
            <ac:picMk id="23" creationId="{A195D733-0BC3-ED16-AE85-4E43191E725B}"/>
          </ac:picMkLst>
        </pc:picChg>
      </pc:sldChg>
      <pc:sldChg chg="addSp delSp modSp new mod">
        <pc:chgData name="Suman, Shankar, Ph.D." userId="5c40f8ff-9e47-4060-8f0c-840d2230e7fd" providerId="ADAL" clId="{85CE6EFC-C947-461A-B6D9-EB162DC25B8B}" dt="2024-06-23T21:38:21.651" v="1155" actId="20577"/>
        <pc:sldMkLst>
          <pc:docMk/>
          <pc:sldMk cId="2446168973" sldId="264"/>
        </pc:sldMkLst>
        <pc:spChg chg="del">
          <ac:chgData name="Suman, Shankar, Ph.D." userId="5c40f8ff-9e47-4060-8f0c-840d2230e7fd" providerId="ADAL" clId="{85CE6EFC-C947-461A-B6D9-EB162DC25B8B}" dt="2024-06-22T00:42:53.843" v="479" actId="478"/>
          <ac:spMkLst>
            <pc:docMk/>
            <pc:sldMk cId="2446168973" sldId="264"/>
            <ac:spMk id="2" creationId="{3AAE4760-ABC8-7FC5-4013-53AB48EB0E7B}"/>
          </ac:spMkLst>
        </pc:spChg>
        <pc:spChg chg="del">
          <ac:chgData name="Suman, Shankar, Ph.D." userId="5c40f8ff-9e47-4060-8f0c-840d2230e7fd" providerId="ADAL" clId="{85CE6EFC-C947-461A-B6D9-EB162DC25B8B}" dt="2024-06-22T00:42:53.843" v="479" actId="478"/>
          <ac:spMkLst>
            <pc:docMk/>
            <pc:sldMk cId="2446168973" sldId="264"/>
            <ac:spMk id="3" creationId="{660AD367-7AA3-C9B7-F918-AD368CF71422}"/>
          </ac:spMkLst>
        </pc:spChg>
        <pc:spChg chg="add mod">
          <ac:chgData name="Suman, Shankar, Ph.D." userId="5c40f8ff-9e47-4060-8f0c-840d2230e7fd" providerId="ADAL" clId="{85CE6EFC-C947-461A-B6D9-EB162DC25B8B}" dt="2024-06-23T21:38:16.517" v="1153" actId="20577"/>
          <ac:spMkLst>
            <pc:docMk/>
            <pc:sldMk cId="2446168973" sldId="264"/>
            <ac:spMk id="7" creationId="{3B7E09B5-C024-E6EA-6FF7-0F7A1792A5A6}"/>
          </ac:spMkLst>
        </pc:spChg>
        <pc:spChg chg="add mod">
          <ac:chgData name="Suman, Shankar, Ph.D." userId="5c40f8ff-9e47-4060-8f0c-840d2230e7fd" providerId="ADAL" clId="{85CE6EFC-C947-461A-B6D9-EB162DC25B8B}" dt="2024-06-23T21:38:21.651" v="1155" actId="20577"/>
          <ac:spMkLst>
            <pc:docMk/>
            <pc:sldMk cId="2446168973" sldId="264"/>
            <ac:spMk id="8" creationId="{61EBC360-C322-0FFA-3AE4-8E35F0C94625}"/>
          </ac:spMkLst>
        </pc:spChg>
        <pc:grpChg chg="add mod">
          <ac:chgData name="Suman, Shankar, Ph.D." userId="5c40f8ff-9e47-4060-8f0c-840d2230e7fd" providerId="ADAL" clId="{85CE6EFC-C947-461A-B6D9-EB162DC25B8B}" dt="2024-06-22T00:44:12.086" v="546" actId="1076"/>
          <ac:grpSpMkLst>
            <pc:docMk/>
            <pc:sldMk cId="2446168973" sldId="264"/>
            <ac:grpSpMk id="4" creationId="{EB097855-54EC-D2F4-0F70-0209730AAE86}"/>
          </ac:grpSpMkLst>
        </pc:grpChg>
        <pc:picChg chg="mod">
          <ac:chgData name="Suman, Shankar, Ph.D." userId="5c40f8ff-9e47-4060-8f0c-840d2230e7fd" providerId="ADAL" clId="{85CE6EFC-C947-461A-B6D9-EB162DC25B8B}" dt="2024-06-22T00:42:54.959" v="480"/>
          <ac:picMkLst>
            <pc:docMk/>
            <pc:sldMk cId="2446168973" sldId="264"/>
            <ac:picMk id="5" creationId="{B69DC839-389A-C9BC-CE15-7DDED2829DBF}"/>
          </ac:picMkLst>
        </pc:picChg>
        <pc:picChg chg="mod">
          <ac:chgData name="Suman, Shankar, Ph.D." userId="5c40f8ff-9e47-4060-8f0c-840d2230e7fd" providerId="ADAL" clId="{85CE6EFC-C947-461A-B6D9-EB162DC25B8B}" dt="2024-06-22T00:43:16.232" v="488" actId="1076"/>
          <ac:picMkLst>
            <pc:docMk/>
            <pc:sldMk cId="2446168973" sldId="264"/>
            <ac:picMk id="6" creationId="{03A200D9-EBF8-BC43-1F8D-111172E70BCF}"/>
          </ac:picMkLst>
        </pc:picChg>
      </pc:sldChg>
      <pc:sldChg chg="addSp delSp modSp new mod">
        <pc:chgData name="Suman, Shankar, Ph.D." userId="5c40f8ff-9e47-4060-8f0c-840d2230e7fd" providerId="ADAL" clId="{85CE6EFC-C947-461A-B6D9-EB162DC25B8B}" dt="2024-06-25T20:37:45.313" v="1416" actId="20577"/>
        <pc:sldMkLst>
          <pc:docMk/>
          <pc:sldMk cId="2121734264" sldId="265"/>
        </pc:sldMkLst>
        <pc:spChg chg="del">
          <ac:chgData name="Suman, Shankar, Ph.D." userId="5c40f8ff-9e47-4060-8f0c-840d2230e7fd" providerId="ADAL" clId="{85CE6EFC-C947-461A-B6D9-EB162DC25B8B}" dt="2024-06-22T23:46:10.334" v="729" actId="478"/>
          <ac:spMkLst>
            <pc:docMk/>
            <pc:sldMk cId="2121734264" sldId="265"/>
            <ac:spMk id="2" creationId="{161905EA-91E9-6F65-FE50-9C83A3C0B491}"/>
          </ac:spMkLst>
        </pc:spChg>
        <pc:spChg chg="del">
          <ac:chgData name="Suman, Shankar, Ph.D." userId="5c40f8ff-9e47-4060-8f0c-840d2230e7fd" providerId="ADAL" clId="{85CE6EFC-C947-461A-B6D9-EB162DC25B8B}" dt="2024-06-22T23:46:10.334" v="729" actId="478"/>
          <ac:spMkLst>
            <pc:docMk/>
            <pc:sldMk cId="2121734264" sldId="265"/>
            <ac:spMk id="3" creationId="{75D2764E-D8E1-CE46-3FA6-D6C6B349E2E2}"/>
          </ac:spMkLst>
        </pc:spChg>
        <pc:spChg chg="add mod">
          <ac:chgData name="Suman, Shankar, Ph.D." userId="5c40f8ff-9e47-4060-8f0c-840d2230e7fd" providerId="ADAL" clId="{85CE6EFC-C947-461A-B6D9-EB162DC25B8B}" dt="2024-06-22T23:49:20.629" v="799" actId="1076"/>
          <ac:spMkLst>
            <pc:docMk/>
            <pc:sldMk cId="2121734264" sldId="265"/>
            <ac:spMk id="4" creationId="{3B5FCC86-00B9-7478-D736-6BB27A34F587}"/>
          </ac:spMkLst>
        </pc:spChg>
        <pc:spChg chg="add mod">
          <ac:chgData name="Suman, Shankar, Ph.D." userId="5c40f8ff-9e47-4060-8f0c-840d2230e7fd" providerId="ADAL" clId="{85CE6EFC-C947-461A-B6D9-EB162DC25B8B}" dt="2024-06-22T23:52:58.468" v="1025" actId="1076"/>
          <ac:spMkLst>
            <pc:docMk/>
            <pc:sldMk cId="2121734264" sldId="265"/>
            <ac:spMk id="6" creationId="{8AAB1EBA-CD04-1C76-A055-9886ACC15518}"/>
          </ac:spMkLst>
        </pc:spChg>
        <pc:spChg chg="add mod">
          <ac:chgData name="Suman, Shankar, Ph.D." userId="5c40f8ff-9e47-4060-8f0c-840d2230e7fd" providerId="ADAL" clId="{85CE6EFC-C947-461A-B6D9-EB162DC25B8B}" dt="2024-06-22T23:48:17.183" v="785" actId="14100"/>
          <ac:spMkLst>
            <pc:docMk/>
            <pc:sldMk cId="2121734264" sldId="265"/>
            <ac:spMk id="7" creationId="{4DB09F1D-E908-5400-87D6-4911A63BA4AF}"/>
          </ac:spMkLst>
        </pc:spChg>
        <pc:spChg chg="add mod">
          <ac:chgData name="Suman, Shankar, Ph.D." userId="5c40f8ff-9e47-4060-8f0c-840d2230e7fd" providerId="ADAL" clId="{85CE6EFC-C947-461A-B6D9-EB162DC25B8B}" dt="2024-06-25T20:37:45.313" v="1416" actId="20577"/>
          <ac:spMkLst>
            <pc:docMk/>
            <pc:sldMk cId="2121734264" sldId="265"/>
            <ac:spMk id="9" creationId="{5E69EF5F-054C-9DA8-BF5F-A943A256D27B}"/>
          </ac:spMkLst>
        </pc:spChg>
        <pc:picChg chg="add mod">
          <ac:chgData name="Suman, Shankar, Ph.D." userId="5c40f8ff-9e47-4060-8f0c-840d2230e7fd" providerId="ADAL" clId="{85CE6EFC-C947-461A-B6D9-EB162DC25B8B}" dt="2024-06-22T23:46:18.275" v="732" actId="1076"/>
          <ac:picMkLst>
            <pc:docMk/>
            <pc:sldMk cId="2121734264" sldId="265"/>
            <ac:picMk id="1026" creationId="{9030184C-C864-2041-DBD0-37451DC93DF7}"/>
          </ac:picMkLst>
        </pc:picChg>
      </pc:sldChg>
      <pc:sldChg chg="addSp delSp modSp new mod">
        <pc:chgData name="Suman, Shankar, Ph.D." userId="5c40f8ff-9e47-4060-8f0c-840d2230e7fd" providerId="ADAL" clId="{85CE6EFC-C947-461A-B6D9-EB162DC25B8B}" dt="2024-07-10T16:30:53.597" v="1680" actId="1076"/>
        <pc:sldMkLst>
          <pc:docMk/>
          <pc:sldMk cId="282446702" sldId="266"/>
        </pc:sldMkLst>
        <pc:spChg chg="mod">
          <ac:chgData name="Suman, Shankar, Ph.D." userId="5c40f8ff-9e47-4060-8f0c-840d2230e7fd" providerId="ADAL" clId="{85CE6EFC-C947-461A-B6D9-EB162DC25B8B}" dt="2024-07-10T16:30:53.597" v="1680" actId="1076"/>
          <ac:spMkLst>
            <pc:docMk/>
            <pc:sldMk cId="282446702" sldId="266"/>
            <ac:spMk id="2" creationId="{6B1B4430-331E-417E-287E-D4C0883E2479}"/>
          </ac:spMkLst>
        </pc:spChg>
        <pc:spChg chg="del">
          <ac:chgData name="Suman, Shankar, Ph.D." userId="5c40f8ff-9e47-4060-8f0c-840d2230e7fd" providerId="ADAL" clId="{85CE6EFC-C947-461A-B6D9-EB162DC25B8B}" dt="2024-07-10T15:22:32.735" v="1508" actId="478"/>
          <ac:spMkLst>
            <pc:docMk/>
            <pc:sldMk cId="282446702" sldId="266"/>
            <ac:spMk id="3" creationId="{2563442A-8F7B-0AE5-8466-950801FFE628}"/>
          </ac:spMkLst>
        </pc:spChg>
        <pc:spChg chg="add del mod">
          <ac:chgData name="Suman, Shankar, Ph.D." userId="5c40f8ff-9e47-4060-8f0c-840d2230e7fd" providerId="ADAL" clId="{85CE6EFC-C947-461A-B6D9-EB162DC25B8B}" dt="2024-07-10T16:24:51.595" v="1644" actId="478"/>
          <ac:spMkLst>
            <pc:docMk/>
            <pc:sldMk cId="282446702" sldId="266"/>
            <ac:spMk id="12" creationId="{8020A4F1-0F10-9026-19F3-B5E3043C3E61}"/>
          </ac:spMkLst>
        </pc:spChg>
        <pc:picChg chg="add del">
          <ac:chgData name="Suman, Shankar, Ph.D." userId="5c40f8ff-9e47-4060-8f0c-840d2230e7fd" providerId="ADAL" clId="{85CE6EFC-C947-461A-B6D9-EB162DC25B8B}" dt="2024-07-10T15:22:52.702" v="1523" actId="478"/>
          <ac:picMkLst>
            <pc:docMk/>
            <pc:sldMk cId="282446702" sldId="266"/>
            <ac:picMk id="5" creationId="{1C0693AB-E8C2-8288-760F-76E2DC629E72}"/>
          </ac:picMkLst>
        </pc:picChg>
        <pc:picChg chg="add del">
          <ac:chgData name="Suman, Shankar, Ph.D." userId="5c40f8ff-9e47-4060-8f0c-840d2230e7fd" providerId="ADAL" clId="{85CE6EFC-C947-461A-B6D9-EB162DC25B8B}" dt="2024-07-10T15:22:58.016" v="1525" actId="478"/>
          <ac:picMkLst>
            <pc:docMk/>
            <pc:sldMk cId="282446702" sldId="266"/>
            <ac:picMk id="7" creationId="{BFC4A982-2F54-7427-6B7D-C47B9C961E06}"/>
          </ac:picMkLst>
        </pc:picChg>
        <pc:picChg chg="add mod">
          <ac:chgData name="Suman, Shankar, Ph.D." userId="5c40f8ff-9e47-4060-8f0c-840d2230e7fd" providerId="ADAL" clId="{85CE6EFC-C947-461A-B6D9-EB162DC25B8B}" dt="2024-07-10T16:24:54.169" v="1645" actId="1076"/>
          <ac:picMkLst>
            <pc:docMk/>
            <pc:sldMk cId="282446702" sldId="266"/>
            <ac:picMk id="9" creationId="{285E4982-0225-62C3-5F11-770BD66657C5}"/>
          </ac:picMkLst>
        </pc:picChg>
        <pc:picChg chg="add mod modCrop">
          <ac:chgData name="Suman, Shankar, Ph.D." userId="5c40f8ff-9e47-4060-8f0c-840d2230e7fd" providerId="ADAL" clId="{85CE6EFC-C947-461A-B6D9-EB162DC25B8B}" dt="2024-07-10T16:24:54.169" v="1645" actId="1076"/>
          <ac:picMkLst>
            <pc:docMk/>
            <pc:sldMk cId="282446702" sldId="266"/>
            <ac:picMk id="11" creationId="{94480890-614C-67CB-C35A-976499390AD6}"/>
          </ac:picMkLst>
        </pc:picChg>
        <pc:picChg chg="add del">
          <ac:chgData name="Suman, Shankar, Ph.D." userId="5c40f8ff-9e47-4060-8f0c-840d2230e7fd" providerId="ADAL" clId="{85CE6EFC-C947-461A-B6D9-EB162DC25B8B}" dt="2024-07-10T16:17:09.823" v="1569" actId="478"/>
          <ac:picMkLst>
            <pc:docMk/>
            <pc:sldMk cId="282446702" sldId="266"/>
            <ac:picMk id="14" creationId="{EF865CA2-8F3B-8959-E538-7A10E039E41A}"/>
          </ac:picMkLst>
        </pc:picChg>
        <pc:picChg chg="add del">
          <ac:chgData name="Suman, Shankar, Ph.D." userId="5c40f8ff-9e47-4060-8f0c-840d2230e7fd" providerId="ADAL" clId="{85CE6EFC-C947-461A-B6D9-EB162DC25B8B}" dt="2024-07-10T16:17:22.603" v="1571" actId="478"/>
          <ac:picMkLst>
            <pc:docMk/>
            <pc:sldMk cId="282446702" sldId="266"/>
            <ac:picMk id="16" creationId="{DC47C1EF-C5D2-9A16-120F-EE3A6F817B10}"/>
          </ac:picMkLst>
        </pc:picChg>
        <pc:picChg chg="add del">
          <ac:chgData name="Suman, Shankar, Ph.D." userId="5c40f8ff-9e47-4060-8f0c-840d2230e7fd" providerId="ADAL" clId="{85CE6EFC-C947-461A-B6D9-EB162DC25B8B}" dt="2024-07-10T16:17:34.463" v="1573" actId="478"/>
          <ac:picMkLst>
            <pc:docMk/>
            <pc:sldMk cId="282446702" sldId="266"/>
            <ac:picMk id="18" creationId="{95D7C182-689D-FDF3-55B9-8388F946E2A3}"/>
          </ac:picMkLst>
        </pc:picChg>
        <pc:picChg chg="add del mod">
          <ac:chgData name="Suman, Shankar, Ph.D." userId="5c40f8ff-9e47-4060-8f0c-840d2230e7fd" providerId="ADAL" clId="{85CE6EFC-C947-461A-B6D9-EB162DC25B8B}" dt="2024-07-10T16:20:10.102" v="1592" actId="478"/>
          <ac:picMkLst>
            <pc:docMk/>
            <pc:sldMk cId="282446702" sldId="266"/>
            <ac:picMk id="20" creationId="{80CE57DD-A542-5974-9D7F-8CB176627D02}"/>
          </ac:picMkLst>
        </pc:picChg>
        <pc:picChg chg="add del mod">
          <ac:chgData name="Suman, Shankar, Ph.D." userId="5c40f8ff-9e47-4060-8f0c-840d2230e7fd" providerId="ADAL" clId="{85CE6EFC-C947-461A-B6D9-EB162DC25B8B}" dt="2024-07-10T16:20:39.640" v="1595" actId="21"/>
          <ac:picMkLst>
            <pc:docMk/>
            <pc:sldMk cId="282446702" sldId="266"/>
            <ac:picMk id="22" creationId="{2C656F30-C8C1-C46F-FC3C-DEE669E96198}"/>
          </ac:picMkLst>
        </pc:picChg>
      </pc:sldChg>
      <pc:sldChg chg="delSp modSp new del mod">
        <pc:chgData name="Suman, Shankar, Ph.D." userId="5c40f8ff-9e47-4060-8f0c-840d2230e7fd" providerId="ADAL" clId="{85CE6EFC-C947-461A-B6D9-EB162DC25B8B}" dt="2024-07-10T15:11:21.491" v="1458" actId="47"/>
        <pc:sldMkLst>
          <pc:docMk/>
          <pc:sldMk cId="1552080838" sldId="266"/>
        </pc:sldMkLst>
        <pc:spChg chg="mod">
          <ac:chgData name="Suman, Shankar, Ph.D." userId="5c40f8ff-9e47-4060-8f0c-840d2230e7fd" providerId="ADAL" clId="{85CE6EFC-C947-461A-B6D9-EB162DC25B8B}" dt="2024-07-09T19:22:16.552" v="1456" actId="14100"/>
          <ac:spMkLst>
            <pc:docMk/>
            <pc:sldMk cId="1552080838" sldId="266"/>
            <ac:spMk id="2" creationId="{0DB198D0-4E05-D571-F55A-CCB3F060D362}"/>
          </ac:spMkLst>
        </pc:spChg>
        <pc:spChg chg="del">
          <ac:chgData name="Suman, Shankar, Ph.D." userId="5c40f8ff-9e47-4060-8f0c-840d2230e7fd" providerId="ADAL" clId="{85CE6EFC-C947-461A-B6D9-EB162DC25B8B}" dt="2024-07-10T15:11:16.509" v="1457" actId="478"/>
          <ac:spMkLst>
            <pc:docMk/>
            <pc:sldMk cId="1552080838" sldId="266"/>
            <ac:spMk id="3" creationId="{980A961B-44BB-2520-AABC-11382C8CBB17}"/>
          </ac:spMkLst>
        </pc:spChg>
      </pc:sldChg>
      <pc:sldChg chg="addSp delSp modSp new mod">
        <pc:chgData name="Suman, Shankar, Ph.D." userId="5c40f8ff-9e47-4060-8f0c-840d2230e7fd" providerId="ADAL" clId="{85CE6EFC-C947-461A-B6D9-EB162DC25B8B}" dt="2024-07-10T16:32:39.934" v="1687" actId="14100"/>
        <pc:sldMkLst>
          <pc:docMk/>
          <pc:sldMk cId="2391247266" sldId="267"/>
        </pc:sldMkLst>
        <pc:spChg chg="del">
          <ac:chgData name="Suman, Shankar, Ph.D." userId="5c40f8ff-9e47-4060-8f0c-840d2230e7fd" providerId="ADAL" clId="{85CE6EFC-C947-461A-B6D9-EB162DC25B8B}" dt="2024-07-10T16:18:26.720" v="1575" actId="478"/>
          <ac:spMkLst>
            <pc:docMk/>
            <pc:sldMk cId="2391247266" sldId="267"/>
            <ac:spMk id="2" creationId="{EC043C43-6461-9111-99F7-609D3123F925}"/>
          </ac:spMkLst>
        </pc:spChg>
        <pc:spChg chg="del">
          <ac:chgData name="Suman, Shankar, Ph.D." userId="5c40f8ff-9e47-4060-8f0c-840d2230e7fd" providerId="ADAL" clId="{85CE6EFC-C947-461A-B6D9-EB162DC25B8B}" dt="2024-07-10T16:18:26.720" v="1575" actId="478"/>
          <ac:spMkLst>
            <pc:docMk/>
            <pc:sldMk cId="2391247266" sldId="267"/>
            <ac:spMk id="3" creationId="{75673732-577B-8CBC-0C99-A901E901FF50}"/>
          </ac:spMkLst>
        </pc:spChg>
        <pc:spChg chg="add del">
          <ac:chgData name="Suman, Shankar, Ph.D." userId="5c40f8ff-9e47-4060-8f0c-840d2230e7fd" providerId="ADAL" clId="{85CE6EFC-C947-461A-B6D9-EB162DC25B8B}" dt="2024-07-10T16:19:39.285" v="1588" actId="478"/>
          <ac:spMkLst>
            <pc:docMk/>
            <pc:sldMk cId="2391247266" sldId="267"/>
            <ac:spMk id="9" creationId="{8816E585-1FD6-3690-F8CB-92BE80046D3F}"/>
          </ac:spMkLst>
        </pc:spChg>
        <pc:spChg chg="add mod">
          <ac:chgData name="Suman, Shankar, Ph.D." userId="5c40f8ff-9e47-4060-8f0c-840d2230e7fd" providerId="ADAL" clId="{85CE6EFC-C947-461A-B6D9-EB162DC25B8B}" dt="2024-07-10T16:32:11.247" v="1681" actId="1076"/>
          <ac:spMkLst>
            <pc:docMk/>
            <pc:sldMk cId="2391247266" sldId="267"/>
            <ac:spMk id="18" creationId="{329C44DF-6A99-05E4-7B95-68253E26CC33}"/>
          </ac:spMkLst>
        </pc:spChg>
        <pc:picChg chg="add del mod modCrop">
          <ac:chgData name="Suman, Shankar, Ph.D." userId="5c40f8ff-9e47-4060-8f0c-840d2230e7fd" providerId="ADAL" clId="{85CE6EFC-C947-461A-B6D9-EB162DC25B8B}" dt="2024-07-10T16:19:25.578" v="1584" actId="478"/>
          <ac:picMkLst>
            <pc:docMk/>
            <pc:sldMk cId="2391247266" sldId="267"/>
            <ac:picMk id="5" creationId="{20CFBFA5-9424-4D51-C67A-095971594139}"/>
          </ac:picMkLst>
        </pc:picChg>
        <pc:picChg chg="add del">
          <ac:chgData name="Suman, Shankar, Ph.D." userId="5c40f8ff-9e47-4060-8f0c-840d2230e7fd" providerId="ADAL" clId="{85CE6EFC-C947-461A-B6D9-EB162DC25B8B}" dt="2024-07-10T16:19:29.380" v="1586" actId="478"/>
          <ac:picMkLst>
            <pc:docMk/>
            <pc:sldMk cId="2391247266" sldId="267"/>
            <ac:picMk id="7" creationId="{1651FFB0-3F3A-0B45-DD8E-64485F907B0F}"/>
          </ac:picMkLst>
        </pc:picChg>
        <pc:picChg chg="add del mod modCrop">
          <ac:chgData name="Suman, Shankar, Ph.D." userId="5c40f8ff-9e47-4060-8f0c-840d2230e7fd" providerId="ADAL" clId="{85CE6EFC-C947-461A-B6D9-EB162DC25B8B}" dt="2024-07-10T16:22:14.862" v="1614" actId="21"/>
          <ac:picMkLst>
            <pc:docMk/>
            <pc:sldMk cId="2391247266" sldId="267"/>
            <ac:picMk id="11" creationId="{337B2A76-2FB3-7AEA-5151-5A02B3EFA530}"/>
          </ac:picMkLst>
        </pc:picChg>
        <pc:picChg chg="add mod modCrop">
          <ac:chgData name="Suman, Shankar, Ph.D." userId="5c40f8ff-9e47-4060-8f0c-840d2230e7fd" providerId="ADAL" clId="{85CE6EFC-C947-461A-B6D9-EB162DC25B8B}" dt="2024-07-10T16:30:17.301" v="1671" actId="1076"/>
          <ac:picMkLst>
            <pc:docMk/>
            <pc:sldMk cId="2391247266" sldId="267"/>
            <ac:picMk id="12" creationId="{865D5516-B850-DE1B-7DF1-38DE8EB30C0A}"/>
          </ac:picMkLst>
        </pc:picChg>
        <pc:picChg chg="add del mod modCrop">
          <ac:chgData name="Suman, Shankar, Ph.D." userId="5c40f8ff-9e47-4060-8f0c-840d2230e7fd" providerId="ADAL" clId="{85CE6EFC-C947-461A-B6D9-EB162DC25B8B}" dt="2024-07-10T16:23:08.409" v="1623" actId="21"/>
          <ac:picMkLst>
            <pc:docMk/>
            <pc:sldMk cId="2391247266" sldId="267"/>
            <ac:picMk id="14" creationId="{8C7541A8-5DE8-3FA9-890D-CEBFC45904BB}"/>
          </ac:picMkLst>
        </pc:picChg>
        <pc:picChg chg="add mod">
          <ac:chgData name="Suman, Shankar, Ph.D." userId="5c40f8ff-9e47-4060-8f0c-840d2230e7fd" providerId="ADAL" clId="{85CE6EFC-C947-461A-B6D9-EB162DC25B8B}" dt="2024-07-10T16:30:46.547" v="1678" actId="1076"/>
          <ac:picMkLst>
            <pc:docMk/>
            <pc:sldMk cId="2391247266" sldId="267"/>
            <ac:picMk id="15" creationId="{C53A1BC7-47E7-5099-7F54-835052317955}"/>
          </ac:picMkLst>
        </pc:picChg>
        <pc:picChg chg="add del mod">
          <ac:chgData name="Suman, Shankar, Ph.D." userId="5c40f8ff-9e47-4060-8f0c-840d2230e7fd" providerId="ADAL" clId="{85CE6EFC-C947-461A-B6D9-EB162DC25B8B}" dt="2024-07-10T16:23:46.770" v="1639" actId="478"/>
          <ac:picMkLst>
            <pc:docMk/>
            <pc:sldMk cId="2391247266" sldId="267"/>
            <ac:picMk id="17" creationId="{DA5F7F8D-7281-A68A-7B71-E313D0F8464B}"/>
          </ac:picMkLst>
        </pc:picChg>
        <pc:picChg chg="add del mod">
          <ac:chgData name="Suman, Shankar, Ph.D." userId="5c40f8ff-9e47-4060-8f0c-840d2230e7fd" providerId="ADAL" clId="{85CE6EFC-C947-461A-B6D9-EB162DC25B8B}" dt="2024-07-10T16:29:26.304" v="1659" actId="478"/>
          <ac:picMkLst>
            <pc:docMk/>
            <pc:sldMk cId="2391247266" sldId="267"/>
            <ac:picMk id="20" creationId="{83896443-C48E-1A93-32B4-D106E0EE8715}"/>
          </ac:picMkLst>
        </pc:picChg>
        <pc:picChg chg="add mod modCrop">
          <ac:chgData name="Suman, Shankar, Ph.D." userId="5c40f8ff-9e47-4060-8f0c-840d2230e7fd" providerId="ADAL" clId="{85CE6EFC-C947-461A-B6D9-EB162DC25B8B}" dt="2024-07-10T16:32:17.674" v="1683" actId="1076"/>
          <ac:picMkLst>
            <pc:docMk/>
            <pc:sldMk cId="2391247266" sldId="267"/>
            <ac:picMk id="22" creationId="{2C656F30-C8C1-C46F-FC3C-DEE669E96198}"/>
          </ac:picMkLst>
        </pc:picChg>
        <pc:picChg chg="add del mod modCrop">
          <ac:chgData name="Suman, Shankar, Ph.D." userId="5c40f8ff-9e47-4060-8f0c-840d2230e7fd" providerId="ADAL" clId="{85CE6EFC-C947-461A-B6D9-EB162DC25B8B}" dt="2024-07-10T16:30:40.483" v="1675" actId="21"/>
          <ac:picMkLst>
            <pc:docMk/>
            <pc:sldMk cId="2391247266" sldId="267"/>
            <ac:picMk id="23" creationId="{D6286BCD-1CC2-A0F1-D56D-3711F6E2B1B1}"/>
          </ac:picMkLst>
        </pc:picChg>
        <pc:picChg chg="add mod">
          <ac:chgData name="Suman, Shankar, Ph.D." userId="5c40f8ff-9e47-4060-8f0c-840d2230e7fd" providerId="ADAL" clId="{85CE6EFC-C947-461A-B6D9-EB162DC25B8B}" dt="2024-07-10T16:32:39.934" v="1687" actId="14100"/>
          <ac:picMkLst>
            <pc:docMk/>
            <pc:sldMk cId="2391247266" sldId="267"/>
            <ac:picMk id="24" creationId="{101254BC-83DA-92E0-028E-EFED903A3A4A}"/>
          </ac:picMkLst>
        </pc:picChg>
      </pc:sldChg>
    </pc:docChg>
  </pc:docChgLst>
  <pc:docChgLst>
    <pc:chgData name="Suman, Shankar, Ph.D." userId="5c40f8ff-9e47-4060-8f0c-840d2230e7fd" providerId="ADAL" clId="{F96F223A-744B-443A-9AE5-FCB292DC9848}"/>
    <pc:docChg chg="custSel addSld modSld sldOrd">
      <pc:chgData name="Suman, Shankar, Ph.D." userId="5c40f8ff-9e47-4060-8f0c-840d2230e7fd" providerId="ADAL" clId="{F96F223A-744B-443A-9AE5-FCB292DC9848}" dt="2024-04-17T23:16:10.103" v="887" actId="20577"/>
      <pc:docMkLst>
        <pc:docMk/>
      </pc:docMkLst>
      <pc:sldChg chg="addSp delSp modSp new mod ord">
        <pc:chgData name="Suman, Shankar, Ph.D." userId="5c40f8ff-9e47-4060-8f0c-840d2230e7fd" providerId="ADAL" clId="{F96F223A-744B-443A-9AE5-FCB292DC9848}" dt="2024-04-17T21:46:51.517" v="545" actId="20577"/>
        <pc:sldMkLst>
          <pc:docMk/>
          <pc:sldMk cId="16268869" sldId="256"/>
        </pc:sldMkLst>
        <pc:spChg chg="del">
          <ac:chgData name="Suman, Shankar, Ph.D." userId="5c40f8ff-9e47-4060-8f0c-840d2230e7fd" providerId="ADAL" clId="{F96F223A-744B-443A-9AE5-FCB292DC9848}" dt="2024-04-03T19:02:31.694" v="1" actId="478"/>
          <ac:spMkLst>
            <pc:docMk/>
            <pc:sldMk cId="16268869" sldId="256"/>
            <ac:spMk id="2" creationId="{68EFF27A-2508-B5C2-7837-DA47737925D0}"/>
          </ac:spMkLst>
        </pc:spChg>
        <pc:spChg chg="add mod">
          <ac:chgData name="Suman, Shankar, Ph.D." userId="5c40f8ff-9e47-4060-8f0c-840d2230e7fd" providerId="ADAL" clId="{F96F223A-744B-443A-9AE5-FCB292DC9848}" dt="2024-04-15T20:33:57.515" v="526" actId="20577"/>
          <ac:spMkLst>
            <pc:docMk/>
            <pc:sldMk cId="16268869" sldId="256"/>
            <ac:spMk id="2" creationId="{78FB01BB-DF30-3E8D-C9C2-69EE59359760}"/>
          </ac:spMkLst>
        </pc:spChg>
        <pc:spChg chg="del">
          <ac:chgData name="Suman, Shankar, Ph.D." userId="5c40f8ff-9e47-4060-8f0c-840d2230e7fd" providerId="ADAL" clId="{F96F223A-744B-443A-9AE5-FCB292DC9848}" dt="2024-04-03T19:02:31.694" v="1" actId="478"/>
          <ac:spMkLst>
            <pc:docMk/>
            <pc:sldMk cId="16268869" sldId="256"/>
            <ac:spMk id="3" creationId="{2C59992E-924E-A998-D601-2E96EBBBC9A4}"/>
          </ac:spMkLst>
        </pc:spChg>
        <pc:spChg chg="mod">
          <ac:chgData name="Suman, Shankar, Ph.D." userId="5c40f8ff-9e47-4060-8f0c-840d2230e7fd" providerId="ADAL" clId="{F96F223A-744B-443A-9AE5-FCB292DC9848}" dt="2024-04-03T19:02:32.366" v="2"/>
          <ac:spMkLst>
            <pc:docMk/>
            <pc:sldMk cId="16268869" sldId="256"/>
            <ac:spMk id="7" creationId="{30F73309-E0C5-66A3-3984-FB5769A2EB2D}"/>
          </ac:spMkLst>
        </pc:spChg>
        <pc:spChg chg="mod">
          <ac:chgData name="Suman, Shankar, Ph.D." userId="5c40f8ff-9e47-4060-8f0c-840d2230e7fd" providerId="ADAL" clId="{F96F223A-744B-443A-9AE5-FCB292DC9848}" dt="2024-04-03T19:02:32.366" v="2"/>
          <ac:spMkLst>
            <pc:docMk/>
            <pc:sldMk cId="16268869" sldId="256"/>
            <ac:spMk id="8" creationId="{EEA8A569-21FC-D22B-7052-03B30F766A94}"/>
          </ac:spMkLst>
        </pc:spChg>
        <pc:spChg chg="mod">
          <ac:chgData name="Suman, Shankar, Ph.D." userId="5c40f8ff-9e47-4060-8f0c-840d2230e7fd" providerId="ADAL" clId="{F96F223A-744B-443A-9AE5-FCB292DC9848}" dt="2024-04-03T19:27:20.819" v="4"/>
          <ac:spMkLst>
            <pc:docMk/>
            <pc:sldMk cId="16268869" sldId="256"/>
            <ac:spMk id="17" creationId="{ABE9F69D-B9A2-B1D5-25E2-6F74FC20F78F}"/>
          </ac:spMkLst>
        </pc:spChg>
        <pc:spChg chg="mod">
          <ac:chgData name="Suman, Shankar, Ph.D." userId="5c40f8ff-9e47-4060-8f0c-840d2230e7fd" providerId="ADAL" clId="{F96F223A-744B-443A-9AE5-FCB292DC9848}" dt="2024-04-03T19:27:20.819" v="4"/>
          <ac:spMkLst>
            <pc:docMk/>
            <pc:sldMk cId="16268869" sldId="256"/>
            <ac:spMk id="18" creationId="{EE7BB775-266F-977A-C704-FE9CB1B6EA7C}"/>
          </ac:spMkLst>
        </pc:spChg>
        <pc:spChg chg="mod">
          <ac:chgData name="Suman, Shankar, Ph.D." userId="5c40f8ff-9e47-4060-8f0c-840d2230e7fd" providerId="ADAL" clId="{F96F223A-744B-443A-9AE5-FCB292DC9848}" dt="2024-04-03T19:27:20.819" v="4"/>
          <ac:spMkLst>
            <pc:docMk/>
            <pc:sldMk cId="16268869" sldId="256"/>
            <ac:spMk id="23" creationId="{CA5E5FB5-C960-09D5-0E57-E6C1686703A9}"/>
          </ac:spMkLst>
        </pc:spChg>
        <pc:spChg chg="mod">
          <ac:chgData name="Suman, Shankar, Ph.D." userId="5c40f8ff-9e47-4060-8f0c-840d2230e7fd" providerId="ADAL" clId="{F96F223A-744B-443A-9AE5-FCB292DC9848}" dt="2024-04-03T19:27:20.819" v="4"/>
          <ac:spMkLst>
            <pc:docMk/>
            <pc:sldMk cId="16268869" sldId="256"/>
            <ac:spMk id="24" creationId="{BB5AB3EB-6BCE-4980-EF62-DFE4B208E5A0}"/>
          </ac:spMkLst>
        </pc:spChg>
        <pc:spChg chg="mod">
          <ac:chgData name="Suman, Shankar, Ph.D." userId="5c40f8ff-9e47-4060-8f0c-840d2230e7fd" providerId="ADAL" clId="{F96F223A-744B-443A-9AE5-FCB292DC9848}" dt="2024-04-03T19:27:20.819" v="4"/>
          <ac:spMkLst>
            <pc:docMk/>
            <pc:sldMk cId="16268869" sldId="256"/>
            <ac:spMk id="29" creationId="{FA6B6355-6257-3800-6675-40AA7560D565}"/>
          </ac:spMkLst>
        </pc:spChg>
        <pc:spChg chg="mod">
          <ac:chgData name="Suman, Shankar, Ph.D." userId="5c40f8ff-9e47-4060-8f0c-840d2230e7fd" providerId="ADAL" clId="{F96F223A-744B-443A-9AE5-FCB292DC9848}" dt="2024-04-03T19:27:20.819" v="4"/>
          <ac:spMkLst>
            <pc:docMk/>
            <pc:sldMk cId="16268869" sldId="256"/>
            <ac:spMk id="30" creationId="{6CF49EB6-3EC7-7E4D-341C-B37556C41545}"/>
          </ac:spMkLst>
        </pc:spChg>
        <pc:spChg chg="mod">
          <ac:chgData name="Suman, Shankar, Ph.D." userId="5c40f8ff-9e47-4060-8f0c-840d2230e7fd" providerId="ADAL" clId="{F96F223A-744B-443A-9AE5-FCB292DC9848}" dt="2024-04-03T19:27:20.819" v="4"/>
          <ac:spMkLst>
            <pc:docMk/>
            <pc:sldMk cId="16268869" sldId="256"/>
            <ac:spMk id="35" creationId="{17021D54-229A-1C65-0C7A-ABA997E23B67}"/>
          </ac:spMkLst>
        </pc:spChg>
        <pc:spChg chg="mod">
          <ac:chgData name="Suman, Shankar, Ph.D." userId="5c40f8ff-9e47-4060-8f0c-840d2230e7fd" providerId="ADAL" clId="{F96F223A-744B-443A-9AE5-FCB292DC9848}" dt="2024-04-03T19:27:20.819" v="4"/>
          <ac:spMkLst>
            <pc:docMk/>
            <pc:sldMk cId="16268869" sldId="256"/>
            <ac:spMk id="36" creationId="{E0077A87-FE1A-8799-A1F0-5C8849A3241D}"/>
          </ac:spMkLst>
        </pc:spChg>
        <pc:spChg chg="add mod">
          <ac:chgData name="Suman, Shankar, Ph.D." userId="5c40f8ff-9e47-4060-8f0c-840d2230e7fd" providerId="ADAL" clId="{F96F223A-744B-443A-9AE5-FCB292DC9848}" dt="2024-04-03T19:28:25.520" v="19" actId="1076"/>
          <ac:spMkLst>
            <pc:docMk/>
            <pc:sldMk cId="16268869" sldId="256"/>
            <ac:spMk id="39" creationId="{5511286E-7BD3-7196-E254-0C8150AFB1EE}"/>
          </ac:spMkLst>
        </pc:spChg>
        <pc:spChg chg="add mod">
          <ac:chgData name="Suman, Shankar, Ph.D." userId="5c40f8ff-9e47-4060-8f0c-840d2230e7fd" providerId="ADAL" clId="{F96F223A-744B-443A-9AE5-FCB292DC9848}" dt="2024-04-03T19:28:25.520" v="19" actId="1076"/>
          <ac:spMkLst>
            <pc:docMk/>
            <pc:sldMk cId="16268869" sldId="256"/>
            <ac:spMk id="40" creationId="{95F2CCE6-E03D-F62F-EF8C-50278485AEB3}"/>
          </ac:spMkLst>
        </pc:spChg>
        <pc:spChg chg="add mod">
          <ac:chgData name="Suman, Shankar, Ph.D." userId="5c40f8ff-9e47-4060-8f0c-840d2230e7fd" providerId="ADAL" clId="{F96F223A-744B-443A-9AE5-FCB292DC9848}" dt="2024-04-03T19:28:25.520" v="19" actId="1076"/>
          <ac:spMkLst>
            <pc:docMk/>
            <pc:sldMk cId="16268869" sldId="256"/>
            <ac:spMk id="41" creationId="{B5737EB9-18DE-2AF9-622C-80ACB5799D33}"/>
          </ac:spMkLst>
        </pc:spChg>
        <pc:spChg chg="add mod">
          <ac:chgData name="Suman, Shankar, Ph.D." userId="5c40f8ff-9e47-4060-8f0c-840d2230e7fd" providerId="ADAL" clId="{F96F223A-744B-443A-9AE5-FCB292DC9848}" dt="2024-04-03T19:28:25.520" v="19" actId="1076"/>
          <ac:spMkLst>
            <pc:docMk/>
            <pc:sldMk cId="16268869" sldId="256"/>
            <ac:spMk id="42" creationId="{26382C9E-EB6B-F0EA-ECBA-7AED4F3A43E5}"/>
          </ac:spMkLst>
        </pc:spChg>
        <pc:spChg chg="add mod">
          <ac:chgData name="Suman, Shankar, Ph.D." userId="5c40f8ff-9e47-4060-8f0c-840d2230e7fd" providerId="ADAL" clId="{F96F223A-744B-443A-9AE5-FCB292DC9848}" dt="2024-04-03T19:28:39.177" v="23" actId="2711"/>
          <ac:spMkLst>
            <pc:docMk/>
            <pc:sldMk cId="16268869" sldId="256"/>
            <ac:spMk id="44" creationId="{FCF80EA5-D365-6886-D270-1732D595363A}"/>
          </ac:spMkLst>
        </pc:spChg>
        <pc:spChg chg="add del mod">
          <ac:chgData name="Suman, Shankar, Ph.D." userId="5c40f8ff-9e47-4060-8f0c-840d2230e7fd" providerId="ADAL" clId="{F96F223A-744B-443A-9AE5-FCB292DC9848}" dt="2024-04-03T19:28:31.603" v="21" actId="478"/>
          <ac:spMkLst>
            <pc:docMk/>
            <pc:sldMk cId="16268869" sldId="256"/>
            <ac:spMk id="45" creationId="{2231E670-46AF-B407-607A-04766885513E}"/>
          </ac:spMkLst>
        </pc:spChg>
        <pc:spChg chg="add mod">
          <ac:chgData name="Suman, Shankar, Ph.D." userId="5c40f8ff-9e47-4060-8f0c-840d2230e7fd" providerId="ADAL" clId="{F96F223A-744B-443A-9AE5-FCB292DC9848}" dt="2024-04-17T21:46:51.517" v="545" actId="20577"/>
          <ac:spMkLst>
            <pc:docMk/>
            <pc:sldMk cId="16268869" sldId="256"/>
            <ac:spMk id="46" creationId="{AA22BBBF-32EB-3D3F-D39A-667988F784EB}"/>
          </ac:spMkLst>
        </pc:spChg>
        <pc:grpChg chg="add mod">
          <ac:chgData name="Suman, Shankar, Ph.D." userId="5c40f8ff-9e47-4060-8f0c-840d2230e7fd" providerId="ADAL" clId="{F96F223A-744B-443A-9AE5-FCB292DC9848}" dt="2024-04-03T19:27:25.975" v="5" actId="164"/>
          <ac:grpSpMkLst>
            <pc:docMk/>
            <pc:sldMk cId="16268869" sldId="256"/>
            <ac:grpSpMk id="5" creationId="{82F3A6B4-343E-D44F-5605-0CC0C45175F2}"/>
          </ac:grpSpMkLst>
        </pc:grpChg>
        <pc:grpChg chg="mod">
          <ac:chgData name="Suman, Shankar, Ph.D." userId="5c40f8ff-9e47-4060-8f0c-840d2230e7fd" providerId="ADAL" clId="{F96F223A-744B-443A-9AE5-FCB292DC9848}" dt="2024-04-03T19:02:32.366" v="2"/>
          <ac:grpSpMkLst>
            <pc:docMk/>
            <pc:sldMk cId="16268869" sldId="256"/>
            <ac:grpSpMk id="6" creationId="{FF62F994-15C1-619B-4C39-E78A9A52EB3A}"/>
          </ac:grpSpMkLst>
        </pc:grpChg>
        <pc:grpChg chg="add mod">
          <ac:chgData name="Suman, Shankar, Ph.D." userId="5c40f8ff-9e47-4060-8f0c-840d2230e7fd" providerId="ADAL" clId="{F96F223A-744B-443A-9AE5-FCB292DC9848}" dt="2024-04-03T19:28:25.520" v="19" actId="1076"/>
          <ac:grpSpMkLst>
            <pc:docMk/>
            <pc:sldMk cId="16268869" sldId="256"/>
            <ac:grpSpMk id="15" creationId="{CCFAB998-C7C3-6540-6BF6-C79A3B994868}"/>
          </ac:grpSpMkLst>
        </pc:grpChg>
        <pc:grpChg chg="mod">
          <ac:chgData name="Suman, Shankar, Ph.D." userId="5c40f8ff-9e47-4060-8f0c-840d2230e7fd" providerId="ADAL" clId="{F96F223A-744B-443A-9AE5-FCB292DC9848}" dt="2024-04-03T19:27:20.819" v="4"/>
          <ac:grpSpMkLst>
            <pc:docMk/>
            <pc:sldMk cId="16268869" sldId="256"/>
            <ac:grpSpMk id="16" creationId="{79FD08A4-8D32-D14A-E1F4-D9A01D3C3C8A}"/>
          </ac:grpSpMkLst>
        </pc:grpChg>
        <pc:grpChg chg="add mod">
          <ac:chgData name="Suman, Shankar, Ph.D." userId="5c40f8ff-9e47-4060-8f0c-840d2230e7fd" providerId="ADAL" clId="{F96F223A-744B-443A-9AE5-FCB292DC9848}" dt="2024-04-03T19:28:25.520" v="19" actId="1076"/>
          <ac:grpSpMkLst>
            <pc:docMk/>
            <pc:sldMk cId="16268869" sldId="256"/>
            <ac:grpSpMk id="21" creationId="{FBD39E89-3596-B079-0C86-3BA6CE35ECBF}"/>
          </ac:grpSpMkLst>
        </pc:grpChg>
        <pc:grpChg chg="mod">
          <ac:chgData name="Suman, Shankar, Ph.D." userId="5c40f8ff-9e47-4060-8f0c-840d2230e7fd" providerId="ADAL" clId="{F96F223A-744B-443A-9AE5-FCB292DC9848}" dt="2024-04-03T19:27:20.819" v="4"/>
          <ac:grpSpMkLst>
            <pc:docMk/>
            <pc:sldMk cId="16268869" sldId="256"/>
            <ac:grpSpMk id="22" creationId="{83951353-AFBE-95B4-473D-1B567C90E8FB}"/>
          </ac:grpSpMkLst>
        </pc:grpChg>
        <pc:grpChg chg="add mod">
          <ac:chgData name="Suman, Shankar, Ph.D." userId="5c40f8ff-9e47-4060-8f0c-840d2230e7fd" providerId="ADAL" clId="{F96F223A-744B-443A-9AE5-FCB292DC9848}" dt="2024-04-03T19:28:25.520" v="19" actId="1076"/>
          <ac:grpSpMkLst>
            <pc:docMk/>
            <pc:sldMk cId="16268869" sldId="256"/>
            <ac:grpSpMk id="27" creationId="{D1E35A08-AD7B-E1B3-C092-0AB341D2D624}"/>
          </ac:grpSpMkLst>
        </pc:grpChg>
        <pc:grpChg chg="mod">
          <ac:chgData name="Suman, Shankar, Ph.D." userId="5c40f8ff-9e47-4060-8f0c-840d2230e7fd" providerId="ADAL" clId="{F96F223A-744B-443A-9AE5-FCB292DC9848}" dt="2024-04-03T19:27:20.819" v="4"/>
          <ac:grpSpMkLst>
            <pc:docMk/>
            <pc:sldMk cId="16268869" sldId="256"/>
            <ac:grpSpMk id="28" creationId="{88C354CD-E040-8E05-660F-90F5FEA4ED0E}"/>
          </ac:grpSpMkLst>
        </pc:grpChg>
        <pc:grpChg chg="add mod">
          <ac:chgData name="Suman, Shankar, Ph.D." userId="5c40f8ff-9e47-4060-8f0c-840d2230e7fd" providerId="ADAL" clId="{F96F223A-744B-443A-9AE5-FCB292DC9848}" dt="2024-04-03T19:28:25.520" v="19" actId="1076"/>
          <ac:grpSpMkLst>
            <pc:docMk/>
            <pc:sldMk cId="16268869" sldId="256"/>
            <ac:grpSpMk id="33" creationId="{FB4CFC52-0D12-539A-691C-2912E9A1EDB7}"/>
          </ac:grpSpMkLst>
        </pc:grpChg>
        <pc:grpChg chg="mod">
          <ac:chgData name="Suman, Shankar, Ph.D." userId="5c40f8ff-9e47-4060-8f0c-840d2230e7fd" providerId="ADAL" clId="{F96F223A-744B-443A-9AE5-FCB292DC9848}" dt="2024-04-03T19:27:20.819" v="4"/>
          <ac:grpSpMkLst>
            <pc:docMk/>
            <pc:sldMk cId="16268869" sldId="256"/>
            <ac:grpSpMk id="34" creationId="{30A53533-E251-A79F-2C13-0DCE2A123CFB}"/>
          </ac:grpSpMkLst>
        </pc:grpChg>
        <pc:grpChg chg="add mod">
          <ac:chgData name="Suman, Shankar, Ph.D." userId="5c40f8ff-9e47-4060-8f0c-840d2230e7fd" providerId="ADAL" clId="{F96F223A-744B-443A-9AE5-FCB292DC9848}" dt="2024-04-03T19:28:20.820" v="18" actId="1076"/>
          <ac:grpSpMkLst>
            <pc:docMk/>
            <pc:sldMk cId="16268869" sldId="256"/>
            <ac:grpSpMk id="43" creationId="{873B3E90-582F-314C-04DE-533F71919434}"/>
          </ac:grpSpMkLst>
        </pc:grpChg>
        <pc:picChg chg="add mod">
          <ac:chgData name="Suman, Shankar, Ph.D." userId="5c40f8ff-9e47-4060-8f0c-840d2230e7fd" providerId="ADAL" clId="{F96F223A-744B-443A-9AE5-FCB292DC9848}" dt="2024-04-03T19:27:25.975" v="5" actId="164"/>
          <ac:picMkLst>
            <pc:docMk/>
            <pc:sldMk cId="16268869" sldId="256"/>
            <ac:picMk id="4" creationId="{C85DF9AF-E183-91C2-97B2-0B13E0EFDC4C}"/>
          </ac:picMkLst>
        </pc:picChg>
        <pc:picChg chg="add mod">
          <ac:chgData name="Suman, Shankar, Ph.D." userId="5c40f8ff-9e47-4060-8f0c-840d2230e7fd" providerId="ADAL" clId="{F96F223A-744B-443A-9AE5-FCB292DC9848}" dt="2024-04-03T19:28:25.520" v="19" actId="1076"/>
          <ac:picMkLst>
            <pc:docMk/>
            <pc:sldMk cId="16268869" sldId="256"/>
            <ac:picMk id="11" creationId="{3995C459-B9A3-8F8B-92A3-BCE2F80BBF1D}"/>
          </ac:picMkLst>
        </pc:picChg>
        <pc:picChg chg="add mod">
          <ac:chgData name="Suman, Shankar, Ph.D." userId="5c40f8ff-9e47-4060-8f0c-840d2230e7fd" providerId="ADAL" clId="{F96F223A-744B-443A-9AE5-FCB292DC9848}" dt="2024-04-03T19:28:25.520" v="19" actId="1076"/>
          <ac:picMkLst>
            <pc:docMk/>
            <pc:sldMk cId="16268869" sldId="256"/>
            <ac:picMk id="12" creationId="{63BBD2E6-D405-B9D4-523E-875F797DFEA9}"/>
          </ac:picMkLst>
        </pc:picChg>
        <pc:picChg chg="add mod">
          <ac:chgData name="Suman, Shankar, Ph.D." userId="5c40f8ff-9e47-4060-8f0c-840d2230e7fd" providerId="ADAL" clId="{F96F223A-744B-443A-9AE5-FCB292DC9848}" dt="2024-04-03T19:28:25.520" v="19" actId="1076"/>
          <ac:picMkLst>
            <pc:docMk/>
            <pc:sldMk cId="16268869" sldId="256"/>
            <ac:picMk id="13" creationId="{1B3ACBE6-519A-05ED-32AB-3985D6E5E0E4}"/>
          </ac:picMkLst>
        </pc:picChg>
        <pc:picChg chg="add mod">
          <ac:chgData name="Suman, Shankar, Ph.D." userId="5c40f8ff-9e47-4060-8f0c-840d2230e7fd" providerId="ADAL" clId="{F96F223A-744B-443A-9AE5-FCB292DC9848}" dt="2024-04-03T19:28:25.520" v="19" actId="1076"/>
          <ac:picMkLst>
            <pc:docMk/>
            <pc:sldMk cId="16268869" sldId="256"/>
            <ac:picMk id="14" creationId="{5D9AECA7-9727-49E6-8501-3680B8486F91}"/>
          </ac:picMkLst>
        </pc:picChg>
        <pc:cxnChg chg="mod">
          <ac:chgData name="Suman, Shankar, Ph.D." userId="5c40f8ff-9e47-4060-8f0c-840d2230e7fd" providerId="ADAL" clId="{F96F223A-744B-443A-9AE5-FCB292DC9848}" dt="2024-04-03T19:02:32.366" v="2"/>
          <ac:cxnSpMkLst>
            <pc:docMk/>
            <pc:sldMk cId="16268869" sldId="256"/>
            <ac:cxnSpMk id="9" creationId="{A4BDDB22-DC8E-BFBC-E3A0-9C8C55323CEA}"/>
          </ac:cxnSpMkLst>
        </pc:cxnChg>
        <pc:cxnChg chg="mod">
          <ac:chgData name="Suman, Shankar, Ph.D." userId="5c40f8ff-9e47-4060-8f0c-840d2230e7fd" providerId="ADAL" clId="{F96F223A-744B-443A-9AE5-FCB292DC9848}" dt="2024-04-03T19:02:32.366" v="2"/>
          <ac:cxnSpMkLst>
            <pc:docMk/>
            <pc:sldMk cId="16268869" sldId="256"/>
            <ac:cxnSpMk id="10" creationId="{92CDD2D7-9BA6-C511-02C5-2D7EBA206D4F}"/>
          </ac:cxnSpMkLst>
        </pc:cxnChg>
        <pc:cxnChg chg="mod">
          <ac:chgData name="Suman, Shankar, Ph.D." userId="5c40f8ff-9e47-4060-8f0c-840d2230e7fd" providerId="ADAL" clId="{F96F223A-744B-443A-9AE5-FCB292DC9848}" dt="2024-04-03T19:27:20.819" v="4"/>
          <ac:cxnSpMkLst>
            <pc:docMk/>
            <pc:sldMk cId="16268869" sldId="256"/>
            <ac:cxnSpMk id="19" creationId="{D32C90BE-CADB-E98B-42AE-022CA4509FC7}"/>
          </ac:cxnSpMkLst>
        </pc:cxnChg>
        <pc:cxnChg chg="mod">
          <ac:chgData name="Suman, Shankar, Ph.D." userId="5c40f8ff-9e47-4060-8f0c-840d2230e7fd" providerId="ADAL" clId="{F96F223A-744B-443A-9AE5-FCB292DC9848}" dt="2024-04-03T19:27:20.819" v="4"/>
          <ac:cxnSpMkLst>
            <pc:docMk/>
            <pc:sldMk cId="16268869" sldId="256"/>
            <ac:cxnSpMk id="20" creationId="{915B8095-C785-7ACF-6FCE-BBC1184359DC}"/>
          </ac:cxnSpMkLst>
        </pc:cxnChg>
        <pc:cxnChg chg="mod">
          <ac:chgData name="Suman, Shankar, Ph.D." userId="5c40f8ff-9e47-4060-8f0c-840d2230e7fd" providerId="ADAL" clId="{F96F223A-744B-443A-9AE5-FCB292DC9848}" dt="2024-04-03T19:27:20.819" v="4"/>
          <ac:cxnSpMkLst>
            <pc:docMk/>
            <pc:sldMk cId="16268869" sldId="256"/>
            <ac:cxnSpMk id="25" creationId="{40DA1218-D43C-2E8B-80D2-74B97F1EE8DF}"/>
          </ac:cxnSpMkLst>
        </pc:cxnChg>
        <pc:cxnChg chg="mod">
          <ac:chgData name="Suman, Shankar, Ph.D." userId="5c40f8ff-9e47-4060-8f0c-840d2230e7fd" providerId="ADAL" clId="{F96F223A-744B-443A-9AE5-FCB292DC9848}" dt="2024-04-03T19:27:20.819" v="4"/>
          <ac:cxnSpMkLst>
            <pc:docMk/>
            <pc:sldMk cId="16268869" sldId="256"/>
            <ac:cxnSpMk id="26" creationId="{D28FEF41-9C9C-5D99-4304-24FC20B6E2D4}"/>
          </ac:cxnSpMkLst>
        </pc:cxnChg>
        <pc:cxnChg chg="mod">
          <ac:chgData name="Suman, Shankar, Ph.D." userId="5c40f8ff-9e47-4060-8f0c-840d2230e7fd" providerId="ADAL" clId="{F96F223A-744B-443A-9AE5-FCB292DC9848}" dt="2024-04-03T19:27:20.819" v="4"/>
          <ac:cxnSpMkLst>
            <pc:docMk/>
            <pc:sldMk cId="16268869" sldId="256"/>
            <ac:cxnSpMk id="31" creationId="{16EE48E9-03D3-FEBE-0DB8-9EF1B2B81151}"/>
          </ac:cxnSpMkLst>
        </pc:cxnChg>
        <pc:cxnChg chg="mod">
          <ac:chgData name="Suman, Shankar, Ph.D." userId="5c40f8ff-9e47-4060-8f0c-840d2230e7fd" providerId="ADAL" clId="{F96F223A-744B-443A-9AE5-FCB292DC9848}" dt="2024-04-03T19:27:20.819" v="4"/>
          <ac:cxnSpMkLst>
            <pc:docMk/>
            <pc:sldMk cId="16268869" sldId="256"/>
            <ac:cxnSpMk id="32" creationId="{59A38B7E-0828-4CE4-56E5-87FC823FCC7E}"/>
          </ac:cxnSpMkLst>
        </pc:cxnChg>
        <pc:cxnChg chg="mod">
          <ac:chgData name="Suman, Shankar, Ph.D." userId="5c40f8ff-9e47-4060-8f0c-840d2230e7fd" providerId="ADAL" clId="{F96F223A-744B-443A-9AE5-FCB292DC9848}" dt="2024-04-03T19:27:20.819" v="4"/>
          <ac:cxnSpMkLst>
            <pc:docMk/>
            <pc:sldMk cId="16268869" sldId="256"/>
            <ac:cxnSpMk id="37" creationId="{93DFF364-1BCE-75DC-4F68-837D987F92EC}"/>
          </ac:cxnSpMkLst>
        </pc:cxnChg>
        <pc:cxnChg chg="mod">
          <ac:chgData name="Suman, Shankar, Ph.D." userId="5c40f8ff-9e47-4060-8f0c-840d2230e7fd" providerId="ADAL" clId="{F96F223A-744B-443A-9AE5-FCB292DC9848}" dt="2024-04-03T19:27:20.819" v="4"/>
          <ac:cxnSpMkLst>
            <pc:docMk/>
            <pc:sldMk cId="16268869" sldId="256"/>
            <ac:cxnSpMk id="38" creationId="{9E740C6E-8FCC-8701-D413-F28D8268D045}"/>
          </ac:cxnSpMkLst>
        </pc:cxnChg>
      </pc:sldChg>
      <pc:sldChg chg="addSp delSp modSp new mod">
        <pc:chgData name="Suman, Shankar, Ph.D." userId="5c40f8ff-9e47-4060-8f0c-840d2230e7fd" providerId="ADAL" clId="{F96F223A-744B-443A-9AE5-FCB292DC9848}" dt="2024-04-17T21:47:03.629" v="547" actId="14100"/>
        <pc:sldMkLst>
          <pc:docMk/>
          <pc:sldMk cId="1762179812" sldId="257"/>
        </pc:sldMkLst>
        <pc:spChg chg="del">
          <ac:chgData name="Suman, Shankar, Ph.D." userId="5c40f8ff-9e47-4060-8f0c-840d2230e7fd" providerId="ADAL" clId="{F96F223A-744B-443A-9AE5-FCB292DC9848}" dt="2024-04-03T19:30:10.980" v="54" actId="478"/>
          <ac:spMkLst>
            <pc:docMk/>
            <pc:sldMk cId="1762179812" sldId="257"/>
            <ac:spMk id="2" creationId="{111B0CB7-3113-EFD3-5CF7-0434215DAF26}"/>
          </ac:spMkLst>
        </pc:spChg>
        <pc:spChg chg="add mod">
          <ac:chgData name="Suman, Shankar, Ph.D." userId="5c40f8ff-9e47-4060-8f0c-840d2230e7fd" providerId="ADAL" clId="{F96F223A-744B-443A-9AE5-FCB292DC9848}" dt="2024-04-15T20:33:51.177" v="524" actId="20577"/>
          <ac:spMkLst>
            <pc:docMk/>
            <pc:sldMk cId="1762179812" sldId="257"/>
            <ac:spMk id="2" creationId="{37709C2F-9977-8CDD-31C8-FEB89D7E6C4D}"/>
          </ac:spMkLst>
        </pc:spChg>
        <pc:spChg chg="del">
          <ac:chgData name="Suman, Shankar, Ph.D." userId="5c40f8ff-9e47-4060-8f0c-840d2230e7fd" providerId="ADAL" clId="{F96F223A-744B-443A-9AE5-FCB292DC9848}" dt="2024-04-03T19:30:10.980" v="54" actId="478"/>
          <ac:spMkLst>
            <pc:docMk/>
            <pc:sldMk cId="1762179812" sldId="257"/>
            <ac:spMk id="3" creationId="{33AB1D11-C309-00F7-94A3-B2FDA02F376C}"/>
          </ac:spMkLst>
        </pc:spChg>
        <pc:spChg chg="add mod ord">
          <ac:chgData name="Suman, Shankar, Ph.D." userId="5c40f8ff-9e47-4060-8f0c-840d2230e7fd" providerId="ADAL" clId="{F96F223A-744B-443A-9AE5-FCB292DC9848}" dt="2024-04-03T19:37:07.010" v="188" actId="1076"/>
          <ac:spMkLst>
            <pc:docMk/>
            <pc:sldMk cId="1762179812" sldId="257"/>
            <ac:spMk id="4" creationId="{D3F87CF8-6F8D-484A-94FA-327FCBFAE740}"/>
          </ac:spMkLst>
        </pc:spChg>
        <pc:spChg chg="mod">
          <ac:chgData name="Suman, Shankar, Ph.D." userId="5c40f8ff-9e47-4060-8f0c-840d2230e7fd" providerId="ADAL" clId="{F96F223A-744B-443A-9AE5-FCB292DC9848}" dt="2024-04-03T19:30:35.218" v="68"/>
          <ac:spMkLst>
            <pc:docMk/>
            <pc:sldMk cId="1762179812" sldId="257"/>
            <ac:spMk id="8" creationId="{99339CAC-44CB-859F-7106-42D94E685698}"/>
          </ac:spMkLst>
        </pc:spChg>
        <pc:spChg chg="mod">
          <ac:chgData name="Suman, Shankar, Ph.D." userId="5c40f8ff-9e47-4060-8f0c-840d2230e7fd" providerId="ADAL" clId="{F96F223A-744B-443A-9AE5-FCB292DC9848}" dt="2024-04-03T19:30:35.218" v="68"/>
          <ac:spMkLst>
            <pc:docMk/>
            <pc:sldMk cId="1762179812" sldId="257"/>
            <ac:spMk id="9" creationId="{8B068FC6-EB5D-1439-C8F5-C83E309A743B}"/>
          </ac:spMkLst>
        </pc:spChg>
        <pc:spChg chg="mod">
          <ac:chgData name="Suman, Shankar, Ph.D." userId="5c40f8ff-9e47-4060-8f0c-840d2230e7fd" providerId="ADAL" clId="{F96F223A-744B-443A-9AE5-FCB292DC9848}" dt="2024-04-03T19:30:35.218" v="68"/>
          <ac:spMkLst>
            <pc:docMk/>
            <pc:sldMk cId="1762179812" sldId="257"/>
            <ac:spMk id="10" creationId="{73FAEF99-518F-73AB-8C49-A374D8AFA7C3}"/>
          </ac:spMkLst>
        </pc:spChg>
        <pc:spChg chg="mod">
          <ac:chgData name="Suman, Shankar, Ph.D." userId="5c40f8ff-9e47-4060-8f0c-840d2230e7fd" providerId="ADAL" clId="{F96F223A-744B-443A-9AE5-FCB292DC9848}" dt="2024-04-03T19:30:35.218" v="68"/>
          <ac:spMkLst>
            <pc:docMk/>
            <pc:sldMk cId="1762179812" sldId="257"/>
            <ac:spMk id="11" creationId="{3F895341-9AB1-A90D-A6B3-2A5D1D3630B6}"/>
          </ac:spMkLst>
        </pc:spChg>
        <pc:spChg chg="mod">
          <ac:chgData name="Suman, Shankar, Ph.D." userId="5c40f8ff-9e47-4060-8f0c-840d2230e7fd" providerId="ADAL" clId="{F96F223A-744B-443A-9AE5-FCB292DC9848}" dt="2024-04-03T19:30:35.218" v="68"/>
          <ac:spMkLst>
            <pc:docMk/>
            <pc:sldMk cId="1762179812" sldId="257"/>
            <ac:spMk id="12" creationId="{FD5BC27C-D2A2-5ECC-ABC8-F86E8CEEDCE3}"/>
          </ac:spMkLst>
        </pc:spChg>
        <pc:spChg chg="mod">
          <ac:chgData name="Suman, Shankar, Ph.D." userId="5c40f8ff-9e47-4060-8f0c-840d2230e7fd" providerId="ADAL" clId="{F96F223A-744B-443A-9AE5-FCB292DC9848}" dt="2024-04-03T19:30:35.218" v="68"/>
          <ac:spMkLst>
            <pc:docMk/>
            <pc:sldMk cId="1762179812" sldId="257"/>
            <ac:spMk id="13" creationId="{DE50A3B4-684D-2394-E1F0-4A89E0F2DBB1}"/>
          </ac:spMkLst>
        </pc:spChg>
        <pc:spChg chg="mod">
          <ac:chgData name="Suman, Shankar, Ph.D." userId="5c40f8ff-9e47-4060-8f0c-840d2230e7fd" providerId="ADAL" clId="{F96F223A-744B-443A-9AE5-FCB292DC9848}" dt="2024-04-03T19:30:35.218" v="68"/>
          <ac:spMkLst>
            <pc:docMk/>
            <pc:sldMk cId="1762179812" sldId="257"/>
            <ac:spMk id="14" creationId="{D8359AB9-EFAF-E72A-16F6-0785D317FC18}"/>
          </ac:spMkLst>
        </pc:spChg>
        <pc:spChg chg="mod">
          <ac:chgData name="Suman, Shankar, Ph.D." userId="5c40f8ff-9e47-4060-8f0c-840d2230e7fd" providerId="ADAL" clId="{F96F223A-744B-443A-9AE5-FCB292DC9848}" dt="2024-04-03T19:30:35.218" v="68"/>
          <ac:spMkLst>
            <pc:docMk/>
            <pc:sldMk cId="1762179812" sldId="257"/>
            <ac:spMk id="15" creationId="{470D350D-EDA9-5392-8199-7A0B5AC35778}"/>
          </ac:spMkLst>
        </pc:spChg>
        <pc:spChg chg="add mod">
          <ac:chgData name="Suman, Shankar, Ph.D." userId="5c40f8ff-9e47-4060-8f0c-840d2230e7fd" providerId="ADAL" clId="{F96F223A-744B-443A-9AE5-FCB292DC9848}" dt="2024-04-17T21:46:53.726" v="546" actId="20577"/>
          <ac:spMkLst>
            <pc:docMk/>
            <pc:sldMk cId="1762179812" sldId="257"/>
            <ac:spMk id="16" creationId="{ECB7D2C6-CE77-41B9-FE05-54DA14375285}"/>
          </ac:spMkLst>
        </pc:spChg>
        <pc:spChg chg="add mod">
          <ac:chgData name="Suman, Shankar, Ph.D." userId="5c40f8ff-9e47-4060-8f0c-840d2230e7fd" providerId="ADAL" clId="{F96F223A-744B-443A-9AE5-FCB292DC9848}" dt="2024-04-03T19:31:01.728" v="77" actId="1076"/>
          <ac:spMkLst>
            <pc:docMk/>
            <pc:sldMk cId="1762179812" sldId="257"/>
            <ac:spMk id="17" creationId="{D31D59E8-9442-F284-6B26-73D940130C60}"/>
          </ac:spMkLst>
        </pc:spChg>
        <pc:spChg chg="add mod">
          <ac:chgData name="Suman, Shankar, Ph.D." userId="5c40f8ff-9e47-4060-8f0c-840d2230e7fd" providerId="ADAL" clId="{F96F223A-744B-443A-9AE5-FCB292DC9848}" dt="2024-04-03T19:35:09.879" v="120" actId="1076"/>
          <ac:spMkLst>
            <pc:docMk/>
            <pc:sldMk cId="1762179812" sldId="257"/>
            <ac:spMk id="18" creationId="{82F6CCA6-7313-D970-2493-9A3C3C64AA35}"/>
          </ac:spMkLst>
        </pc:spChg>
        <pc:grpChg chg="add mod">
          <ac:chgData name="Suman, Shankar, Ph.D." userId="5c40f8ff-9e47-4060-8f0c-840d2230e7fd" providerId="ADAL" clId="{F96F223A-744B-443A-9AE5-FCB292DC9848}" dt="2024-04-03T19:35:11.145" v="121" actId="1076"/>
          <ac:grpSpMkLst>
            <pc:docMk/>
            <pc:sldMk cId="1762179812" sldId="257"/>
            <ac:grpSpMk id="6" creationId="{3A2F69B2-7CF6-EFC8-5E3D-2F3D682DD02B}"/>
          </ac:grpSpMkLst>
        </pc:grpChg>
        <pc:graphicFrameChg chg="add mod">
          <ac:chgData name="Suman, Shankar, Ph.D." userId="5c40f8ff-9e47-4060-8f0c-840d2230e7fd" providerId="ADAL" clId="{F96F223A-744B-443A-9AE5-FCB292DC9848}" dt="2024-04-03T19:37:04.771" v="187" actId="1076"/>
          <ac:graphicFrameMkLst>
            <pc:docMk/>
            <pc:sldMk cId="1762179812" sldId="257"/>
            <ac:graphicFrameMk id="5" creationId="{ECC36C1F-FE95-30BE-41CF-D4107E7C4B5B}"/>
          </ac:graphicFrameMkLst>
        </pc:graphicFrameChg>
        <pc:picChg chg="mod">
          <ac:chgData name="Suman, Shankar, Ph.D." userId="5c40f8ff-9e47-4060-8f0c-840d2230e7fd" providerId="ADAL" clId="{F96F223A-744B-443A-9AE5-FCB292DC9848}" dt="2024-04-17T21:47:03.629" v="547" actId="14100"/>
          <ac:picMkLst>
            <pc:docMk/>
            <pc:sldMk cId="1762179812" sldId="257"/>
            <ac:picMk id="7" creationId="{319EAA58-FEDB-9B19-7AA8-5150B8356667}"/>
          </ac:picMkLst>
        </pc:picChg>
        <pc:picChg chg="add mod modCrop">
          <ac:chgData name="Suman, Shankar, Ph.D." userId="5c40f8ff-9e47-4060-8f0c-840d2230e7fd" providerId="ADAL" clId="{F96F223A-744B-443A-9AE5-FCB292DC9848}" dt="2024-04-03T19:37:09.783" v="189" actId="14100"/>
          <ac:picMkLst>
            <pc:docMk/>
            <pc:sldMk cId="1762179812" sldId="257"/>
            <ac:picMk id="19" creationId="{3C302D61-E013-15AF-3569-74C6D6A39163}"/>
          </ac:picMkLst>
        </pc:picChg>
      </pc:sldChg>
      <pc:sldChg chg="addSp delSp modSp new mod ord">
        <pc:chgData name="Suman, Shankar, Ph.D." userId="5c40f8ff-9e47-4060-8f0c-840d2230e7fd" providerId="ADAL" clId="{F96F223A-744B-443A-9AE5-FCB292DC9848}" dt="2024-04-17T23:16:10.103" v="887" actId="20577"/>
        <pc:sldMkLst>
          <pc:docMk/>
          <pc:sldMk cId="82386172" sldId="258"/>
        </pc:sldMkLst>
        <pc:spChg chg="del">
          <ac:chgData name="Suman, Shankar, Ph.D." userId="5c40f8ff-9e47-4060-8f0c-840d2230e7fd" providerId="ADAL" clId="{F96F223A-744B-443A-9AE5-FCB292DC9848}" dt="2024-04-03T19:42:14.736" v="440" actId="478"/>
          <ac:spMkLst>
            <pc:docMk/>
            <pc:sldMk cId="82386172" sldId="258"/>
            <ac:spMk id="2" creationId="{4F992B5B-47E0-C052-4F27-CFE1EB4FD4B1}"/>
          </ac:spMkLst>
        </pc:spChg>
        <pc:spChg chg="add mod">
          <ac:chgData name="Suman, Shankar, Ph.D." userId="5c40f8ff-9e47-4060-8f0c-840d2230e7fd" providerId="ADAL" clId="{F96F223A-744B-443A-9AE5-FCB292DC9848}" dt="2024-04-17T21:52:58.593" v="549" actId="20577"/>
          <ac:spMkLst>
            <pc:docMk/>
            <pc:sldMk cId="82386172" sldId="258"/>
            <ac:spMk id="2" creationId="{8F9C5386-591D-F5A2-8036-86BB9C5A7A10}"/>
          </ac:spMkLst>
        </pc:spChg>
        <pc:spChg chg="del">
          <ac:chgData name="Suman, Shankar, Ph.D." userId="5c40f8ff-9e47-4060-8f0c-840d2230e7fd" providerId="ADAL" clId="{F96F223A-744B-443A-9AE5-FCB292DC9848}" dt="2024-04-03T19:42:14.736" v="440" actId="478"/>
          <ac:spMkLst>
            <pc:docMk/>
            <pc:sldMk cId="82386172" sldId="258"/>
            <ac:spMk id="3" creationId="{346B2C35-9CA4-9839-73C0-07A0773AC03D}"/>
          </ac:spMkLst>
        </pc:spChg>
        <pc:spChg chg="add mod">
          <ac:chgData name="Suman, Shankar, Ph.D." userId="5c40f8ff-9e47-4060-8f0c-840d2230e7fd" providerId="ADAL" clId="{F96F223A-744B-443A-9AE5-FCB292DC9848}" dt="2024-04-17T23:16:10.103" v="887" actId="20577"/>
          <ac:spMkLst>
            <pc:docMk/>
            <pc:sldMk cId="82386172" sldId="258"/>
            <ac:spMk id="4" creationId="{77B976B6-553F-4F55-F2B4-A9734EA88A85}"/>
          </ac:spMkLst>
        </pc:spChg>
        <pc:spChg chg="mod">
          <ac:chgData name="Suman, Shankar, Ph.D." userId="5c40f8ff-9e47-4060-8f0c-840d2230e7fd" providerId="ADAL" clId="{F96F223A-744B-443A-9AE5-FCB292DC9848}" dt="2024-04-03T19:45:11.768" v="445"/>
          <ac:spMkLst>
            <pc:docMk/>
            <pc:sldMk cId="82386172" sldId="258"/>
            <ac:spMk id="7" creationId="{83C1721C-8407-9AC4-3F0D-0FA77DA28F6C}"/>
          </ac:spMkLst>
        </pc:spChg>
        <pc:spChg chg="mod">
          <ac:chgData name="Suman, Shankar, Ph.D." userId="5c40f8ff-9e47-4060-8f0c-840d2230e7fd" providerId="ADAL" clId="{F96F223A-744B-443A-9AE5-FCB292DC9848}" dt="2024-04-03T19:45:11.768" v="445"/>
          <ac:spMkLst>
            <pc:docMk/>
            <pc:sldMk cId="82386172" sldId="258"/>
            <ac:spMk id="8" creationId="{6CF18541-DA42-2B00-AD75-5574B396EC4A}"/>
          </ac:spMkLst>
        </pc:spChg>
        <pc:spChg chg="mod">
          <ac:chgData name="Suman, Shankar, Ph.D." userId="5c40f8ff-9e47-4060-8f0c-840d2230e7fd" providerId="ADAL" clId="{F96F223A-744B-443A-9AE5-FCB292DC9848}" dt="2024-04-03T19:45:11.768" v="445"/>
          <ac:spMkLst>
            <pc:docMk/>
            <pc:sldMk cId="82386172" sldId="258"/>
            <ac:spMk id="9" creationId="{59D14F7B-191A-868B-077D-C82DA328783A}"/>
          </ac:spMkLst>
        </pc:spChg>
        <pc:spChg chg="mod">
          <ac:chgData name="Suman, Shankar, Ph.D." userId="5c40f8ff-9e47-4060-8f0c-840d2230e7fd" providerId="ADAL" clId="{F96F223A-744B-443A-9AE5-FCB292DC9848}" dt="2024-04-03T19:45:11.768" v="445"/>
          <ac:spMkLst>
            <pc:docMk/>
            <pc:sldMk cId="82386172" sldId="258"/>
            <ac:spMk id="10" creationId="{3B8CD912-A0F5-A91D-1F60-845CD222048C}"/>
          </ac:spMkLst>
        </pc:spChg>
        <pc:spChg chg="mod">
          <ac:chgData name="Suman, Shankar, Ph.D." userId="5c40f8ff-9e47-4060-8f0c-840d2230e7fd" providerId="ADAL" clId="{F96F223A-744B-443A-9AE5-FCB292DC9848}" dt="2024-04-03T19:45:11.768" v="445"/>
          <ac:spMkLst>
            <pc:docMk/>
            <pc:sldMk cId="82386172" sldId="258"/>
            <ac:spMk id="14" creationId="{51FC1957-0CE9-1F18-AD8A-64EC1F85DFDF}"/>
          </ac:spMkLst>
        </pc:spChg>
        <pc:spChg chg="mod">
          <ac:chgData name="Suman, Shankar, Ph.D." userId="5c40f8ff-9e47-4060-8f0c-840d2230e7fd" providerId="ADAL" clId="{F96F223A-744B-443A-9AE5-FCB292DC9848}" dt="2024-04-03T19:45:11.768" v="445"/>
          <ac:spMkLst>
            <pc:docMk/>
            <pc:sldMk cId="82386172" sldId="258"/>
            <ac:spMk id="15" creationId="{87D67BAA-8E27-F0EF-FBC2-7173F18727E6}"/>
          </ac:spMkLst>
        </pc:spChg>
        <pc:spChg chg="add del mod">
          <ac:chgData name="Suman, Shankar, Ph.D." userId="5c40f8ff-9e47-4060-8f0c-840d2230e7fd" providerId="ADAL" clId="{F96F223A-744B-443A-9AE5-FCB292DC9848}" dt="2024-04-03T20:29:31.532" v="452" actId="478"/>
          <ac:spMkLst>
            <pc:docMk/>
            <pc:sldMk cId="82386172" sldId="258"/>
            <ac:spMk id="16" creationId="{0693AB5C-5BC1-2B92-F514-1577A6401E73}"/>
          </ac:spMkLst>
        </pc:spChg>
        <pc:spChg chg="add del mod">
          <ac:chgData name="Suman, Shankar, Ph.D." userId="5c40f8ff-9e47-4060-8f0c-840d2230e7fd" providerId="ADAL" clId="{F96F223A-744B-443A-9AE5-FCB292DC9848}" dt="2024-04-03T20:29:44.834" v="460" actId="478"/>
          <ac:spMkLst>
            <pc:docMk/>
            <pc:sldMk cId="82386172" sldId="258"/>
            <ac:spMk id="17" creationId="{6A6924ED-673F-4E6E-511A-93B0540CFB49}"/>
          </ac:spMkLst>
        </pc:spChg>
        <pc:spChg chg="add mod">
          <ac:chgData name="Suman, Shankar, Ph.D." userId="5c40f8ff-9e47-4060-8f0c-840d2230e7fd" providerId="ADAL" clId="{F96F223A-744B-443A-9AE5-FCB292DC9848}" dt="2024-04-03T20:30:17.201" v="471" actId="1076"/>
          <ac:spMkLst>
            <pc:docMk/>
            <pc:sldMk cId="82386172" sldId="258"/>
            <ac:spMk id="18" creationId="{B8EF0BCD-3062-4C6B-ED1F-4E3F6FE23550}"/>
          </ac:spMkLst>
        </pc:spChg>
        <pc:spChg chg="add mod">
          <ac:chgData name="Suman, Shankar, Ph.D." userId="5c40f8ff-9e47-4060-8f0c-840d2230e7fd" providerId="ADAL" clId="{F96F223A-744B-443A-9AE5-FCB292DC9848}" dt="2024-04-03T20:29:50.004" v="462" actId="1076"/>
          <ac:spMkLst>
            <pc:docMk/>
            <pc:sldMk cId="82386172" sldId="258"/>
            <ac:spMk id="19" creationId="{458DDED6-B62E-9065-857E-D1F356D29343}"/>
          </ac:spMkLst>
        </pc:spChg>
        <pc:spChg chg="add mod">
          <ac:chgData name="Suman, Shankar, Ph.D." userId="5c40f8ff-9e47-4060-8f0c-840d2230e7fd" providerId="ADAL" clId="{F96F223A-744B-443A-9AE5-FCB292DC9848}" dt="2024-04-03T20:29:52.665" v="463" actId="1076"/>
          <ac:spMkLst>
            <pc:docMk/>
            <pc:sldMk cId="82386172" sldId="258"/>
            <ac:spMk id="20" creationId="{9830BFAC-51D1-B355-2380-4ECAF00ACD9D}"/>
          </ac:spMkLst>
        </pc:spChg>
        <pc:spChg chg="add del mod">
          <ac:chgData name="Suman, Shankar, Ph.D." userId="5c40f8ff-9e47-4060-8f0c-840d2230e7fd" providerId="ADAL" clId="{F96F223A-744B-443A-9AE5-FCB292DC9848}" dt="2024-04-03T20:30:19.421" v="472" actId="478"/>
          <ac:spMkLst>
            <pc:docMk/>
            <pc:sldMk cId="82386172" sldId="258"/>
            <ac:spMk id="21" creationId="{E72D0657-9CED-1941-5289-AA68CBBEB31D}"/>
          </ac:spMkLst>
        </pc:spChg>
        <pc:spChg chg="add mod">
          <ac:chgData name="Suman, Shankar, Ph.D." userId="5c40f8ff-9e47-4060-8f0c-840d2230e7fd" providerId="ADAL" clId="{F96F223A-744B-443A-9AE5-FCB292DC9848}" dt="2024-04-03T20:31:22.795" v="499" actId="1076"/>
          <ac:spMkLst>
            <pc:docMk/>
            <pc:sldMk cId="82386172" sldId="258"/>
            <ac:spMk id="23" creationId="{62987D06-59A5-3393-49D0-3F20628967A5}"/>
          </ac:spMkLst>
        </pc:spChg>
        <pc:spChg chg="add mod">
          <ac:chgData name="Suman, Shankar, Ph.D." userId="5c40f8ff-9e47-4060-8f0c-840d2230e7fd" providerId="ADAL" clId="{F96F223A-744B-443A-9AE5-FCB292DC9848}" dt="2024-04-03T20:31:29.189" v="501" actId="1076"/>
          <ac:spMkLst>
            <pc:docMk/>
            <pc:sldMk cId="82386172" sldId="258"/>
            <ac:spMk id="24" creationId="{49BAA0A6-7292-AE93-38C4-4B5849D39561}"/>
          </ac:spMkLst>
        </pc:spChg>
        <pc:spChg chg="add del mod">
          <ac:chgData name="Suman, Shankar, Ph.D." userId="5c40f8ff-9e47-4060-8f0c-840d2230e7fd" providerId="ADAL" clId="{F96F223A-744B-443A-9AE5-FCB292DC9848}" dt="2024-04-03T20:31:48.828" v="506" actId="478"/>
          <ac:spMkLst>
            <pc:docMk/>
            <pc:sldMk cId="82386172" sldId="258"/>
            <ac:spMk id="25" creationId="{4397D418-675C-60E8-21CF-8AF4E3249716}"/>
          </ac:spMkLst>
        </pc:spChg>
        <pc:grpChg chg="add mod">
          <ac:chgData name="Suman, Shankar, Ph.D." userId="5c40f8ff-9e47-4060-8f0c-840d2230e7fd" providerId="ADAL" clId="{F96F223A-744B-443A-9AE5-FCB292DC9848}" dt="2024-04-03T19:45:15.123" v="446" actId="1076"/>
          <ac:grpSpMkLst>
            <pc:docMk/>
            <pc:sldMk cId="82386172" sldId="258"/>
            <ac:grpSpMk id="5" creationId="{E74DA9B1-F74D-7A91-E8AF-86F485C4695E}"/>
          </ac:grpSpMkLst>
        </pc:grpChg>
        <pc:grpChg chg="mod">
          <ac:chgData name="Suman, Shankar, Ph.D." userId="5c40f8ff-9e47-4060-8f0c-840d2230e7fd" providerId="ADAL" clId="{F96F223A-744B-443A-9AE5-FCB292DC9848}" dt="2024-04-03T19:45:11.768" v="445"/>
          <ac:grpSpMkLst>
            <pc:docMk/>
            <pc:sldMk cId="82386172" sldId="258"/>
            <ac:grpSpMk id="11" creationId="{9980C76D-3B07-4BE7-22FF-983AE5A42D40}"/>
          </ac:grpSpMkLst>
        </pc:grpChg>
        <pc:picChg chg="mod">
          <ac:chgData name="Suman, Shankar, Ph.D." userId="5c40f8ff-9e47-4060-8f0c-840d2230e7fd" providerId="ADAL" clId="{F96F223A-744B-443A-9AE5-FCB292DC9848}" dt="2024-04-03T19:45:11.768" v="445"/>
          <ac:picMkLst>
            <pc:docMk/>
            <pc:sldMk cId="82386172" sldId="258"/>
            <ac:picMk id="6" creationId="{4686E6F7-1A12-C48A-8C4B-366086DB05CE}"/>
          </ac:picMkLst>
        </pc:picChg>
        <pc:picChg chg="mod">
          <ac:chgData name="Suman, Shankar, Ph.D." userId="5c40f8ff-9e47-4060-8f0c-840d2230e7fd" providerId="ADAL" clId="{F96F223A-744B-443A-9AE5-FCB292DC9848}" dt="2024-04-03T19:45:11.768" v="445"/>
          <ac:picMkLst>
            <pc:docMk/>
            <pc:sldMk cId="82386172" sldId="258"/>
            <ac:picMk id="12" creationId="{6F089C6B-F714-9081-55DF-6CBA8F159563}"/>
          </ac:picMkLst>
        </pc:picChg>
        <pc:picChg chg="del mod modCrop">
          <ac:chgData name="Suman, Shankar, Ph.D." userId="5c40f8ff-9e47-4060-8f0c-840d2230e7fd" providerId="ADAL" clId="{F96F223A-744B-443A-9AE5-FCB292DC9848}" dt="2024-04-03T20:30:33.336" v="474" actId="21"/>
          <ac:picMkLst>
            <pc:docMk/>
            <pc:sldMk cId="82386172" sldId="258"/>
            <ac:picMk id="13" creationId="{2B782F9C-E9BD-BA1D-912B-43F2814F4E31}"/>
          </ac:picMkLst>
        </pc:picChg>
        <pc:picChg chg="add mod">
          <ac:chgData name="Suman, Shankar, Ph.D." userId="5c40f8ff-9e47-4060-8f0c-840d2230e7fd" providerId="ADAL" clId="{F96F223A-744B-443A-9AE5-FCB292DC9848}" dt="2024-04-03T20:30:45.143" v="477" actId="1076"/>
          <ac:picMkLst>
            <pc:docMk/>
            <pc:sldMk cId="82386172" sldId="258"/>
            <ac:picMk id="22" creationId="{04AB3514-FC06-FB87-4AF9-FF6DCFE4FDF4}"/>
          </ac:picMkLst>
        </pc:picChg>
      </pc:sldChg>
      <pc:sldChg chg="addSp delSp modSp new mod">
        <pc:chgData name="Suman, Shankar, Ph.D." userId="5c40f8ff-9e47-4060-8f0c-840d2230e7fd" providerId="ADAL" clId="{F96F223A-744B-443A-9AE5-FCB292DC9848}" dt="2024-04-17T21:59:21.888" v="675" actId="20577"/>
        <pc:sldMkLst>
          <pc:docMk/>
          <pc:sldMk cId="1006216581" sldId="259"/>
        </pc:sldMkLst>
        <pc:spChg chg="del">
          <ac:chgData name="Suman, Shankar, Ph.D." userId="5c40f8ff-9e47-4060-8f0c-840d2230e7fd" providerId="ADAL" clId="{F96F223A-744B-443A-9AE5-FCB292DC9848}" dt="2024-04-03T20:32:14.459" v="508" actId="478"/>
          <ac:spMkLst>
            <pc:docMk/>
            <pc:sldMk cId="1006216581" sldId="259"/>
            <ac:spMk id="2" creationId="{23CC00DB-BDFA-A4C2-9833-6C9BED1171AB}"/>
          </ac:spMkLst>
        </pc:spChg>
        <pc:spChg chg="add mod">
          <ac:chgData name="Suman, Shankar, Ph.D." userId="5c40f8ff-9e47-4060-8f0c-840d2230e7fd" providerId="ADAL" clId="{F96F223A-744B-443A-9AE5-FCB292DC9848}" dt="2024-04-17T21:59:21.888" v="675" actId="20577"/>
          <ac:spMkLst>
            <pc:docMk/>
            <pc:sldMk cId="1006216581" sldId="259"/>
            <ac:spMk id="3" creationId="{820AC9B5-EF24-EDC3-A37B-BA9BB9E0EC1B}"/>
          </ac:spMkLst>
        </pc:spChg>
        <pc:spChg chg="del">
          <ac:chgData name="Suman, Shankar, Ph.D." userId="5c40f8ff-9e47-4060-8f0c-840d2230e7fd" providerId="ADAL" clId="{F96F223A-744B-443A-9AE5-FCB292DC9848}" dt="2024-04-03T20:32:14.459" v="508" actId="478"/>
          <ac:spMkLst>
            <pc:docMk/>
            <pc:sldMk cId="1006216581" sldId="259"/>
            <ac:spMk id="3" creationId="{D77C0098-20A3-6C4F-E935-15E597271BE7}"/>
          </ac:spMkLst>
        </pc:spChg>
        <pc:spChg chg="add del mod">
          <ac:chgData name="Suman, Shankar, Ph.D." userId="5c40f8ff-9e47-4060-8f0c-840d2230e7fd" providerId="ADAL" clId="{F96F223A-744B-443A-9AE5-FCB292DC9848}" dt="2024-04-15T20:34:11.069" v="530" actId="478"/>
          <ac:spMkLst>
            <pc:docMk/>
            <pc:sldMk cId="1006216581" sldId="259"/>
            <ac:spMk id="4" creationId="{873C9E33-EEA6-65E6-F1F9-FAE59484D703}"/>
          </ac:spMkLst>
        </pc:spChg>
        <pc:spChg chg="add mod">
          <ac:chgData name="Suman, Shankar, Ph.D." userId="5c40f8ff-9e47-4060-8f0c-840d2230e7fd" providerId="ADAL" clId="{F96F223A-744B-443A-9AE5-FCB292DC9848}" dt="2024-04-17T21:57:23.475" v="555" actId="20577"/>
          <ac:spMkLst>
            <pc:docMk/>
            <pc:sldMk cId="1006216581" sldId="259"/>
            <ac:spMk id="4" creationId="{B114B6FA-95FA-4472-9852-72971ABD883E}"/>
          </ac:spMkLst>
        </pc:spChg>
        <pc:graphicFrameChg chg="add mod">
          <ac:chgData name="Suman, Shankar, Ph.D." userId="5c40f8ff-9e47-4060-8f0c-840d2230e7fd" providerId="ADAL" clId="{F96F223A-744B-443A-9AE5-FCB292DC9848}" dt="2024-04-17T21:56:39.025" v="553"/>
          <ac:graphicFrameMkLst>
            <pc:docMk/>
            <pc:sldMk cId="1006216581" sldId="259"/>
            <ac:graphicFrameMk id="2" creationId="{98157053-CAFA-7B7F-48C2-D97796166411}"/>
          </ac:graphicFrameMkLst>
        </pc:graphicFrameChg>
      </pc:sldChg>
    </pc:docChg>
  </pc:docChgLst>
  <pc:docChgLst>
    <pc:chgData name="Suman, Shankar, Ph.D." userId="5c40f8ff-9e47-4060-8f0c-840d2230e7fd" providerId="ADAL" clId="{6E4720F3-8BE3-46B0-A6CD-52882C4F77D0}"/>
    <pc:docChg chg="undo custSel addSld modSld sldOrd">
      <pc:chgData name="Suman, Shankar, Ph.D." userId="5c40f8ff-9e47-4060-8f0c-840d2230e7fd" providerId="ADAL" clId="{6E4720F3-8BE3-46B0-A6CD-52882C4F77D0}" dt="2024-05-13T20:22:17.444" v="202" actId="20577"/>
      <pc:docMkLst>
        <pc:docMk/>
      </pc:docMkLst>
      <pc:sldChg chg="modSp mod ord">
        <pc:chgData name="Suman, Shankar, Ph.D." userId="5c40f8ff-9e47-4060-8f0c-840d2230e7fd" providerId="ADAL" clId="{6E4720F3-8BE3-46B0-A6CD-52882C4F77D0}" dt="2024-05-13T19:26:37.077" v="189" actId="20577"/>
        <pc:sldMkLst>
          <pc:docMk/>
          <pc:sldMk cId="82386172" sldId="258"/>
        </pc:sldMkLst>
        <pc:spChg chg="mod">
          <ac:chgData name="Suman, Shankar, Ph.D." userId="5c40f8ff-9e47-4060-8f0c-840d2230e7fd" providerId="ADAL" clId="{6E4720F3-8BE3-46B0-A6CD-52882C4F77D0}" dt="2024-05-13T19:26:37.077" v="189" actId="20577"/>
          <ac:spMkLst>
            <pc:docMk/>
            <pc:sldMk cId="82386172" sldId="258"/>
            <ac:spMk id="2" creationId="{8F9C5386-591D-F5A2-8036-86BB9C5A7A10}"/>
          </ac:spMkLst>
        </pc:spChg>
        <pc:spChg chg="mod">
          <ac:chgData name="Suman, Shankar, Ph.D." userId="5c40f8ff-9e47-4060-8f0c-840d2230e7fd" providerId="ADAL" clId="{6E4720F3-8BE3-46B0-A6CD-52882C4F77D0}" dt="2024-05-13T16:24:03.055" v="173" actId="20577"/>
          <ac:spMkLst>
            <pc:docMk/>
            <pc:sldMk cId="82386172" sldId="258"/>
            <ac:spMk id="4" creationId="{77B976B6-553F-4F55-F2B4-A9734EA88A85}"/>
          </ac:spMkLst>
        </pc:spChg>
        <pc:spChg chg="mod">
          <ac:chgData name="Suman, Shankar, Ph.D." userId="5c40f8ff-9e47-4060-8f0c-840d2230e7fd" providerId="ADAL" clId="{6E4720F3-8BE3-46B0-A6CD-52882C4F77D0}" dt="2024-05-13T17:05:39.633" v="187" actId="1076"/>
          <ac:spMkLst>
            <pc:docMk/>
            <pc:sldMk cId="82386172" sldId="258"/>
            <ac:spMk id="23" creationId="{62987D06-59A5-3393-49D0-3F20628967A5}"/>
          </ac:spMkLst>
        </pc:spChg>
        <pc:spChg chg="mod">
          <ac:chgData name="Suman, Shankar, Ph.D." userId="5c40f8ff-9e47-4060-8f0c-840d2230e7fd" providerId="ADAL" clId="{6E4720F3-8BE3-46B0-A6CD-52882C4F77D0}" dt="2024-05-13T17:05:37.177" v="186" actId="1076"/>
          <ac:spMkLst>
            <pc:docMk/>
            <pc:sldMk cId="82386172" sldId="258"/>
            <ac:spMk id="24" creationId="{49BAA0A6-7292-AE93-38C4-4B5849D39561}"/>
          </ac:spMkLst>
        </pc:spChg>
      </pc:sldChg>
      <pc:sldChg chg="modSp mod">
        <pc:chgData name="Suman, Shankar, Ph.D." userId="5c40f8ff-9e47-4060-8f0c-840d2230e7fd" providerId="ADAL" clId="{6E4720F3-8BE3-46B0-A6CD-52882C4F77D0}" dt="2024-05-13T20:22:14.660" v="200" actId="20577"/>
        <pc:sldMkLst>
          <pc:docMk/>
          <pc:sldMk cId="1006216581" sldId="259"/>
        </pc:sldMkLst>
        <pc:spChg chg="mod">
          <ac:chgData name="Suman, Shankar, Ph.D." userId="5c40f8ff-9e47-4060-8f0c-840d2230e7fd" providerId="ADAL" clId="{6E4720F3-8BE3-46B0-A6CD-52882C4F77D0}" dt="2024-05-13T20:22:12.042" v="198" actId="20577"/>
          <ac:spMkLst>
            <pc:docMk/>
            <pc:sldMk cId="1006216581" sldId="259"/>
            <ac:spMk id="3" creationId="{820AC9B5-EF24-EDC3-A37B-BA9BB9E0EC1B}"/>
          </ac:spMkLst>
        </pc:spChg>
        <pc:spChg chg="mod">
          <ac:chgData name="Suman, Shankar, Ph.D." userId="5c40f8ff-9e47-4060-8f0c-840d2230e7fd" providerId="ADAL" clId="{6E4720F3-8BE3-46B0-A6CD-52882C4F77D0}" dt="2024-05-13T20:22:14.660" v="200" actId="20577"/>
          <ac:spMkLst>
            <pc:docMk/>
            <pc:sldMk cId="1006216581" sldId="259"/>
            <ac:spMk id="4" creationId="{B114B6FA-95FA-4472-9852-72971ABD883E}"/>
          </ac:spMkLst>
        </pc:spChg>
        <pc:graphicFrameChg chg="mod">
          <ac:chgData name="Suman, Shankar, Ph.D." userId="5c40f8ff-9e47-4060-8f0c-840d2230e7fd" providerId="ADAL" clId="{6E4720F3-8BE3-46B0-A6CD-52882C4F77D0}" dt="2024-05-02T22:34:00.764" v="2"/>
          <ac:graphicFrameMkLst>
            <pc:docMk/>
            <pc:sldMk cId="1006216581" sldId="259"/>
            <ac:graphicFrameMk id="2" creationId="{98157053-CAFA-7B7F-48C2-D97796166411}"/>
          </ac:graphicFrameMkLst>
        </pc:graphicFrameChg>
      </pc:sldChg>
      <pc:sldChg chg="addSp delSp modSp new mod ord">
        <pc:chgData name="Suman, Shankar, Ph.D." userId="5c40f8ff-9e47-4060-8f0c-840d2230e7fd" providerId="ADAL" clId="{6E4720F3-8BE3-46B0-A6CD-52882C4F77D0}" dt="2024-05-13T20:22:17.444" v="202" actId="20577"/>
        <pc:sldMkLst>
          <pc:docMk/>
          <pc:sldMk cId="566839228" sldId="260"/>
        </pc:sldMkLst>
        <pc:spChg chg="del">
          <ac:chgData name="Suman, Shankar, Ph.D." userId="5c40f8ff-9e47-4060-8f0c-840d2230e7fd" providerId="ADAL" clId="{6E4720F3-8BE3-46B0-A6CD-52882C4F77D0}" dt="2024-05-13T16:10:46.314" v="4" actId="478"/>
          <ac:spMkLst>
            <pc:docMk/>
            <pc:sldMk cId="566839228" sldId="260"/>
            <ac:spMk id="2" creationId="{702BAFAA-DA19-53C0-DFBB-60795F21CEFC}"/>
          </ac:spMkLst>
        </pc:spChg>
        <pc:spChg chg="add mod">
          <ac:chgData name="Suman, Shankar, Ph.D." userId="5c40f8ff-9e47-4060-8f0c-840d2230e7fd" providerId="ADAL" clId="{6E4720F3-8BE3-46B0-A6CD-52882C4F77D0}" dt="2024-05-13T20:22:17.444" v="202" actId="20577"/>
          <ac:spMkLst>
            <pc:docMk/>
            <pc:sldMk cId="566839228" sldId="260"/>
            <ac:spMk id="2" creationId="{E2F815E8-B831-BDC7-C3EF-DB50F4996774}"/>
          </ac:spMkLst>
        </pc:spChg>
        <pc:spChg chg="del">
          <ac:chgData name="Suman, Shankar, Ph.D." userId="5c40f8ff-9e47-4060-8f0c-840d2230e7fd" providerId="ADAL" clId="{6E4720F3-8BE3-46B0-A6CD-52882C4F77D0}" dt="2024-05-13T16:10:46.314" v="4" actId="478"/>
          <ac:spMkLst>
            <pc:docMk/>
            <pc:sldMk cId="566839228" sldId="260"/>
            <ac:spMk id="3" creationId="{357E47AE-4EDC-46BC-A8DB-F2E6AFB61D10}"/>
          </ac:spMkLst>
        </pc:spChg>
        <pc:spChg chg="mod">
          <ac:chgData name="Suman, Shankar, Ph.D." userId="5c40f8ff-9e47-4060-8f0c-840d2230e7fd" providerId="ADAL" clId="{6E4720F3-8BE3-46B0-A6CD-52882C4F77D0}" dt="2024-05-13T16:10:47.387" v="5"/>
          <ac:spMkLst>
            <pc:docMk/>
            <pc:sldMk cId="566839228" sldId="260"/>
            <ac:spMk id="5" creationId="{A9286494-85F3-471E-9607-058AAD99A8C8}"/>
          </ac:spMkLst>
        </pc:spChg>
        <pc:spChg chg="mod">
          <ac:chgData name="Suman, Shankar, Ph.D." userId="5c40f8ff-9e47-4060-8f0c-840d2230e7fd" providerId="ADAL" clId="{6E4720F3-8BE3-46B0-A6CD-52882C4F77D0}" dt="2024-05-13T16:10:47.387" v="5"/>
          <ac:spMkLst>
            <pc:docMk/>
            <pc:sldMk cId="566839228" sldId="260"/>
            <ac:spMk id="6" creationId="{5907269C-D45B-E027-9E3D-846EB3FC47F3}"/>
          </ac:spMkLst>
        </pc:spChg>
        <pc:spChg chg="mod">
          <ac:chgData name="Suman, Shankar, Ph.D." userId="5c40f8ff-9e47-4060-8f0c-840d2230e7fd" providerId="ADAL" clId="{6E4720F3-8BE3-46B0-A6CD-52882C4F77D0}" dt="2024-05-13T16:10:47.387" v="5"/>
          <ac:spMkLst>
            <pc:docMk/>
            <pc:sldMk cId="566839228" sldId="260"/>
            <ac:spMk id="8" creationId="{A8994BD7-983E-7560-C6A3-6004EFD9482F}"/>
          </ac:spMkLst>
        </pc:spChg>
        <pc:spChg chg="mod">
          <ac:chgData name="Suman, Shankar, Ph.D." userId="5c40f8ff-9e47-4060-8f0c-840d2230e7fd" providerId="ADAL" clId="{6E4720F3-8BE3-46B0-A6CD-52882C4F77D0}" dt="2024-05-13T16:10:47.387" v="5"/>
          <ac:spMkLst>
            <pc:docMk/>
            <pc:sldMk cId="566839228" sldId="260"/>
            <ac:spMk id="9" creationId="{F989164F-1CE9-33D3-35F9-DFA88E1180BC}"/>
          </ac:spMkLst>
        </pc:spChg>
        <pc:spChg chg="mod">
          <ac:chgData name="Suman, Shankar, Ph.D." userId="5c40f8ff-9e47-4060-8f0c-840d2230e7fd" providerId="ADAL" clId="{6E4720F3-8BE3-46B0-A6CD-52882C4F77D0}" dt="2024-05-13T16:10:47.387" v="5"/>
          <ac:spMkLst>
            <pc:docMk/>
            <pc:sldMk cId="566839228" sldId="260"/>
            <ac:spMk id="10" creationId="{E02F5D9A-D8C1-6DDE-7547-575D15D545E5}"/>
          </ac:spMkLst>
        </pc:spChg>
        <pc:spChg chg="mod">
          <ac:chgData name="Suman, Shankar, Ph.D." userId="5c40f8ff-9e47-4060-8f0c-840d2230e7fd" providerId="ADAL" clId="{6E4720F3-8BE3-46B0-A6CD-52882C4F77D0}" dt="2024-05-13T16:10:47.387" v="5"/>
          <ac:spMkLst>
            <pc:docMk/>
            <pc:sldMk cId="566839228" sldId="260"/>
            <ac:spMk id="11" creationId="{90EF35B7-95BB-F50B-2D7A-E9AFC1F93D28}"/>
          </ac:spMkLst>
        </pc:spChg>
        <pc:spChg chg="add mod">
          <ac:chgData name="Suman, Shankar, Ph.D." userId="5c40f8ff-9e47-4060-8f0c-840d2230e7fd" providerId="ADAL" clId="{6E4720F3-8BE3-46B0-A6CD-52882C4F77D0}" dt="2024-05-13T20:22:06.528" v="194" actId="20577"/>
          <ac:spMkLst>
            <pc:docMk/>
            <pc:sldMk cId="566839228" sldId="260"/>
            <ac:spMk id="12" creationId="{C5DC9843-A5A5-1AF7-108A-B2BDD67A3E83}"/>
          </ac:spMkLst>
        </pc:spChg>
        <pc:spChg chg="add del mod">
          <ac:chgData name="Suman, Shankar, Ph.D." userId="5c40f8ff-9e47-4060-8f0c-840d2230e7fd" providerId="ADAL" clId="{6E4720F3-8BE3-46B0-A6CD-52882C4F77D0}" dt="2024-05-13T16:21:28.139" v="111" actId="478"/>
          <ac:spMkLst>
            <pc:docMk/>
            <pc:sldMk cId="566839228" sldId="260"/>
            <ac:spMk id="14" creationId="{401E846A-2A2D-582E-561A-29D147089FE4}"/>
          </ac:spMkLst>
        </pc:spChg>
        <pc:spChg chg="add del mod">
          <ac:chgData name="Suman, Shankar, Ph.D." userId="5c40f8ff-9e47-4060-8f0c-840d2230e7fd" providerId="ADAL" clId="{6E4720F3-8BE3-46B0-A6CD-52882C4F77D0}" dt="2024-05-13T16:21:29.268" v="112" actId="478"/>
          <ac:spMkLst>
            <pc:docMk/>
            <pc:sldMk cId="566839228" sldId="260"/>
            <ac:spMk id="16" creationId="{CB89867C-7411-E083-D3A3-4B9163F6A8E3}"/>
          </ac:spMkLst>
        </pc:spChg>
        <pc:spChg chg="add mod">
          <ac:chgData name="Suman, Shankar, Ph.D." userId="5c40f8ff-9e47-4060-8f0c-840d2230e7fd" providerId="ADAL" clId="{6E4720F3-8BE3-46B0-A6CD-52882C4F77D0}" dt="2024-05-13T16:21:53.901" v="127" actId="1076"/>
          <ac:spMkLst>
            <pc:docMk/>
            <pc:sldMk cId="566839228" sldId="260"/>
            <ac:spMk id="17" creationId="{561B2D43-FD6C-5C23-5D6F-A705620DC80D}"/>
          </ac:spMkLst>
        </pc:spChg>
        <pc:spChg chg="add mod">
          <ac:chgData name="Suman, Shankar, Ph.D." userId="5c40f8ff-9e47-4060-8f0c-840d2230e7fd" providerId="ADAL" clId="{6E4720F3-8BE3-46B0-A6CD-52882C4F77D0}" dt="2024-05-13T16:22:34.873" v="171" actId="20577"/>
          <ac:spMkLst>
            <pc:docMk/>
            <pc:sldMk cId="566839228" sldId="260"/>
            <ac:spMk id="18" creationId="{C47E9812-246F-4DC9-A7D8-E876D8AC0BD4}"/>
          </ac:spMkLst>
        </pc:spChg>
        <pc:grpChg chg="add mod">
          <ac:chgData name="Suman, Shankar, Ph.D." userId="5c40f8ff-9e47-4060-8f0c-840d2230e7fd" providerId="ADAL" clId="{6E4720F3-8BE3-46B0-A6CD-52882C4F77D0}" dt="2024-05-13T16:10:49.942" v="6" actId="1076"/>
          <ac:grpSpMkLst>
            <pc:docMk/>
            <pc:sldMk cId="566839228" sldId="260"/>
            <ac:grpSpMk id="4" creationId="{436DA0C9-400E-1C30-B32F-D7760D548B11}"/>
          </ac:grpSpMkLst>
        </pc:grpChg>
        <pc:picChg chg="mod">
          <ac:chgData name="Suman, Shankar, Ph.D." userId="5c40f8ff-9e47-4060-8f0c-840d2230e7fd" providerId="ADAL" clId="{6E4720F3-8BE3-46B0-A6CD-52882C4F77D0}" dt="2024-05-13T16:10:47.387" v="5"/>
          <ac:picMkLst>
            <pc:docMk/>
            <pc:sldMk cId="566839228" sldId="260"/>
            <ac:picMk id="7" creationId="{7A14FC36-318B-EB7E-8DBE-796453D76CCD}"/>
          </ac:picMkLst>
        </pc:picChg>
      </pc:sldChg>
    </pc:docChg>
  </pc:docChgLst>
  <pc:docChgLst>
    <pc:chgData name="Suman, Shankar, Ph.D." userId="5c40f8ff-9e47-4060-8f0c-840d2230e7fd" providerId="ADAL" clId="{54C19A9D-9880-497A-8DF1-3CAC4F7AC62D}"/>
    <pc:docChg chg="undo custSel addSld delSld modSld sldOrd">
      <pc:chgData name="Suman, Shankar, Ph.D." userId="5c40f8ff-9e47-4060-8f0c-840d2230e7fd" providerId="ADAL" clId="{54C19A9D-9880-497A-8DF1-3CAC4F7AC62D}" dt="2024-04-23T03:28:06.954" v="392" actId="47"/>
      <pc:docMkLst>
        <pc:docMk/>
      </pc:docMkLst>
      <pc:sldChg chg="ord">
        <pc:chgData name="Suman, Shankar, Ph.D." userId="5c40f8ff-9e47-4060-8f0c-840d2230e7fd" providerId="ADAL" clId="{54C19A9D-9880-497A-8DF1-3CAC4F7AC62D}" dt="2024-04-23T02:45:24.709" v="2" actId="20578"/>
        <pc:sldMkLst>
          <pc:docMk/>
          <pc:sldMk cId="1762179812" sldId="257"/>
        </pc:sldMkLst>
      </pc:sldChg>
      <pc:sldChg chg="addSp delSp modSp new del mod">
        <pc:chgData name="Suman, Shankar, Ph.D." userId="5c40f8ff-9e47-4060-8f0c-840d2230e7fd" providerId="ADAL" clId="{54C19A9D-9880-497A-8DF1-3CAC4F7AC62D}" dt="2024-04-23T03:28:06.954" v="392" actId="47"/>
        <pc:sldMkLst>
          <pc:docMk/>
          <pc:sldMk cId="13977908" sldId="260"/>
        </pc:sldMkLst>
        <pc:spChg chg="del">
          <ac:chgData name="Suman, Shankar, Ph.D." userId="5c40f8ff-9e47-4060-8f0c-840d2230e7fd" providerId="ADAL" clId="{54C19A9D-9880-497A-8DF1-3CAC4F7AC62D}" dt="2024-04-23T02:45:40.264" v="4" actId="478"/>
          <ac:spMkLst>
            <pc:docMk/>
            <pc:sldMk cId="13977908" sldId="260"/>
            <ac:spMk id="2" creationId="{AA7ECFDF-180D-C474-B012-DE2CE6ED5921}"/>
          </ac:spMkLst>
        </pc:spChg>
        <pc:spChg chg="del">
          <ac:chgData name="Suman, Shankar, Ph.D." userId="5c40f8ff-9e47-4060-8f0c-840d2230e7fd" providerId="ADAL" clId="{54C19A9D-9880-497A-8DF1-3CAC4F7AC62D}" dt="2024-04-23T02:45:40.264" v="4" actId="478"/>
          <ac:spMkLst>
            <pc:docMk/>
            <pc:sldMk cId="13977908" sldId="260"/>
            <ac:spMk id="3" creationId="{158EB39D-E11C-D2FC-3CCC-93E8EC731CA0}"/>
          </ac:spMkLst>
        </pc:spChg>
        <pc:spChg chg="add mod">
          <ac:chgData name="Suman, Shankar, Ph.D." userId="5c40f8ff-9e47-4060-8f0c-840d2230e7fd" providerId="ADAL" clId="{54C19A9D-9880-497A-8DF1-3CAC4F7AC62D}" dt="2024-04-23T02:55:19.269" v="12" actId="1076"/>
          <ac:spMkLst>
            <pc:docMk/>
            <pc:sldMk cId="13977908" sldId="260"/>
            <ac:spMk id="4" creationId="{F4F9F56A-0CE3-C65A-9FEB-4409C5229B70}"/>
          </ac:spMkLst>
        </pc:spChg>
        <pc:spChg chg="add del">
          <ac:chgData name="Suman, Shankar, Ph.D." userId="5c40f8ff-9e47-4060-8f0c-840d2230e7fd" providerId="ADAL" clId="{54C19A9D-9880-497A-8DF1-3CAC4F7AC62D}" dt="2024-04-23T03:08:01.691" v="388" actId="22"/>
          <ac:spMkLst>
            <pc:docMk/>
            <pc:sldMk cId="13977908" sldId="260"/>
            <ac:spMk id="7" creationId="{6A9DB6FB-4987-DFC8-6157-9F85E8186791}"/>
          </ac:spMkLst>
        </pc:spChg>
        <pc:spChg chg="add del">
          <ac:chgData name="Suman, Shankar, Ph.D." userId="5c40f8ff-9e47-4060-8f0c-840d2230e7fd" providerId="ADAL" clId="{54C19A9D-9880-497A-8DF1-3CAC4F7AC62D}" dt="2024-04-23T03:08:05.831" v="390" actId="22"/>
          <ac:spMkLst>
            <pc:docMk/>
            <pc:sldMk cId="13977908" sldId="260"/>
            <ac:spMk id="9" creationId="{6241CF9A-44D8-9B33-1371-10E0C3434199}"/>
          </ac:spMkLst>
        </pc:spChg>
        <pc:graphicFrameChg chg="add del mod modGraphic">
          <ac:chgData name="Suman, Shankar, Ph.D." userId="5c40f8ff-9e47-4060-8f0c-840d2230e7fd" providerId="ADAL" clId="{54C19A9D-9880-497A-8DF1-3CAC4F7AC62D}" dt="2024-04-23T03:27:58.157" v="391" actId="21"/>
          <ac:graphicFrameMkLst>
            <pc:docMk/>
            <pc:sldMk cId="13977908" sldId="260"/>
            <ac:graphicFrameMk id="5" creationId="{527909EA-1EE6-9678-45DB-C3FB7FFBD966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78EFA3-C36E-4F5E-9798-471440AC0886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A7C94F-FABE-4BC8-ACE8-AB3AD7CFED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0938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A7C94F-FABE-4BC8-ACE8-AB3AD7CFEDD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2136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A7C94F-FABE-4BC8-ACE8-AB3AD7CFEDD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6755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r>
              <a:rPr lang="en-US" b="0" i="0">
                <a:solidFill>
                  <a:srgbClr val="232323"/>
                </a:solidFill>
                <a:effectLst/>
                <a:highlight>
                  <a:srgbClr val="FFFFFF"/>
                </a:highlight>
                <a:latin typeface="inherit"/>
              </a:rPr>
              <a:t>Recombinant Human CD36 Protein (ECD, His Tag), HPLC-verified</a:t>
            </a:r>
          </a:p>
          <a:p>
            <a:pPr algn="l"/>
            <a:r>
              <a:rPr lang="en-US" b="1" i="0">
                <a:solidFill>
                  <a:srgbClr val="232323"/>
                </a:solidFill>
                <a:effectLst/>
                <a:highlight>
                  <a:srgbClr val="FFFFFF"/>
                </a:highlight>
                <a:latin typeface="Helvetica" panose="020B0604020202020204" pitchFamily="34" charset="0"/>
              </a:rPr>
              <a:t> 10752-H08H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A7C94F-FABE-4BC8-ACE8-AB3AD7CFEDD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84646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A83254-6574-4D17-949E-9CD1D24092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0825D7-7C63-3365-5465-C3D53BC741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66F081-FF3A-2D24-BF45-28CEF8942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81A4F3-035C-D598-5A07-25C7A3102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3CC1E1-933F-E6CE-2B50-160C4DCEB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07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13BC04-63FE-1503-6D33-12A9D88C78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A1A335-2201-4CDF-A67B-F60E453123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961CDC-6149-A0B7-6792-6507ECC2C4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FB4D70-DD92-73D8-0B8F-39D950F72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69CDF6-142D-C346-235C-7C9B5ACEB2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812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EAF96F5-AD20-2B85-A6BE-CDD8BFDC32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1D226D-09B8-0DB5-B093-71B40E3874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019F2-45D1-2B7C-3FD6-249F2636B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BDA464-96D9-15AF-0D48-17D3606DC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A7CFF1-A55F-7BE3-D091-B57DA2D8FE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3122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197BF7-F0DD-B072-4952-FB9C1D00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2F00F7-DD37-21A4-D8EC-1762610C20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65A7B5-0102-4FFC-0C30-49C8B05F6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7589B8-7EB6-9B6A-BC7F-E8BE23529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F888D9-537F-45AA-DB18-794D1992B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359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2FD6EA-2A59-1488-1889-6D4E4DE91B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A21084-FC94-A0AA-97F4-EEE71669CE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16126B-6A5B-5EC0-A9A2-B61818C95A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E5C2BF-9987-8D1F-8E25-0CCD645F6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A84899-E79A-66CE-375B-CBC601833C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788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F77C1E-A592-0F7E-1379-4B28073E59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6148C1-129F-EE57-D662-2F26AD03F8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33C19D-993D-75FB-3058-B17515636A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060A55-F1FB-A194-B356-D3B9D74040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AD7836-D77C-2EE2-A105-4CC1B9164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CBF5F5-8F7E-ACCB-00DC-1FA9B267F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611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66555-FD19-7F05-B52E-BCE00A5555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030DB0-87AC-D12C-FD22-28025C14BE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DBB5BE8-A0A7-CEF4-E8EB-78A538C149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BD6D70-C475-AB73-5913-A1ED6D25A2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93F001B-46E3-7A5E-086F-5253FC82F7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48DFD8-3012-6129-EFB7-0628950C7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9C2D20-1EEC-6F32-D3B0-CF42840D82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74F1D63-01EF-13FE-BFC2-99B8628A2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955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F5CC0B-C46D-A37F-A0CB-F8F4E36897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F316E1-520A-00DE-62D2-044EF0AC6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D2096E-8FF2-E3A0-A3DE-8716C04A06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583E191-D4E4-B645-EDBF-8D3E94FB82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073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6BA0A7A-3A3A-DF72-BDDC-0732438CB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A6C45C-35A5-0A56-9D87-BF6CC28D5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D03568-BBE3-EE14-54BA-991B20BE8F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461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065C71-205D-042F-9A69-00775752A7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1A53C8-AD63-CC4D-4A1F-A2E6F990C9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F27913-5139-A15F-F50C-CC22198B38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8D04D8-6839-AB39-A517-FF7D8D09F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64F720-F4EB-9336-F016-B81CDF20A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64522B-2183-31C8-EFE7-596B218AA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424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24DE0E-06B1-66ED-AF5E-E994880ACD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253E4B2-09D8-03A0-95C9-0C48AF86BB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51D036-0628-CB3E-645C-3F47937C11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09DE97-21D0-A80E-46B6-6780FAC53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50E604-B354-FDB2-75E0-EA3AFACC27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EC837F-3BCB-F350-A8AB-66DCDB5F0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994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BC2D689-A04F-3A63-7F7B-D5EE441C06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25C83D-CCB2-411D-27FF-74FA5B0AB5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4D3D9D-DDBF-D390-9CFC-6CF81D0733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BD1034-487E-44B6-A6DD-45FD1ED112F3}" type="datetimeFigureOut">
              <a:rPr lang="en-US" smtClean="0"/>
              <a:t>2024-07-1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774714-638E-5370-1C2E-0E183DE18F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240901-0A37-39A4-DC2B-83EB981786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AFFBC-6860-4F4F-ACBD-3240EC8AA3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153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Plot object">
            <a:extLst>
              <a:ext uri="{FF2B5EF4-FFF2-40B4-BE49-F238E27FC236}">
                <a16:creationId xmlns:a16="http://schemas.microsoft.com/office/drawing/2014/main" id="{9030184C-C864-2041-DBD0-37451DC93D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2636" y="876300"/>
            <a:ext cx="11588363" cy="5511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B5FCC86-00B9-7478-D736-6BB27A34F587}"/>
              </a:ext>
            </a:extLst>
          </p:cNvPr>
          <p:cNvSpPr txBox="1"/>
          <p:nvPr/>
        </p:nvSpPr>
        <p:spPr>
          <a:xfrm>
            <a:off x="10836803" y="6388100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ure: S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AAB1EBA-CD04-1C76-A055-9886ACC15518}"/>
              </a:ext>
            </a:extLst>
          </p:cNvPr>
          <p:cNvSpPr txBox="1"/>
          <p:nvPr/>
        </p:nvSpPr>
        <p:spPr>
          <a:xfrm>
            <a:off x="1298107" y="335992"/>
            <a:ext cx="959578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Palatino Linotype" panose="02040502050505030304" pitchFamily="18" charset="0"/>
              </a:rPr>
              <a:t>Figure S1</a:t>
            </a:r>
            <a:r>
              <a:rPr lang="en-US" b="1" dirty="0">
                <a:latin typeface="Palatino Linotype" panose="02040502050505030304" pitchFamily="18" charset="0"/>
              </a:rPr>
              <a:t>.</a:t>
            </a:r>
            <a:r>
              <a:rPr lang="en-US" sz="1800" dirty="0">
                <a:latin typeface="Palatino Linotype" panose="02040502050505030304" pitchFamily="18" charset="0"/>
              </a:rPr>
              <a:t> Differentially expression of CD36 </a:t>
            </a:r>
            <a:r>
              <a:rPr lang="en-US" dirty="0">
                <a:latin typeface="Palatino Linotype" panose="02040502050505030304" pitchFamily="18" charset="0"/>
              </a:rPr>
              <a:t>in the </a:t>
            </a:r>
            <a:r>
              <a:rPr lang="en-US" sz="1800" dirty="0">
                <a:latin typeface="Palatino Linotype" panose="02040502050505030304" pitchFamily="18" charset="0"/>
              </a:rPr>
              <a:t>multiple cancer</a:t>
            </a:r>
            <a:r>
              <a:rPr lang="en-US" dirty="0">
                <a:latin typeface="Palatino Linotype" panose="02040502050505030304" pitchFamily="18" charset="0"/>
              </a:rPr>
              <a:t>s.</a:t>
            </a:r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DB09F1D-E908-5400-87D6-4911A63BA4AF}"/>
              </a:ext>
            </a:extLst>
          </p:cNvPr>
          <p:cNvSpPr/>
          <p:nvPr/>
        </p:nvSpPr>
        <p:spPr>
          <a:xfrm>
            <a:off x="9535879" y="876300"/>
            <a:ext cx="383763" cy="5290066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E69EF5F-054C-9DA8-BF5F-A943A256D27B}"/>
              </a:ext>
            </a:extLst>
          </p:cNvPr>
          <p:cNvSpPr txBox="1"/>
          <p:nvPr/>
        </p:nvSpPr>
        <p:spPr>
          <a:xfrm>
            <a:off x="0" y="6282077"/>
            <a:ext cx="1019196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>
                <a:latin typeface="Palatino Linotype" panose="02040502050505030304" pitchFamily="18" charset="0"/>
              </a:rPr>
              <a:t>Statistical significance computed by the Wilcoxon test is annotated by the number of stars (*: p-value &lt; 0.05; **: p-value &lt;0.01; ***: p-value &lt;0.001).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200" dirty="0">
                <a:latin typeface="Palatino Linotype" panose="02040502050505030304" pitchFamily="18" charset="0"/>
              </a:rPr>
              <a:t>Melanoma patients' datasets analysis is outlined in the image. </a:t>
            </a:r>
          </a:p>
          <a:p>
            <a:endParaRPr lang="en-US" sz="12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173426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7B976B6-553F-4F55-F2B4-A9734EA88A85}"/>
              </a:ext>
            </a:extLst>
          </p:cNvPr>
          <p:cNvSpPr txBox="1"/>
          <p:nvPr/>
        </p:nvSpPr>
        <p:spPr>
          <a:xfrm>
            <a:off x="293543" y="402453"/>
            <a:ext cx="116461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10.</a:t>
            </a:r>
            <a:r>
              <a:rPr lang="en-US" dirty="0">
                <a:latin typeface="Palatino Linotype" panose="02040502050505030304" pitchFamily="18" charset="0"/>
              </a:rPr>
              <a:t> Challenging C32TG EVs from NTC and SiRNA#3 show modulation of M2-like 				macrophage characteristics in PMA-pretreated THP1 cells.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8EF0BCD-3062-4C6B-ED1F-4E3F6FE23550}"/>
              </a:ext>
            </a:extLst>
          </p:cNvPr>
          <p:cNvSpPr txBox="1"/>
          <p:nvPr/>
        </p:nvSpPr>
        <p:spPr>
          <a:xfrm>
            <a:off x="7527209" y="1239358"/>
            <a:ext cx="20008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32 EVs (CD36 SiRNA#3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58DDED6-B62E-9065-857E-D1F356D29343}"/>
              </a:ext>
            </a:extLst>
          </p:cNvPr>
          <p:cNvSpPr txBox="1"/>
          <p:nvPr/>
        </p:nvSpPr>
        <p:spPr>
          <a:xfrm>
            <a:off x="6116611" y="1239358"/>
            <a:ext cx="1316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32 EVs (NTC 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830BFAC-51D1-B355-2380-4ECAF00ACD9D}"/>
              </a:ext>
            </a:extLst>
          </p:cNvPr>
          <p:cNvSpPr txBox="1"/>
          <p:nvPr/>
        </p:nvSpPr>
        <p:spPr>
          <a:xfrm>
            <a:off x="4352664" y="1239358"/>
            <a:ext cx="13164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32 EVs (NTC 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F9C5386-591D-F5A2-8036-86BB9C5A7A10}"/>
              </a:ext>
            </a:extLst>
          </p:cNvPr>
          <p:cNvSpPr txBox="1"/>
          <p:nvPr/>
        </p:nvSpPr>
        <p:spPr>
          <a:xfrm>
            <a:off x="10250906" y="6358368"/>
            <a:ext cx="13179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ure: S10</a:t>
            </a:r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A8FDA411-C753-040D-BE42-CB7D8FB011B5}"/>
              </a:ext>
            </a:extLst>
          </p:cNvPr>
          <p:cNvGrpSpPr/>
          <p:nvPr/>
        </p:nvGrpSpPr>
        <p:grpSpPr>
          <a:xfrm>
            <a:off x="3737024" y="1510298"/>
            <a:ext cx="5827152" cy="4613370"/>
            <a:chOff x="3737024" y="1510298"/>
            <a:chExt cx="5827152" cy="4613370"/>
          </a:xfrm>
        </p:grpSpPr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D9D585F9-8140-F1B2-3CE0-D6277CBF983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2996" y="4301656"/>
              <a:ext cx="7951" cy="1545013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E74DA9B1-F74D-7A91-E8AF-86F485C4695E}"/>
                </a:ext>
              </a:extLst>
            </p:cNvPr>
            <p:cNvGrpSpPr/>
            <p:nvPr/>
          </p:nvGrpSpPr>
          <p:grpSpPr>
            <a:xfrm>
              <a:off x="3737024" y="1510298"/>
              <a:ext cx="5827152" cy="2650926"/>
              <a:chOff x="375806" y="619795"/>
              <a:chExt cx="5827152" cy="2650926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4686E6F7-1A12-C48A-8C4B-366086DB05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31966" r="59493" b="4311"/>
              <a:stretch/>
            </p:blipFill>
            <p:spPr>
              <a:xfrm>
                <a:off x="683584" y="619795"/>
                <a:ext cx="3584458" cy="1907718"/>
              </a:xfrm>
              <a:prstGeom prst="rect">
                <a:avLst/>
              </a:prstGeom>
            </p:spPr>
          </p:pic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83C1721C-8407-9AC4-3F0D-0FA77DA28F6C}"/>
                  </a:ext>
                </a:extLst>
              </p:cNvPr>
              <p:cNvSpPr txBox="1"/>
              <p:nvPr/>
            </p:nvSpPr>
            <p:spPr>
              <a:xfrm>
                <a:off x="2966377" y="2481823"/>
                <a:ext cx="10311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CD36-PE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CF18541-DA42-2B00-AD75-5574B396EC4A}"/>
                  </a:ext>
                </a:extLst>
              </p:cNvPr>
              <p:cNvSpPr txBox="1"/>
              <p:nvPr/>
            </p:nvSpPr>
            <p:spPr>
              <a:xfrm>
                <a:off x="1233285" y="2547993"/>
                <a:ext cx="83279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IgG-PE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59D14F7B-191A-868B-077D-C82DA328783A}"/>
                  </a:ext>
                </a:extLst>
              </p:cNvPr>
              <p:cNvSpPr txBox="1"/>
              <p:nvPr/>
            </p:nvSpPr>
            <p:spPr>
              <a:xfrm>
                <a:off x="4757363" y="2539798"/>
                <a:ext cx="14455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CD36-PE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3B8CD912-A0F5-A91D-1F60-845CD222048C}"/>
                  </a:ext>
                </a:extLst>
              </p:cNvPr>
              <p:cNvSpPr txBox="1"/>
              <p:nvPr/>
            </p:nvSpPr>
            <p:spPr>
              <a:xfrm rot="16200000">
                <a:off x="129350" y="1218006"/>
                <a:ext cx="8006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>
                    <a:latin typeface="Arial" panose="020B0604020202020204" pitchFamily="34" charset="0"/>
                    <a:cs typeface="Arial" panose="020B0604020202020204" pitchFamily="34" charset="0"/>
                  </a:rPr>
                  <a:t>FSC</a:t>
                </a:r>
              </a:p>
            </p:txBody>
          </p: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9980C76D-3B07-4BE7-22FF-983AE5A42D40}"/>
                  </a:ext>
                </a:extLst>
              </p:cNvPr>
              <p:cNvGrpSpPr/>
              <p:nvPr/>
            </p:nvGrpSpPr>
            <p:grpSpPr>
              <a:xfrm>
                <a:off x="2475813" y="2993722"/>
                <a:ext cx="2804449" cy="276999"/>
                <a:chOff x="3193796" y="3425396"/>
                <a:chExt cx="3003140" cy="331715"/>
              </a:xfrm>
            </p:grpSpPr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51FC1957-0CE9-1F18-AD8A-64EC1F85DFDF}"/>
                    </a:ext>
                  </a:extLst>
                </p:cNvPr>
                <p:cNvSpPr txBox="1"/>
                <p:nvPr/>
              </p:nvSpPr>
              <p:spPr>
                <a:xfrm>
                  <a:off x="3193796" y="3428998"/>
                  <a:ext cx="500458" cy="27700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>
                      <a:latin typeface="Arial" panose="020B0604020202020204" pitchFamily="34" charset="0"/>
                      <a:cs typeface="Arial" panose="020B0604020202020204" pitchFamily="34" charset="0"/>
                    </a:rPr>
                    <a:t>NTC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87D67BAA-8E27-F0EF-FBC2-7173F18727E6}"/>
                    </a:ext>
                  </a:extLst>
                </p:cNvPr>
                <p:cNvSpPr txBox="1"/>
                <p:nvPr/>
              </p:nvSpPr>
              <p:spPr>
                <a:xfrm>
                  <a:off x="4859382" y="3425396"/>
                  <a:ext cx="1337554" cy="33171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6 SiRNA#3</a:t>
                  </a:r>
                </a:p>
              </p:txBody>
            </p:sp>
          </p:grpSp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6F089C6B-F714-9081-55DF-6CBA8F15956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0351" t="31966" b="4311"/>
              <a:stretch/>
            </p:blipFill>
            <p:spPr>
              <a:xfrm>
                <a:off x="4268042" y="632080"/>
                <a:ext cx="1738743" cy="1907718"/>
              </a:xfrm>
              <a:prstGeom prst="rect">
                <a:avLst/>
              </a:prstGeom>
            </p:spPr>
          </p:pic>
        </p:grp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04AB3514-FC06-FB87-4AF9-FF6DCFE4FD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604" r="49475"/>
            <a:stretch/>
          </p:blipFill>
          <p:spPr>
            <a:xfrm>
              <a:off x="5192202" y="4096965"/>
              <a:ext cx="1808519" cy="1749704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6002919C-FD8C-4C7A-2A6F-7C8234449E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5113"/>
            <a:stretch/>
          </p:blipFill>
          <p:spPr>
            <a:xfrm>
              <a:off x="7119927" y="4103249"/>
              <a:ext cx="1767809" cy="1749704"/>
            </a:xfrm>
            <a:prstGeom prst="rect">
              <a:avLst/>
            </a:prstGeom>
          </p:spPr>
        </p:pic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6BDB89ED-9A10-0104-9B25-270E8270AC84}"/>
                </a:ext>
              </a:extLst>
            </p:cNvPr>
            <p:cNvCxnSpPr/>
            <p:nvPr/>
          </p:nvCxnSpPr>
          <p:spPr>
            <a:xfrm>
              <a:off x="5427301" y="5971903"/>
              <a:ext cx="34604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9BAA0A6-7292-AE93-38C4-4B5849D39561}"/>
                </a:ext>
              </a:extLst>
            </p:cNvPr>
            <p:cNvSpPr txBox="1"/>
            <p:nvPr/>
          </p:nvSpPr>
          <p:spPr>
            <a:xfrm>
              <a:off x="6870189" y="5846669"/>
              <a:ext cx="74049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2 m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φ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9B00CE0-5C07-2D72-BECD-73DE5E011A16}"/>
                </a:ext>
              </a:extLst>
            </p:cNvPr>
            <p:cNvSpPr txBox="1"/>
            <p:nvPr/>
          </p:nvSpPr>
          <p:spPr>
            <a:xfrm rot="16200000">
              <a:off x="4710701" y="4869740"/>
              <a:ext cx="74049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1 m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φ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238617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B4430-331E-417E-287E-D4C0883E24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35552" y="556597"/>
            <a:ext cx="4367033" cy="553066"/>
          </a:xfrm>
        </p:spPr>
        <p:txBody>
          <a:bodyPr>
            <a:norm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lots used in figure 2 (A). 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285E4982-0225-62C3-5F11-770BD66657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 flipH="1">
            <a:off x="2745133" y="1957685"/>
            <a:ext cx="3549552" cy="294263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4480890-614C-67CB-C35A-976499390AD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549" t="2061" r="16619" b="-2061"/>
          <a:stretch/>
        </p:blipFill>
        <p:spPr>
          <a:xfrm rot="5400000" flipV="1">
            <a:off x="5474516" y="2275707"/>
            <a:ext cx="3549553" cy="23065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4467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2C656F30-C8C1-C46F-FC3C-DEE669E9619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159"/>
          <a:stretch/>
        </p:blipFill>
        <p:spPr>
          <a:xfrm>
            <a:off x="7283354" y="553066"/>
            <a:ext cx="3618283" cy="292417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65D5516-B850-DE1B-7DF1-38DE8EB30C0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/>
          <a:stretch/>
        </p:blipFill>
        <p:spPr>
          <a:xfrm>
            <a:off x="7394613" y="3480938"/>
            <a:ext cx="3395766" cy="334089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53A1BC7-47E7-5099-7F54-8350523179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9118" y="3803785"/>
            <a:ext cx="3986650" cy="3018051"/>
          </a:xfrm>
          <a:prstGeom prst="rect">
            <a:avLst/>
          </a:prstGeom>
        </p:spPr>
      </p:pic>
      <p:sp>
        <p:nvSpPr>
          <p:cNvPr id="18" name="Title 1">
            <a:extLst>
              <a:ext uri="{FF2B5EF4-FFF2-40B4-BE49-F238E27FC236}">
                <a16:creationId xmlns:a16="http://schemas.microsoft.com/office/drawing/2014/main" id="{329C44DF-6A99-05E4-7B95-68253E26CC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1100" y="0"/>
            <a:ext cx="4367033" cy="553066"/>
          </a:xfrm>
        </p:spPr>
        <p:txBody>
          <a:bodyPr>
            <a:norm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lots used in figure 2 (C). 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101254BC-83DA-92E0-028E-EFED903A3A4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0264" y="785734"/>
            <a:ext cx="4525504" cy="29241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12472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CC36C1F-FE95-30BE-41CF-D4107E7C4B5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3067689"/>
              </p:ext>
            </p:extLst>
          </p:nvPr>
        </p:nvGraphicFramePr>
        <p:xfrm>
          <a:off x="3605202" y="4944395"/>
          <a:ext cx="4981596" cy="1469213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815813">
                  <a:extLst>
                    <a:ext uri="{9D8B030D-6E8A-4147-A177-3AD203B41FA5}">
                      <a16:colId xmlns:a16="http://schemas.microsoft.com/office/drawing/2014/main" val="823354772"/>
                    </a:ext>
                  </a:extLst>
                </a:gridCol>
                <a:gridCol w="552171">
                  <a:extLst>
                    <a:ext uri="{9D8B030D-6E8A-4147-A177-3AD203B41FA5}">
                      <a16:colId xmlns:a16="http://schemas.microsoft.com/office/drawing/2014/main" val="4033752660"/>
                    </a:ext>
                  </a:extLst>
                </a:gridCol>
                <a:gridCol w="791446">
                  <a:extLst>
                    <a:ext uri="{9D8B030D-6E8A-4147-A177-3AD203B41FA5}">
                      <a16:colId xmlns:a16="http://schemas.microsoft.com/office/drawing/2014/main" val="3150238889"/>
                    </a:ext>
                  </a:extLst>
                </a:gridCol>
                <a:gridCol w="588982">
                  <a:extLst>
                    <a:ext uri="{9D8B030D-6E8A-4147-A177-3AD203B41FA5}">
                      <a16:colId xmlns:a16="http://schemas.microsoft.com/office/drawing/2014/main" val="984532386"/>
                    </a:ext>
                  </a:extLst>
                </a:gridCol>
                <a:gridCol w="579780">
                  <a:extLst>
                    <a:ext uri="{9D8B030D-6E8A-4147-A177-3AD203B41FA5}">
                      <a16:colId xmlns:a16="http://schemas.microsoft.com/office/drawing/2014/main" val="2389657792"/>
                    </a:ext>
                  </a:extLst>
                </a:gridCol>
                <a:gridCol w="653404">
                  <a:extLst>
                    <a:ext uri="{9D8B030D-6E8A-4147-A177-3AD203B41FA5}">
                      <a16:colId xmlns:a16="http://schemas.microsoft.com/office/drawing/2014/main" val="1489216164"/>
                    </a:ext>
                  </a:extLst>
                </a:gridCol>
              </a:tblGrid>
              <a:tr h="270495">
                <a:tc rowSpan="2"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crophages</a:t>
                      </a: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200" b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99155929"/>
                  </a:ext>
                </a:extLst>
              </a:tr>
              <a:tr h="270495">
                <a:tc vMerge="1"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 vMerge="1">
                  <a:txBody>
                    <a:bodyPr/>
                    <a:lstStyle/>
                    <a:p>
                      <a:pPr algn="ctr" fontAlgn="b"/>
                      <a:r>
                        <a:rPr lang="en-US" sz="1000" b="0" u="none" strike="noStrike">
                          <a:solidFill>
                            <a:srgbClr val="000000"/>
                          </a:solidFill>
                          <a:effectLst/>
                        </a:rPr>
                        <a:t>Tumor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61218109"/>
                  </a:ext>
                </a:extLst>
              </a:tr>
              <a:tr h="27646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CM (n=471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7</a:t>
                      </a:r>
                    </a:p>
                  </a:txBody>
                  <a:tcPr marL="38100" marR="38100" marT="38100" marB="38100" anchor="ctr"/>
                </a:tc>
                <a:extLst>
                  <a:ext uri="{0D108BD9-81ED-4DB2-BD59-A6C34878D82A}">
                    <a16:rowId xmlns:a16="http://schemas.microsoft.com/office/drawing/2014/main" val="3965207829"/>
                  </a:ext>
                </a:extLst>
              </a:tr>
              <a:tr h="27646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CM Metastasis (n=368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3</a:t>
                      </a:r>
                    </a:p>
                  </a:txBody>
                  <a:tcPr marL="38100" marR="38100" marT="38100" marB="38100" anchor="ctr"/>
                </a:tc>
                <a:extLst>
                  <a:ext uri="{0D108BD9-81ED-4DB2-BD59-A6C34878D82A}">
                    <a16:rowId xmlns:a16="http://schemas.microsoft.com/office/drawing/2014/main" val="343567540"/>
                  </a:ext>
                </a:extLst>
              </a:tr>
              <a:tr h="27646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CM-Primary (n=103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6</a:t>
                      </a:r>
                    </a:p>
                  </a:txBody>
                  <a:tcPr marL="38100" marR="38100" marT="38100" marB="38100" anchor="ctr"/>
                </a:tc>
                <a:extLst>
                  <a:ext uri="{0D108BD9-81ED-4DB2-BD59-A6C34878D82A}">
                    <a16:rowId xmlns:a16="http://schemas.microsoft.com/office/drawing/2014/main" val="4214588789"/>
                  </a:ext>
                </a:extLst>
              </a:tr>
            </a:tbl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ECB7D2C6-CE77-41B9-FE05-54DA14375285}"/>
              </a:ext>
            </a:extLst>
          </p:cNvPr>
          <p:cNvSpPr txBox="1"/>
          <p:nvPr/>
        </p:nvSpPr>
        <p:spPr>
          <a:xfrm>
            <a:off x="779228" y="182507"/>
            <a:ext cx="110876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2.</a:t>
            </a:r>
            <a:r>
              <a:rPr lang="en-US" dirty="0">
                <a:latin typeface="Palatino Linotype" panose="02040502050505030304" pitchFamily="18" charset="0"/>
              </a:rPr>
              <a:t> Timer 2.0 based analysis of CD36 with tumor, endothelial cells, and 				macrophages in SKCM dataset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3F87CF8-6F8D-484A-94FA-327FCBFAE740}"/>
              </a:ext>
            </a:extLst>
          </p:cNvPr>
          <p:cNvSpPr txBox="1"/>
          <p:nvPr/>
        </p:nvSpPr>
        <p:spPr>
          <a:xfrm>
            <a:off x="1208598" y="4415188"/>
            <a:ext cx="9246742" cy="30777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r>
              <a:rPr lang="en-US" sz="1400" b="1" u="none" strike="noStrike" dirty="0">
                <a:effectLst/>
                <a:latin typeface="Palatino Linotype" panose="02040502050505030304" pitchFamily="18" charset="0"/>
                <a:cs typeface="Arial" panose="020B0604020202020204" pitchFamily="34" charset="0"/>
              </a:rPr>
              <a:t>CD36 correlation with macrophage infiltration (CIBERSORT-ABS) and with melanoma tumors</a:t>
            </a:r>
            <a:endParaRPr lang="en-US" sz="14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7709C2F-9977-8CDD-31C8-FEB89D7E6C4D}"/>
              </a:ext>
            </a:extLst>
          </p:cNvPr>
          <p:cNvSpPr txBox="1"/>
          <p:nvPr/>
        </p:nvSpPr>
        <p:spPr>
          <a:xfrm>
            <a:off x="10323095" y="6374410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ure: S2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31188B6E-E04D-DD4C-7D19-4864D22AC30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045" t="27555" r="5491" b="33053"/>
          <a:stretch/>
        </p:blipFill>
        <p:spPr>
          <a:xfrm>
            <a:off x="1552808" y="1113184"/>
            <a:ext cx="10130595" cy="3017658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B83AE3FE-19DE-998A-4E14-0A5D41B2887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5204"/>
          <a:stretch/>
        </p:blipFill>
        <p:spPr>
          <a:xfrm>
            <a:off x="289917" y="1198102"/>
            <a:ext cx="3315285" cy="710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621798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701231C-7D03-0656-40C5-FCA2BA995A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97067" y="1696859"/>
            <a:ext cx="5107704" cy="339821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BA89740-C6A9-7079-B710-F6CDC980CDB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31407" y="1876011"/>
            <a:ext cx="5146397" cy="321906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4C726CC-D893-101A-0042-D683C54969DE}"/>
              </a:ext>
            </a:extLst>
          </p:cNvPr>
          <p:cNvSpPr txBox="1"/>
          <p:nvPr/>
        </p:nvSpPr>
        <p:spPr>
          <a:xfrm>
            <a:off x="10323095" y="6374410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ure: S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DD3EF42-6F69-B380-B2AF-5CE84372FC7F}"/>
              </a:ext>
            </a:extLst>
          </p:cNvPr>
          <p:cNvSpPr txBox="1"/>
          <p:nvPr/>
        </p:nvSpPr>
        <p:spPr>
          <a:xfrm>
            <a:off x="1174349" y="417522"/>
            <a:ext cx="7618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3.</a:t>
            </a:r>
            <a:r>
              <a:rPr lang="en-US" dirty="0">
                <a:latin typeface="Palatino Linotype" panose="02040502050505030304" pitchFamily="18" charset="0"/>
              </a:rPr>
              <a:t> NTA analysis of control and melanoma patient lymphatic EVs</a:t>
            </a:r>
          </a:p>
        </p:txBody>
      </p:sp>
    </p:spTree>
    <p:extLst>
      <p:ext uri="{BB962C8B-B14F-4D97-AF65-F5344CB8AC3E}">
        <p14:creationId xmlns:p14="http://schemas.microsoft.com/office/powerpoint/2010/main" val="10360542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44">
            <a:extLst>
              <a:ext uri="{FF2B5EF4-FFF2-40B4-BE49-F238E27FC236}">
                <a16:creationId xmlns:a16="http://schemas.microsoft.com/office/drawing/2014/main" id="{700F651B-B872-833A-0356-85957238FEB6}"/>
              </a:ext>
            </a:extLst>
          </p:cNvPr>
          <p:cNvGrpSpPr/>
          <p:nvPr/>
        </p:nvGrpSpPr>
        <p:grpSpPr>
          <a:xfrm>
            <a:off x="882104" y="946119"/>
            <a:ext cx="10447539" cy="5893142"/>
            <a:chOff x="882104" y="874560"/>
            <a:chExt cx="10447539" cy="5893142"/>
          </a:xfrm>
        </p:grpSpPr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id="{873B3E90-582F-314C-04DE-533F71919434}"/>
                </a:ext>
              </a:extLst>
            </p:cNvPr>
            <p:cNvGrpSpPr/>
            <p:nvPr/>
          </p:nvGrpSpPr>
          <p:grpSpPr>
            <a:xfrm>
              <a:off x="4889966" y="3747777"/>
              <a:ext cx="2936968" cy="3019925"/>
              <a:chOff x="7150907" y="1201905"/>
              <a:chExt cx="3236356" cy="3293914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C85DF9AF-E183-91C2-97B2-0B13E0EFDC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7500" b="4921"/>
              <a:stretch/>
            </p:blipFill>
            <p:spPr>
              <a:xfrm>
                <a:off x="7567863" y="1201905"/>
                <a:ext cx="2819400" cy="2852738"/>
              </a:xfrm>
              <a:prstGeom prst="rect">
                <a:avLst/>
              </a:prstGeom>
            </p:spPr>
          </p:pic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82F3A6B4-343E-D44F-5605-0CC0C45175F2}"/>
                  </a:ext>
                </a:extLst>
              </p:cNvPr>
              <p:cNvGrpSpPr/>
              <p:nvPr/>
            </p:nvGrpSpPr>
            <p:grpSpPr>
              <a:xfrm>
                <a:off x="7150907" y="2469489"/>
                <a:ext cx="1826656" cy="2026330"/>
                <a:chOff x="497444" y="2758247"/>
                <a:chExt cx="1826656" cy="2026330"/>
              </a:xfrm>
            </p:grpSpPr>
            <p:grpSp>
              <p:nvGrpSpPr>
                <p:cNvPr id="6" name="Group 5">
                  <a:extLst>
                    <a:ext uri="{FF2B5EF4-FFF2-40B4-BE49-F238E27FC236}">
                      <a16:creationId xmlns:a16="http://schemas.microsoft.com/office/drawing/2014/main" id="{FF62F994-15C1-619B-4C39-E78A9A52EB3A}"/>
                    </a:ext>
                  </a:extLst>
                </p:cNvPr>
                <p:cNvGrpSpPr/>
                <p:nvPr/>
              </p:nvGrpSpPr>
              <p:grpSpPr>
                <a:xfrm>
                  <a:off x="876300" y="3226525"/>
                  <a:ext cx="1188720" cy="1188720"/>
                  <a:chOff x="914400" y="3226525"/>
                  <a:chExt cx="1188720" cy="1188720"/>
                </a:xfrm>
              </p:grpSpPr>
              <p:cxnSp>
                <p:nvCxnSpPr>
                  <p:cNvPr id="9" name="Straight Arrow Connector 8">
                    <a:extLst>
                      <a:ext uri="{FF2B5EF4-FFF2-40B4-BE49-F238E27FC236}">
                        <a16:creationId xmlns:a16="http://schemas.microsoft.com/office/drawing/2014/main" id="{A4BDDB22-DC8E-BFBC-E3A0-9C8C55323CEA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914400" y="3226525"/>
                    <a:ext cx="0" cy="1188720"/>
                  </a:xfrm>
                  <a:prstGeom prst="straightConnector1">
                    <a:avLst/>
                  </a:prstGeom>
                  <a:ln w="15875"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" name="Straight Arrow Connector 9">
                    <a:extLst>
                      <a:ext uri="{FF2B5EF4-FFF2-40B4-BE49-F238E27FC236}">
                        <a16:creationId xmlns:a16="http://schemas.microsoft.com/office/drawing/2014/main" id="{92CDD2D7-9BA6-C511-02C5-2D7EBA206D4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914400" y="4415245"/>
                    <a:ext cx="1188720" cy="0"/>
                  </a:xfrm>
                  <a:prstGeom prst="straightConnector1">
                    <a:avLst/>
                  </a:prstGeom>
                  <a:ln w="15875">
                    <a:tailEnd type="triangle"/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30F73309-E0C5-66A3-3984-FB5769A2EB2D}"/>
                    </a:ext>
                  </a:extLst>
                </p:cNvPr>
                <p:cNvSpPr txBox="1"/>
                <p:nvPr/>
              </p:nvSpPr>
              <p:spPr>
                <a:xfrm>
                  <a:off x="764571" y="4415245"/>
                  <a:ext cx="1559529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/>
                    <a:t>Diameter (nm)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EEA8A569-21FC-D22B-7052-03B30F766A94}"/>
                    </a:ext>
                  </a:extLst>
                </p:cNvPr>
                <p:cNvSpPr txBox="1"/>
                <p:nvPr/>
              </p:nvSpPr>
              <p:spPr>
                <a:xfrm rot="16200000">
                  <a:off x="-189764" y="3445455"/>
                  <a:ext cx="174374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/>
                    <a:t>FL AF647 (MESF)</a:t>
                  </a:r>
                </a:p>
              </p:txBody>
            </p:sp>
          </p:grp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51A2B812-3673-26A8-CA94-0FC8310775ED}"/>
                </a:ext>
              </a:extLst>
            </p:cNvPr>
            <p:cNvGrpSpPr/>
            <p:nvPr/>
          </p:nvGrpSpPr>
          <p:grpSpPr>
            <a:xfrm>
              <a:off x="882104" y="874560"/>
              <a:ext cx="10447539" cy="3031584"/>
              <a:chOff x="882104" y="818903"/>
              <a:chExt cx="10447539" cy="3031584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3995C459-B9A3-8F8B-92A3-BCE2F80BBF1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8425" b="5230"/>
              <a:stretch/>
            </p:blipFill>
            <p:spPr>
              <a:xfrm>
                <a:off x="1217619" y="1009285"/>
                <a:ext cx="1860813" cy="1877583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63BBD2E6-D405-B9D4-523E-875F797DFEA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8425" b="5230"/>
              <a:stretch/>
            </p:blipFill>
            <p:spPr>
              <a:xfrm>
                <a:off x="3873388" y="1009285"/>
                <a:ext cx="1860814" cy="1877583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1B3ACBE6-519A-05ED-32AB-3985D6E5E0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8425" b="5230"/>
              <a:stretch/>
            </p:blipFill>
            <p:spPr>
              <a:xfrm>
                <a:off x="6459569" y="1009285"/>
                <a:ext cx="1860814" cy="1877583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5D9AECA7-9727-49E6-8501-3680B8486F9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8424" b="5230"/>
              <a:stretch/>
            </p:blipFill>
            <p:spPr>
              <a:xfrm>
                <a:off x="9045750" y="1009285"/>
                <a:ext cx="1860815" cy="1877583"/>
              </a:xfrm>
              <a:prstGeom prst="rect">
                <a:avLst/>
              </a:prstGeom>
            </p:spPr>
          </p:pic>
          <p:grpSp>
            <p:nvGrpSpPr>
              <p:cNvPr id="15" name="Group 14">
                <a:extLst>
                  <a:ext uri="{FF2B5EF4-FFF2-40B4-BE49-F238E27FC236}">
                    <a16:creationId xmlns:a16="http://schemas.microsoft.com/office/drawing/2014/main" id="{CCFAB998-C7C3-6540-6BF6-C79A3B994868}"/>
                  </a:ext>
                </a:extLst>
              </p:cNvPr>
              <p:cNvGrpSpPr/>
              <p:nvPr/>
            </p:nvGrpSpPr>
            <p:grpSpPr>
              <a:xfrm>
                <a:off x="882104" y="1567332"/>
                <a:ext cx="1191183" cy="1627899"/>
                <a:chOff x="292557" y="1218314"/>
                <a:chExt cx="1191183" cy="1627899"/>
              </a:xfrm>
            </p:grpSpPr>
            <p:grpSp>
              <p:nvGrpSpPr>
                <p:cNvPr id="16" name="Group 15">
                  <a:extLst>
                    <a:ext uri="{FF2B5EF4-FFF2-40B4-BE49-F238E27FC236}">
                      <a16:creationId xmlns:a16="http://schemas.microsoft.com/office/drawing/2014/main" id="{79FD08A4-8D32-D14A-E1F4-D9A01D3C3C8A}"/>
                    </a:ext>
                  </a:extLst>
                </p:cNvPr>
                <p:cNvGrpSpPr/>
                <p:nvPr/>
              </p:nvGrpSpPr>
              <p:grpSpPr>
                <a:xfrm>
                  <a:off x="541908" y="1652322"/>
                  <a:ext cx="941832" cy="947983"/>
                  <a:chOff x="541908" y="1652322"/>
                  <a:chExt cx="941832" cy="947983"/>
                </a:xfrm>
              </p:grpSpPr>
              <p:cxnSp>
                <p:nvCxnSpPr>
                  <p:cNvPr id="19" name="Straight Arrow Connector 18">
                    <a:extLst>
                      <a:ext uri="{FF2B5EF4-FFF2-40B4-BE49-F238E27FC236}">
                        <a16:creationId xmlns:a16="http://schemas.microsoft.com/office/drawing/2014/main" id="{D32C90BE-CADB-E98B-42AE-022CA4509FC7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50786" y="1652322"/>
                    <a:ext cx="0" cy="938792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" name="Straight Arrow Connector 19">
                    <a:extLst>
                      <a:ext uri="{FF2B5EF4-FFF2-40B4-BE49-F238E27FC236}">
                        <a16:creationId xmlns:a16="http://schemas.microsoft.com/office/drawing/2014/main" id="{915B8095-C785-7ACF-6FCE-BBC1184359D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1908" y="2600305"/>
                    <a:ext cx="941832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ABE9F69D-B9A2-B1D5-25E2-6F74FC20F78F}"/>
                    </a:ext>
                  </a:extLst>
                </p:cNvPr>
                <p:cNvSpPr txBox="1"/>
                <p:nvPr/>
              </p:nvSpPr>
              <p:spPr>
                <a:xfrm>
                  <a:off x="438261" y="2599992"/>
                  <a:ext cx="104547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iameter (nm)</a:t>
                  </a:r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EE7BB775-266F-977A-C704-FE9CB1B6EA7C}"/>
                    </a:ext>
                  </a:extLst>
                </p:cNvPr>
                <p:cNvSpPr txBox="1"/>
                <p:nvPr/>
              </p:nvSpPr>
              <p:spPr>
                <a:xfrm rot="16200000">
                  <a:off x="-326683" y="1837554"/>
                  <a:ext cx="148470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Fluorescence (MESF)</a:t>
                  </a:r>
                </a:p>
              </p:txBody>
            </p:sp>
          </p:grp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FBD39E89-3596-B079-0C86-3BA6CE35ECBF}"/>
                  </a:ext>
                </a:extLst>
              </p:cNvPr>
              <p:cNvGrpSpPr/>
              <p:nvPr/>
            </p:nvGrpSpPr>
            <p:grpSpPr>
              <a:xfrm>
                <a:off x="3541721" y="1567331"/>
                <a:ext cx="1191183" cy="1627899"/>
                <a:chOff x="292557" y="1218314"/>
                <a:chExt cx="1191183" cy="1627899"/>
              </a:xfrm>
            </p:grpSpPr>
            <p:grpSp>
              <p:nvGrpSpPr>
                <p:cNvPr id="22" name="Group 21">
                  <a:extLst>
                    <a:ext uri="{FF2B5EF4-FFF2-40B4-BE49-F238E27FC236}">
                      <a16:creationId xmlns:a16="http://schemas.microsoft.com/office/drawing/2014/main" id="{83951353-AFBE-95B4-473D-1B567C90E8FB}"/>
                    </a:ext>
                  </a:extLst>
                </p:cNvPr>
                <p:cNvGrpSpPr/>
                <p:nvPr/>
              </p:nvGrpSpPr>
              <p:grpSpPr>
                <a:xfrm>
                  <a:off x="541908" y="1652322"/>
                  <a:ext cx="941832" cy="947983"/>
                  <a:chOff x="541908" y="1652322"/>
                  <a:chExt cx="941832" cy="947983"/>
                </a:xfrm>
              </p:grpSpPr>
              <p:cxnSp>
                <p:nvCxnSpPr>
                  <p:cNvPr id="25" name="Straight Arrow Connector 24">
                    <a:extLst>
                      <a:ext uri="{FF2B5EF4-FFF2-40B4-BE49-F238E27FC236}">
                        <a16:creationId xmlns:a16="http://schemas.microsoft.com/office/drawing/2014/main" id="{40DA1218-D43C-2E8B-80D2-74B97F1EE8DF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50786" y="1652322"/>
                    <a:ext cx="0" cy="938792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Straight Arrow Connector 25">
                    <a:extLst>
                      <a:ext uri="{FF2B5EF4-FFF2-40B4-BE49-F238E27FC236}">
                        <a16:creationId xmlns:a16="http://schemas.microsoft.com/office/drawing/2014/main" id="{D28FEF41-9C9C-5D99-4304-24FC20B6E2D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1908" y="2600305"/>
                    <a:ext cx="941832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CA5E5FB5-C960-09D5-0E57-E6C1686703A9}"/>
                    </a:ext>
                  </a:extLst>
                </p:cNvPr>
                <p:cNvSpPr txBox="1"/>
                <p:nvPr/>
              </p:nvSpPr>
              <p:spPr>
                <a:xfrm>
                  <a:off x="438261" y="2599992"/>
                  <a:ext cx="104547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iameter (nm)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BB5AB3EB-6BCE-4980-EF62-DFE4B208E5A0}"/>
                    </a:ext>
                  </a:extLst>
                </p:cNvPr>
                <p:cNvSpPr txBox="1"/>
                <p:nvPr/>
              </p:nvSpPr>
              <p:spPr>
                <a:xfrm rot="16200000">
                  <a:off x="-326683" y="1837554"/>
                  <a:ext cx="148470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Fluorescence (MESF)</a:t>
                  </a:r>
                </a:p>
              </p:txBody>
            </p: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D1E35A08-AD7B-E1B3-C092-0AB341D2D624}"/>
                  </a:ext>
                </a:extLst>
              </p:cNvPr>
              <p:cNvGrpSpPr/>
              <p:nvPr/>
            </p:nvGrpSpPr>
            <p:grpSpPr>
              <a:xfrm>
                <a:off x="6164620" y="1567330"/>
                <a:ext cx="1191183" cy="1627899"/>
                <a:chOff x="292557" y="1218314"/>
                <a:chExt cx="1191183" cy="1627899"/>
              </a:xfrm>
            </p:grpSpPr>
            <p:grpSp>
              <p:nvGrpSpPr>
                <p:cNvPr id="28" name="Group 27">
                  <a:extLst>
                    <a:ext uri="{FF2B5EF4-FFF2-40B4-BE49-F238E27FC236}">
                      <a16:creationId xmlns:a16="http://schemas.microsoft.com/office/drawing/2014/main" id="{88C354CD-E040-8E05-660F-90F5FEA4ED0E}"/>
                    </a:ext>
                  </a:extLst>
                </p:cNvPr>
                <p:cNvGrpSpPr/>
                <p:nvPr/>
              </p:nvGrpSpPr>
              <p:grpSpPr>
                <a:xfrm>
                  <a:off x="541908" y="1652322"/>
                  <a:ext cx="941832" cy="947983"/>
                  <a:chOff x="541908" y="1652322"/>
                  <a:chExt cx="941832" cy="947983"/>
                </a:xfrm>
              </p:grpSpPr>
              <p:cxnSp>
                <p:nvCxnSpPr>
                  <p:cNvPr id="31" name="Straight Arrow Connector 30">
                    <a:extLst>
                      <a:ext uri="{FF2B5EF4-FFF2-40B4-BE49-F238E27FC236}">
                        <a16:creationId xmlns:a16="http://schemas.microsoft.com/office/drawing/2014/main" id="{16EE48E9-03D3-FEBE-0DB8-9EF1B2B81151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50786" y="1652322"/>
                    <a:ext cx="0" cy="938792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Straight Arrow Connector 31">
                    <a:extLst>
                      <a:ext uri="{FF2B5EF4-FFF2-40B4-BE49-F238E27FC236}">
                        <a16:creationId xmlns:a16="http://schemas.microsoft.com/office/drawing/2014/main" id="{59A38B7E-0828-4CE4-56E5-87FC823FCC7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1908" y="2600305"/>
                    <a:ext cx="941832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FA6B6355-6257-3800-6675-40AA7560D565}"/>
                    </a:ext>
                  </a:extLst>
                </p:cNvPr>
                <p:cNvSpPr txBox="1"/>
                <p:nvPr/>
              </p:nvSpPr>
              <p:spPr>
                <a:xfrm>
                  <a:off x="438261" y="2599992"/>
                  <a:ext cx="104547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iameter (nm)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6CF49EB6-3EC7-7E4D-341C-B37556C41545}"/>
                    </a:ext>
                  </a:extLst>
                </p:cNvPr>
                <p:cNvSpPr txBox="1"/>
                <p:nvPr/>
              </p:nvSpPr>
              <p:spPr>
                <a:xfrm rot="16200000">
                  <a:off x="-326683" y="1837554"/>
                  <a:ext cx="148470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Fluorescence (MESF)</a:t>
                  </a:r>
                </a:p>
              </p:txBody>
            </p:sp>
          </p:grpSp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FB4CFC52-0D12-539A-691C-2912E9A1EDB7}"/>
                  </a:ext>
                </a:extLst>
              </p:cNvPr>
              <p:cNvGrpSpPr/>
              <p:nvPr/>
            </p:nvGrpSpPr>
            <p:grpSpPr>
              <a:xfrm>
                <a:off x="8734023" y="1567330"/>
                <a:ext cx="1191183" cy="1627899"/>
                <a:chOff x="292557" y="1218314"/>
                <a:chExt cx="1191183" cy="1627899"/>
              </a:xfrm>
            </p:grpSpPr>
            <p:grpSp>
              <p:nvGrpSpPr>
                <p:cNvPr id="34" name="Group 33">
                  <a:extLst>
                    <a:ext uri="{FF2B5EF4-FFF2-40B4-BE49-F238E27FC236}">
                      <a16:creationId xmlns:a16="http://schemas.microsoft.com/office/drawing/2014/main" id="{30A53533-E251-A79F-2C13-0DCE2A123CFB}"/>
                    </a:ext>
                  </a:extLst>
                </p:cNvPr>
                <p:cNvGrpSpPr/>
                <p:nvPr/>
              </p:nvGrpSpPr>
              <p:grpSpPr>
                <a:xfrm>
                  <a:off x="541908" y="1652322"/>
                  <a:ext cx="941832" cy="947983"/>
                  <a:chOff x="541908" y="1652322"/>
                  <a:chExt cx="941832" cy="947983"/>
                </a:xfrm>
              </p:grpSpPr>
              <p:cxnSp>
                <p:nvCxnSpPr>
                  <p:cNvPr id="37" name="Straight Arrow Connector 36">
                    <a:extLst>
                      <a:ext uri="{FF2B5EF4-FFF2-40B4-BE49-F238E27FC236}">
                        <a16:creationId xmlns:a16="http://schemas.microsoft.com/office/drawing/2014/main" id="{93DFF364-1BCE-75DC-4F68-837D987F92EC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550786" y="1652322"/>
                    <a:ext cx="0" cy="938792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Straight Arrow Connector 37">
                    <a:extLst>
                      <a:ext uri="{FF2B5EF4-FFF2-40B4-BE49-F238E27FC236}">
                        <a16:creationId xmlns:a16="http://schemas.microsoft.com/office/drawing/2014/main" id="{9E740C6E-8FCC-8701-D413-F28D8268D04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41908" y="2600305"/>
                    <a:ext cx="941832" cy="0"/>
                  </a:xfrm>
                  <a:prstGeom prst="straightConnector1">
                    <a:avLst/>
                  </a:prstGeom>
                  <a:ln>
                    <a:tailEnd type="triangle"/>
                  </a:ln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17021D54-229A-1C65-0C7A-ABA997E23B67}"/>
                    </a:ext>
                  </a:extLst>
                </p:cNvPr>
                <p:cNvSpPr txBox="1"/>
                <p:nvPr/>
              </p:nvSpPr>
              <p:spPr>
                <a:xfrm>
                  <a:off x="438261" y="2599992"/>
                  <a:ext cx="104547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Diameter (nm)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E0077A87-FE1A-8799-A1F0-5C8849A3241D}"/>
                    </a:ext>
                  </a:extLst>
                </p:cNvPr>
                <p:cNvSpPr txBox="1"/>
                <p:nvPr/>
              </p:nvSpPr>
              <p:spPr>
                <a:xfrm rot="16200000">
                  <a:off x="-326683" y="1837554"/>
                  <a:ext cx="148470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>
                      <a:latin typeface="Arial" panose="020B0604020202020204" pitchFamily="34" charset="0"/>
                      <a:cs typeface="Arial" panose="020B0604020202020204" pitchFamily="34" charset="0"/>
                    </a:rPr>
                    <a:t>Fluorescence (MESF)</a:t>
                  </a:r>
                </a:p>
              </p:txBody>
            </p:sp>
          </p:grp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5511286E-7BD3-7196-E254-0C8150AFB1EE}"/>
                  </a:ext>
                </a:extLst>
              </p:cNvPr>
              <p:cNvSpPr txBox="1"/>
              <p:nvPr/>
            </p:nvSpPr>
            <p:spPr>
              <a:xfrm>
                <a:off x="1367137" y="819430"/>
                <a:ext cx="17347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PBS + Anti-CD36 AF647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95F2CCE6-E03D-F62F-EF8C-50278485AEB3}"/>
                  </a:ext>
                </a:extLst>
              </p:cNvPr>
              <p:cNvSpPr txBox="1"/>
              <p:nvPr/>
            </p:nvSpPr>
            <p:spPr>
              <a:xfrm>
                <a:off x="4005151" y="820750"/>
                <a:ext cx="156645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Unstained THP-1 EVs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5737EB9-18DE-2AF9-622C-80ACB5799D33}"/>
                  </a:ext>
                </a:extLst>
              </p:cNvPr>
              <p:cNvSpPr txBox="1"/>
              <p:nvPr/>
            </p:nvSpPr>
            <p:spPr>
              <a:xfrm>
                <a:off x="6585499" y="824175"/>
                <a:ext cx="217880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THP-1 EVs + Anti-IgG2a AF647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26382C9E-EB6B-F0EA-ECBA-7AED4F3A43E5}"/>
                  </a:ext>
                </a:extLst>
              </p:cNvPr>
              <p:cNvSpPr txBox="1"/>
              <p:nvPr/>
            </p:nvSpPr>
            <p:spPr>
              <a:xfrm>
                <a:off x="9171680" y="818903"/>
                <a:ext cx="215796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THP-1 EVs + Anti-CD36 AF647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FCF80EA5-D365-6886-D270-1732D595363A}"/>
                  </a:ext>
                </a:extLst>
              </p:cNvPr>
              <p:cNvSpPr txBox="1"/>
              <p:nvPr/>
            </p:nvSpPr>
            <p:spPr>
              <a:xfrm>
                <a:off x="6397422" y="3481155"/>
                <a:ext cx="731290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Palatino Linotype" panose="02040502050505030304" pitchFamily="18" charset="0"/>
                  </a:rPr>
                  <a:t>LEVs</a:t>
                </a:r>
              </a:p>
            </p:txBody>
          </p:sp>
        </p:grpSp>
      </p:grpSp>
      <p:sp>
        <p:nvSpPr>
          <p:cNvPr id="46" name="TextBox 45">
            <a:extLst>
              <a:ext uri="{FF2B5EF4-FFF2-40B4-BE49-F238E27FC236}">
                <a16:creationId xmlns:a16="http://schemas.microsoft.com/office/drawing/2014/main" id="{AA22BBBF-32EB-3D3F-D39A-667988F784EB}"/>
              </a:ext>
            </a:extLst>
          </p:cNvPr>
          <p:cNvSpPr txBox="1"/>
          <p:nvPr/>
        </p:nvSpPr>
        <p:spPr>
          <a:xfrm>
            <a:off x="568056" y="349375"/>
            <a:ext cx="9752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4.</a:t>
            </a:r>
            <a:r>
              <a:rPr lang="en-US" dirty="0">
                <a:latin typeface="Palatino Linotype" panose="02040502050505030304" pitchFamily="18" charset="0"/>
              </a:rPr>
              <a:t> Scatterplot with </a:t>
            </a:r>
            <a:r>
              <a:rPr lang="en-US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anoscale flow cytometer for analysis of patient and control LEVs </a:t>
            </a:r>
            <a:endParaRPr lang="en-US" dirty="0">
              <a:latin typeface="Palatino Linotype" panose="0204050205050503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8FB01BB-DF30-3E8D-C9C2-69EE59359760}"/>
              </a:ext>
            </a:extLst>
          </p:cNvPr>
          <p:cNvSpPr txBox="1"/>
          <p:nvPr/>
        </p:nvSpPr>
        <p:spPr>
          <a:xfrm>
            <a:off x="10989427" y="6431271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ure: S4</a:t>
            </a:r>
          </a:p>
        </p:txBody>
      </p:sp>
    </p:spTree>
    <p:extLst>
      <p:ext uri="{BB962C8B-B14F-4D97-AF65-F5344CB8AC3E}">
        <p14:creationId xmlns:p14="http://schemas.microsoft.com/office/powerpoint/2010/main" val="162688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C5DC9843-A5A5-1AF7-108A-B2BDD67A3E83}"/>
              </a:ext>
            </a:extLst>
          </p:cNvPr>
          <p:cNvSpPr txBox="1"/>
          <p:nvPr/>
        </p:nvSpPr>
        <p:spPr>
          <a:xfrm>
            <a:off x="545865" y="398395"/>
            <a:ext cx="116461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5.</a:t>
            </a:r>
            <a:r>
              <a:rPr lang="en-US" dirty="0">
                <a:latin typeface="Palatino Linotype" panose="02040502050505030304" pitchFamily="18" charset="0"/>
              </a:rPr>
              <a:t> Challenging SKMEL28 EVs increases CD36 expression in THP1 cells in 48 hours.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2F815E8-B831-BDC7-C3EF-DB50F4996774}"/>
              </a:ext>
            </a:extLst>
          </p:cNvPr>
          <p:cNvSpPr txBox="1"/>
          <p:nvPr/>
        </p:nvSpPr>
        <p:spPr>
          <a:xfrm>
            <a:off x="10827812" y="6337841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ure: S5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0F0F4671-07B1-C0F1-DAA0-D90D77703F3C}"/>
              </a:ext>
            </a:extLst>
          </p:cNvPr>
          <p:cNvGrpSpPr/>
          <p:nvPr/>
        </p:nvGrpSpPr>
        <p:grpSpPr>
          <a:xfrm>
            <a:off x="4194523" y="767727"/>
            <a:ext cx="3991428" cy="3963079"/>
            <a:chOff x="6943898" y="241835"/>
            <a:chExt cx="3991428" cy="3963079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E0A6433-A745-DDD7-5BB7-5D9E8582A4F0}"/>
                </a:ext>
              </a:extLst>
            </p:cNvPr>
            <p:cNvSpPr txBox="1"/>
            <p:nvPr/>
          </p:nvSpPr>
          <p:spPr>
            <a:xfrm>
              <a:off x="6965534" y="3686437"/>
              <a:ext cx="8448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7KD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D7D45A5-68CA-3C92-3C88-7E1A2B05B7A3}"/>
                </a:ext>
              </a:extLst>
            </p:cNvPr>
            <p:cNvSpPr txBox="1"/>
            <p:nvPr/>
          </p:nvSpPr>
          <p:spPr>
            <a:xfrm>
              <a:off x="6943898" y="2829930"/>
              <a:ext cx="84484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75KDa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8338D657-CA0F-A78D-5981-215A82450A68}"/>
                </a:ext>
              </a:extLst>
            </p:cNvPr>
            <p:cNvSpPr txBox="1"/>
            <p:nvPr/>
          </p:nvSpPr>
          <p:spPr>
            <a:xfrm rot="21595318">
              <a:off x="9410023" y="3619157"/>
              <a:ext cx="15253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6DB34F0-E5C5-9C45-43AC-4AD1B2CFE87D}"/>
                </a:ext>
              </a:extLst>
            </p:cNvPr>
            <p:cNvSpPr txBox="1"/>
            <p:nvPr/>
          </p:nvSpPr>
          <p:spPr>
            <a:xfrm rot="21595318">
              <a:off x="9410023" y="2777541"/>
              <a:ext cx="125869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CD36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28F72F1-5620-380C-A40C-B41335DE8B36}"/>
                </a:ext>
              </a:extLst>
            </p:cNvPr>
            <p:cNvSpPr txBox="1"/>
            <p:nvPr/>
          </p:nvSpPr>
          <p:spPr>
            <a:xfrm rot="18318549">
              <a:off x="8060816" y="1308708"/>
              <a:ext cx="22663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Palatino Linotype" panose="02040502050505030304" pitchFamily="18" charset="0"/>
                  <a:cs typeface="Arial" panose="020B0604020202020204" pitchFamily="34" charset="0"/>
                </a:rPr>
                <a:t>SKMEL28 EVs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E2301E8-81DB-6ADC-2FF2-771E955F3448}"/>
                </a:ext>
              </a:extLst>
            </p:cNvPr>
            <p:cNvSpPr txBox="1"/>
            <p:nvPr/>
          </p:nvSpPr>
          <p:spPr>
            <a:xfrm rot="18318549">
              <a:off x="7554436" y="1294389"/>
              <a:ext cx="226630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Palatino Linotype" panose="02040502050505030304" pitchFamily="18" charset="0"/>
                  <a:cs typeface="Arial" panose="020B0604020202020204" pitchFamily="34" charset="0"/>
                </a:rPr>
                <a:t>No EVs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4C0BBFB2-1A63-E9A8-5728-D3A347F18C37}"/>
                </a:ext>
              </a:extLst>
            </p:cNvPr>
            <p:cNvSpPr txBox="1"/>
            <p:nvPr/>
          </p:nvSpPr>
          <p:spPr>
            <a:xfrm rot="18318549">
              <a:off x="8611939" y="1238005"/>
              <a:ext cx="23616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Palatino Linotype" panose="02040502050505030304" pitchFamily="18" charset="0"/>
                  <a:cs typeface="Arial" panose="020B0604020202020204" pitchFamily="34" charset="0"/>
                </a:rPr>
                <a:t>rhCD36 (purified)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9A09383A-034F-AFF2-7280-408AA75EFC1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663740" y="2412535"/>
              <a:ext cx="1700931" cy="179237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5668392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8593C73-85CA-B2D7-075B-E516FDD8F179}"/>
              </a:ext>
            </a:extLst>
          </p:cNvPr>
          <p:cNvSpPr txBox="1"/>
          <p:nvPr/>
        </p:nvSpPr>
        <p:spPr>
          <a:xfrm>
            <a:off x="382900" y="420044"/>
            <a:ext cx="10241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6.</a:t>
            </a:r>
            <a:r>
              <a:rPr lang="en-US" dirty="0">
                <a:latin typeface="Palatino Linotype" panose="02040502050505030304" pitchFamily="18" charset="0"/>
              </a:rPr>
              <a:t> SKMEL28 EVs upregulate CD36 expression in HLEC cells after 16 hours of incubation. 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C249A5D-B850-D349-71F3-CF40E1134F24}"/>
              </a:ext>
            </a:extLst>
          </p:cNvPr>
          <p:cNvSpPr txBox="1"/>
          <p:nvPr/>
        </p:nvSpPr>
        <p:spPr>
          <a:xfrm>
            <a:off x="10862911" y="6331417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ure: S6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7724812-B49F-006B-BB56-05769EC74B4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2645"/>
          <a:stretch/>
        </p:blipFill>
        <p:spPr>
          <a:xfrm>
            <a:off x="2216113" y="1287939"/>
            <a:ext cx="8045437" cy="44397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47904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B097855-54EC-D2F4-0F70-0209730AAE86}"/>
              </a:ext>
            </a:extLst>
          </p:cNvPr>
          <p:cNvGrpSpPr/>
          <p:nvPr/>
        </p:nvGrpSpPr>
        <p:grpSpPr>
          <a:xfrm>
            <a:off x="826935" y="1254320"/>
            <a:ext cx="9525661" cy="3522428"/>
            <a:chOff x="1851192" y="1811534"/>
            <a:chExt cx="6887422" cy="237811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69DC839-389A-C9BC-CE15-7DDED2829DB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851192" y="1811534"/>
              <a:ext cx="5340628" cy="2378114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03A200D9-EBF8-BC43-1F8D-111172E70B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2119"/>
            <a:stretch/>
          </p:blipFill>
          <p:spPr>
            <a:xfrm>
              <a:off x="6663188" y="2116169"/>
              <a:ext cx="2075426" cy="1581320"/>
            </a:xfrm>
            <a:prstGeom prst="rect">
              <a:avLst/>
            </a:prstGeom>
          </p:spPr>
        </p:pic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3B7E09B5-C024-E6EA-6FF7-0F7A1792A5A6}"/>
              </a:ext>
            </a:extLst>
          </p:cNvPr>
          <p:cNvSpPr txBox="1"/>
          <p:nvPr/>
        </p:nvSpPr>
        <p:spPr>
          <a:xfrm>
            <a:off x="1570624" y="374873"/>
            <a:ext cx="6061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7.</a:t>
            </a:r>
            <a:r>
              <a:rPr lang="en-US" dirty="0">
                <a:latin typeface="Palatino Linotype" panose="02040502050505030304" pitchFamily="18" charset="0"/>
              </a:rPr>
              <a:t> Gating strategy for CD36 expression analysis. 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1EBC360-C322-0FFA-3AE4-8E35F0C94625}"/>
              </a:ext>
            </a:extLst>
          </p:cNvPr>
          <p:cNvSpPr txBox="1"/>
          <p:nvPr/>
        </p:nvSpPr>
        <p:spPr>
          <a:xfrm>
            <a:off x="10719788" y="6316150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ure: S7</a:t>
            </a:r>
          </a:p>
        </p:txBody>
      </p:sp>
    </p:spTree>
    <p:extLst>
      <p:ext uri="{BB962C8B-B14F-4D97-AF65-F5344CB8AC3E}">
        <p14:creationId xmlns:p14="http://schemas.microsoft.com/office/powerpoint/2010/main" val="24461689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C5DC9843-A5A5-1AF7-108A-B2BDD67A3E83}"/>
              </a:ext>
            </a:extLst>
          </p:cNvPr>
          <p:cNvSpPr txBox="1"/>
          <p:nvPr/>
        </p:nvSpPr>
        <p:spPr>
          <a:xfrm>
            <a:off x="697832" y="399688"/>
            <a:ext cx="107556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8.</a:t>
            </a:r>
            <a:r>
              <a:rPr lang="en-US" dirty="0">
                <a:latin typeface="Palatino Linotype" panose="02040502050505030304" pitchFamily="18" charset="0"/>
              </a:rPr>
              <a:t> Western blot analysis of NTC and CD36 siRNAs transfected SKMEL28 Cell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2F815E8-B831-BDC7-C3EF-DB50F4996774}"/>
              </a:ext>
            </a:extLst>
          </p:cNvPr>
          <p:cNvSpPr txBox="1"/>
          <p:nvPr/>
        </p:nvSpPr>
        <p:spPr>
          <a:xfrm>
            <a:off x="10250906" y="6358368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ure: S8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B3618958-AB2F-02AC-B551-8936C2A611B5}"/>
              </a:ext>
            </a:extLst>
          </p:cNvPr>
          <p:cNvGrpSpPr/>
          <p:nvPr/>
        </p:nvGrpSpPr>
        <p:grpSpPr>
          <a:xfrm>
            <a:off x="2012917" y="732648"/>
            <a:ext cx="9218203" cy="5368292"/>
            <a:chOff x="2168507" y="232407"/>
            <a:chExt cx="9218203" cy="5368292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398F2A7-C9A7-43B4-6013-15B91A56B8E9}"/>
                </a:ext>
              </a:extLst>
            </p:cNvPr>
            <p:cNvSpPr txBox="1"/>
            <p:nvPr/>
          </p:nvSpPr>
          <p:spPr>
            <a:xfrm rot="21595318">
              <a:off x="8128225" y="4825296"/>
              <a:ext cx="2452094" cy="59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ctin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21EA18A-AFFE-A99B-A7FD-A60679F01D19}"/>
                </a:ext>
              </a:extLst>
            </p:cNvPr>
            <p:cNvSpPr txBox="1"/>
            <p:nvPr/>
          </p:nvSpPr>
          <p:spPr>
            <a:xfrm rot="21595318">
              <a:off x="8128225" y="3583754"/>
              <a:ext cx="2023493" cy="59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CD36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71041E7-E61B-0558-8B9F-83B569DD569E}"/>
                </a:ext>
              </a:extLst>
            </p:cNvPr>
            <p:cNvSpPr txBox="1"/>
            <p:nvPr/>
          </p:nvSpPr>
          <p:spPr>
            <a:xfrm rot="17672729">
              <a:off x="3563484" y="1805409"/>
              <a:ext cx="1142214" cy="59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NTC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F633B3A-B94A-7E59-3850-8C5351ED12D4}"/>
                </a:ext>
              </a:extLst>
            </p:cNvPr>
            <p:cNvSpPr txBox="1"/>
            <p:nvPr/>
          </p:nvSpPr>
          <p:spPr>
            <a:xfrm rot="17869250">
              <a:off x="4295723" y="1250756"/>
              <a:ext cx="2630439" cy="5937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SiRNA#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8307FE9-B194-BCA4-3ADB-464C466A46A2}"/>
                </a:ext>
              </a:extLst>
            </p:cNvPr>
            <p:cNvSpPr txBox="1"/>
            <p:nvPr/>
          </p:nvSpPr>
          <p:spPr>
            <a:xfrm rot="17869250">
              <a:off x="5557181" y="1250756"/>
              <a:ext cx="2630439" cy="5937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SiRNA#2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54CB50D-0E7D-4C07-BC7F-C3679195CB1C}"/>
                </a:ext>
              </a:extLst>
            </p:cNvPr>
            <p:cNvSpPr txBox="1"/>
            <p:nvPr/>
          </p:nvSpPr>
          <p:spPr>
            <a:xfrm rot="17869250">
              <a:off x="6950853" y="1250756"/>
              <a:ext cx="2630439" cy="5937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SiRNA#3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E376937-413B-085C-68FA-3B2FD8614C0A}"/>
                </a:ext>
              </a:extLst>
            </p:cNvPr>
            <p:cNvSpPr txBox="1"/>
            <p:nvPr/>
          </p:nvSpPr>
          <p:spPr>
            <a:xfrm>
              <a:off x="2168507" y="3842879"/>
              <a:ext cx="1358185" cy="59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75KDa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41D9533-87DD-467F-BB18-DC397FB20C57}"/>
                </a:ext>
              </a:extLst>
            </p:cNvPr>
            <p:cNvSpPr txBox="1"/>
            <p:nvPr/>
          </p:nvSpPr>
          <p:spPr>
            <a:xfrm>
              <a:off x="2259535" y="5009034"/>
              <a:ext cx="1358185" cy="59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37KDa</a:t>
              </a:r>
            </a:p>
          </p:txBody>
        </p:sp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A195D733-0BC3-ED16-AE85-4E43191E725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976944" y="3041864"/>
              <a:ext cx="5174846" cy="2558835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933ECF1-307B-40BD-4712-FEB2EC1E102E}"/>
                </a:ext>
              </a:extLst>
            </p:cNvPr>
            <p:cNvSpPr txBox="1"/>
            <p:nvPr/>
          </p:nvSpPr>
          <p:spPr>
            <a:xfrm>
              <a:off x="3651969" y="2708082"/>
              <a:ext cx="44029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1         	0.93	        0.49              0.44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ECE05CA0-DB22-3069-9DE9-06B9C3632B8E}"/>
                </a:ext>
              </a:extLst>
            </p:cNvPr>
            <p:cNvSpPr txBox="1"/>
            <p:nvPr/>
          </p:nvSpPr>
          <p:spPr>
            <a:xfrm>
              <a:off x="8077909" y="2626023"/>
              <a:ext cx="3308801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i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Fold change </a:t>
              </a:r>
            </a:p>
            <a:p>
              <a:r>
                <a:rPr lang="en-US" b="1" i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(normalized by actin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2212589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8157053-CAFA-7B7F-48C2-D9779616641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1615724"/>
              </p:ext>
            </p:extLst>
          </p:nvPr>
        </p:nvGraphicFramePr>
        <p:xfrm>
          <a:off x="4189413" y="1000125"/>
          <a:ext cx="3960812" cy="5041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623949" imgH="3340429" progId="Prism10.Document">
                  <p:embed/>
                </p:oleObj>
              </mc:Choice>
              <mc:Fallback>
                <p:oleObj name="Prism 10" r:id="rId2" imgW="2623949" imgH="3340429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8157053-CAFA-7B7F-48C2-D9779616641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89413" y="1000125"/>
                        <a:ext cx="3960812" cy="5041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20AC9B5-EF24-EDC3-A37B-BA9BB9E0EC1B}"/>
              </a:ext>
            </a:extLst>
          </p:cNvPr>
          <p:cNvSpPr txBox="1"/>
          <p:nvPr/>
        </p:nvSpPr>
        <p:spPr>
          <a:xfrm>
            <a:off x="1341326" y="398690"/>
            <a:ext cx="8408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9. </a:t>
            </a:r>
            <a:r>
              <a:rPr lang="en-US" dirty="0">
                <a:latin typeface="Palatino Linotype" panose="02040502050505030304" pitchFamily="18" charset="0"/>
              </a:rPr>
              <a:t>EVs collected from SkMEL28 cells transfected with NTC and SiRNAs</a:t>
            </a:r>
            <a:r>
              <a:rPr lang="en-US" b="1" dirty="0">
                <a:latin typeface="Palatino Linotype" panose="02040502050505030304" pitchFamily="18" charset="0"/>
              </a:rPr>
              <a:t>.</a:t>
            </a:r>
            <a:endParaRPr lang="en-US" dirty="0">
              <a:latin typeface="Palatino Linotype" panose="0204050205050503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114B6FA-95FA-4472-9852-72971ABD883E}"/>
              </a:ext>
            </a:extLst>
          </p:cNvPr>
          <p:cNvSpPr txBox="1"/>
          <p:nvPr/>
        </p:nvSpPr>
        <p:spPr>
          <a:xfrm>
            <a:off x="10323095" y="6374410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Palatino Linotype" panose="02040502050505030304" pitchFamily="18" charset="0"/>
              </a:rPr>
              <a:t>Figure: S9</a:t>
            </a:r>
          </a:p>
        </p:txBody>
      </p:sp>
    </p:spTree>
    <p:extLst>
      <p:ext uri="{BB962C8B-B14F-4D97-AF65-F5344CB8AC3E}">
        <p14:creationId xmlns:p14="http://schemas.microsoft.com/office/powerpoint/2010/main" val="10062165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8846</TotalTime>
  <Words>447</Words>
  <Application>Microsoft Office PowerPoint</Application>
  <PresentationFormat>Widescreen</PresentationFormat>
  <Paragraphs>98</Paragraphs>
  <Slides>12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20" baseType="lpstr">
      <vt:lpstr>inherit</vt:lpstr>
      <vt:lpstr>Arial</vt:lpstr>
      <vt:lpstr>Calibri</vt:lpstr>
      <vt:lpstr>Calibri Light</vt:lpstr>
      <vt:lpstr>Helvetica</vt:lpstr>
      <vt:lpstr>Palatino Linotype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Blots used in figure 2 (A). </vt:lpstr>
      <vt:lpstr>Blots used in figure 2 (C)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man, Shankar, Ph.D.</dc:creator>
  <cp:lastModifiedBy>MDPI</cp:lastModifiedBy>
  <cp:revision>10</cp:revision>
  <dcterms:created xsi:type="dcterms:W3CDTF">2024-04-03T19:02:25Z</dcterms:created>
  <dcterms:modified xsi:type="dcterms:W3CDTF">2024-07-11T13:45:42Z</dcterms:modified>
</cp:coreProperties>
</file>